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vml" ContentType="application/vnd.openxmlformats-officedocument.vmlDrawing"/>
  <Default Extension="tif" ContentType="image/tiff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  <p:sldId id="258" r:id="rId3"/>
    <p:sldId id="259" r:id="rId4"/>
    <p:sldId id="260" r:id="rId5"/>
    <p:sldId id="261" r:id="rId6"/>
    <p:sldId id="262" r:id="rId7"/>
    <p:sldId id="263" r:id="rId8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84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98" autoAdjust="0"/>
    <p:restoredTop sz="94660"/>
  </p:normalViewPr>
  <p:slideViewPr>
    <p:cSldViewPr showGuides="1">
      <p:cViewPr>
        <p:scale>
          <a:sx n="165" d="100"/>
          <a:sy n="165" d="100"/>
        </p:scale>
        <p:origin x="1138" y="-7550"/>
      </p:cViewPr>
      <p:guideLst>
        <p:guide orient="horz" pos="384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5" Type="http://schemas.openxmlformats.org/officeDocument/2006/relationships/image" Target="../media/image5.emf"/><Relationship Id="rId4" Type="http://schemas.openxmlformats.org/officeDocument/2006/relationships/image" Target="../media/image4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6.emf"/></Relationships>
</file>

<file path=ppt/drawings/_rels/vmlDrawing3.vml.rels><?xml version="1.0" encoding="UTF-8" standalone="yes"?>
<Relationships xmlns="http://schemas.openxmlformats.org/package/2006/relationships"><Relationship Id="rId1" Type="http://schemas.openxmlformats.org/officeDocument/2006/relationships/image" Target="../media/image16.emf"/></Relationships>
</file>

<file path=ppt/drawings/_rels/vmlDrawing4.vml.rels><?xml version="1.0" encoding="UTF-8" standalone="yes"?>
<Relationships xmlns="http://schemas.openxmlformats.org/package/2006/relationships"><Relationship Id="rId3" Type="http://schemas.openxmlformats.org/officeDocument/2006/relationships/image" Target="../media/image38.emf"/><Relationship Id="rId2" Type="http://schemas.openxmlformats.org/officeDocument/2006/relationships/image" Target="../media/image37.emf"/><Relationship Id="rId1" Type="http://schemas.openxmlformats.org/officeDocument/2006/relationships/image" Target="../media/image36.emf"/><Relationship Id="rId4" Type="http://schemas.openxmlformats.org/officeDocument/2006/relationships/image" Target="../media/image39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7B50F6-FA39-40EA-8043-0672C79F3081}" type="datetimeFigureOut">
              <a:rPr lang="en-US" smtClean="0"/>
              <a:t>7/2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AE6557-53A3-4286-A44D-9C4362A5B2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84065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7B50F6-FA39-40EA-8043-0672C79F3081}" type="datetimeFigureOut">
              <a:rPr lang="en-US" smtClean="0"/>
              <a:t>7/2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AE6557-53A3-4286-A44D-9C4362A5B2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71213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7B50F6-FA39-40EA-8043-0672C79F3081}" type="datetimeFigureOut">
              <a:rPr lang="en-US" smtClean="0"/>
              <a:t>7/2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AE6557-53A3-4286-A44D-9C4362A5B2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17816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7B50F6-FA39-40EA-8043-0672C79F3081}" type="datetimeFigureOut">
              <a:rPr lang="en-US" smtClean="0"/>
              <a:t>7/2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AE6557-53A3-4286-A44D-9C4362A5B2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66683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7B50F6-FA39-40EA-8043-0672C79F3081}" type="datetimeFigureOut">
              <a:rPr lang="en-US" smtClean="0"/>
              <a:t>7/2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AE6557-53A3-4286-A44D-9C4362A5B2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27625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7B50F6-FA39-40EA-8043-0672C79F3081}" type="datetimeFigureOut">
              <a:rPr lang="en-US" smtClean="0"/>
              <a:t>7/2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AE6557-53A3-4286-A44D-9C4362A5B2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37285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7B50F6-FA39-40EA-8043-0672C79F3081}" type="datetimeFigureOut">
              <a:rPr lang="en-US" smtClean="0"/>
              <a:t>7/22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AE6557-53A3-4286-A44D-9C4362A5B2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3981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7B50F6-FA39-40EA-8043-0672C79F3081}" type="datetimeFigureOut">
              <a:rPr lang="en-US" smtClean="0"/>
              <a:t>7/22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AE6557-53A3-4286-A44D-9C4362A5B2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73999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7B50F6-FA39-40EA-8043-0672C79F3081}" type="datetimeFigureOut">
              <a:rPr lang="en-US" smtClean="0"/>
              <a:t>7/22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AE6557-53A3-4286-A44D-9C4362A5B2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15283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7B50F6-FA39-40EA-8043-0672C79F3081}" type="datetimeFigureOut">
              <a:rPr lang="en-US" smtClean="0"/>
              <a:t>7/2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AE6557-53A3-4286-A44D-9C4362A5B2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81290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7B50F6-FA39-40EA-8043-0672C79F3081}" type="datetimeFigureOut">
              <a:rPr lang="en-US" smtClean="0"/>
              <a:t>7/2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AE6557-53A3-4286-A44D-9C4362A5B2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6273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7B50F6-FA39-40EA-8043-0672C79F3081}" type="datetimeFigureOut">
              <a:rPr lang="en-US" smtClean="0"/>
              <a:t>7/2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AE6557-53A3-4286-A44D-9C4362A5B2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08065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5.emf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11" Type="http://schemas.openxmlformats.org/officeDocument/2006/relationships/oleObject" Target="../embeddings/oleObject5.bin"/><Relationship Id="rId5" Type="http://schemas.openxmlformats.org/officeDocument/2006/relationships/oleObject" Target="../embeddings/oleObject2.bin"/><Relationship Id="rId10" Type="http://schemas.openxmlformats.org/officeDocument/2006/relationships/image" Target="../media/image4.emf"/><Relationship Id="rId4" Type="http://schemas.openxmlformats.org/officeDocument/2006/relationships/image" Target="../media/image1.emf"/><Relationship Id="rId9" Type="http://schemas.openxmlformats.org/officeDocument/2006/relationships/oleObject" Target="../embeddings/oleObject4.bin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6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.vml"/><Relationship Id="rId4" Type="http://schemas.openxmlformats.org/officeDocument/2006/relationships/image" Target="../media/image6.em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.jpg"/><Relationship Id="rId3" Type="http://schemas.openxmlformats.org/officeDocument/2006/relationships/image" Target="../media/image8.jpg"/><Relationship Id="rId7" Type="http://schemas.openxmlformats.org/officeDocument/2006/relationships/image" Target="../media/image12.jp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.jpg"/><Relationship Id="rId5" Type="http://schemas.openxmlformats.org/officeDocument/2006/relationships/image" Target="../media/image10.jpg"/><Relationship Id="rId10" Type="http://schemas.openxmlformats.org/officeDocument/2006/relationships/image" Target="../media/image15.jpg"/><Relationship Id="rId4" Type="http://schemas.openxmlformats.org/officeDocument/2006/relationships/image" Target="../media/image9.jpg"/><Relationship Id="rId9" Type="http://schemas.openxmlformats.org/officeDocument/2006/relationships/image" Target="../media/image14.jpg"/></Relationships>
</file>

<file path=ppt/slides/_rels/slide5.xml.rels><?xml version="1.0" encoding="UTF-8" standalone="yes"?>
<Relationships xmlns="http://schemas.openxmlformats.org/package/2006/relationships"><Relationship Id="rId8" Type="http://schemas.microsoft.com/office/2007/relationships/hdphoto" Target="../media/hdphoto2.wdp"/><Relationship Id="rId13" Type="http://schemas.openxmlformats.org/officeDocument/2006/relationships/image" Target="../media/image21.png"/><Relationship Id="rId18" Type="http://schemas.microsoft.com/office/2007/relationships/hdphoto" Target="../media/hdphoto7.wdp"/><Relationship Id="rId26" Type="http://schemas.microsoft.com/office/2007/relationships/hdphoto" Target="../media/hdphoto11.wdp"/><Relationship Id="rId39" Type="http://schemas.openxmlformats.org/officeDocument/2006/relationships/image" Target="../media/image34.png"/><Relationship Id="rId3" Type="http://schemas.openxmlformats.org/officeDocument/2006/relationships/oleObject" Target="../embeddings/oleObject7.bin"/><Relationship Id="rId21" Type="http://schemas.openxmlformats.org/officeDocument/2006/relationships/image" Target="../media/image25.png"/><Relationship Id="rId34" Type="http://schemas.microsoft.com/office/2007/relationships/hdphoto" Target="../media/hdphoto15.wdp"/><Relationship Id="rId7" Type="http://schemas.openxmlformats.org/officeDocument/2006/relationships/image" Target="../media/image18.png"/><Relationship Id="rId12" Type="http://schemas.microsoft.com/office/2007/relationships/hdphoto" Target="../media/hdphoto4.wdp"/><Relationship Id="rId17" Type="http://schemas.openxmlformats.org/officeDocument/2006/relationships/image" Target="../media/image23.png"/><Relationship Id="rId25" Type="http://schemas.openxmlformats.org/officeDocument/2006/relationships/image" Target="../media/image27.png"/><Relationship Id="rId33" Type="http://schemas.openxmlformats.org/officeDocument/2006/relationships/image" Target="../media/image31.png"/><Relationship Id="rId38" Type="http://schemas.microsoft.com/office/2007/relationships/hdphoto" Target="../media/hdphoto17.wdp"/><Relationship Id="rId2" Type="http://schemas.openxmlformats.org/officeDocument/2006/relationships/slideLayout" Target="../slideLayouts/slideLayout7.xml"/><Relationship Id="rId16" Type="http://schemas.microsoft.com/office/2007/relationships/hdphoto" Target="../media/hdphoto6.wdp"/><Relationship Id="rId20" Type="http://schemas.microsoft.com/office/2007/relationships/hdphoto" Target="../media/hdphoto8.wdp"/><Relationship Id="rId29" Type="http://schemas.openxmlformats.org/officeDocument/2006/relationships/image" Target="../media/image29.png"/><Relationship Id="rId41" Type="http://schemas.openxmlformats.org/officeDocument/2006/relationships/image" Target="../media/image35.png"/><Relationship Id="rId1" Type="http://schemas.openxmlformats.org/officeDocument/2006/relationships/vmlDrawing" Target="../drawings/vmlDrawing3.vml"/><Relationship Id="rId6" Type="http://schemas.microsoft.com/office/2007/relationships/hdphoto" Target="../media/hdphoto1.wdp"/><Relationship Id="rId11" Type="http://schemas.openxmlformats.org/officeDocument/2006/relationships/image" Target="../media/image20.png"/><Relationship Id="rId24" Type="http://schemas.microsoft.com/office/2007/relationships/hdphoto" Target="../media/hdphoto10.wdp"/><Relationship Id="rId32" Type="http://schemas.microsoft.com/office/2007/relationships/hdphoto" Target="../media/hdphoto14.wdp"/><Relationship Id="rId37" Type="http://schemas.openxmlformats.org/officeDocument/2006/relationships/image" Target="../media/image33.png"/><Relationship Id="rId40" Type="http://schemas.microsoft.com/office/2007/relationships/hdphoto" Target="../media/hdphoto18.wdp"/><Relationship Id="rId5" Type="http://schemas.openxmlformats.org/officeDocument/2006/relationships/image" Target="../media/image17.png"/><Relationship Id="rId15" Type="http://schemas.openxmlformats.org/officeDocument/2006/relationships/image" Target="../media/image22.png"/><Relationship Id="rId23" Type="http://schemas.openxmlformats.org/officeDocument/2006/relationships/image" Target="../media/image26.png"/><Relationship Id="rId28" Type="http://schemas.microsoft.com/office/2007/relationships/hdphoto" Target="../media/hdphoto12.wdp"/><Relationship Id="rId36" Type="http://schemas.microsoft.com/office/2007/relationships/hdphoto" Target="../media/hdphoto16.wdp"/><Relationship Id="rId10" Type="http://schemas.microsoft.com/office/2007/relationships/hdphoto" Target="../media/hdphoto3.wdp"/><Relationship Id="rId19" Type="http://schemas.openxmlformats.org/officeDocument/2006/relationships/image" Target="../media/image24.png"/><Relationship Id="rId31" Type="http://schemas.openxmlformats.org/officeDocument/2006/relationships/image" Target="../media/image30.png"/><Relationship Id="rId4" Type="http://schemas.openxmlformats.org/officeDocument/2006/relationships/image" Target="../media/image16.emf"/><Relationship Id="rId9" Type="http://schemas.openxmlformats.org/officeDocument/2006/relationships/image" Target="../media/image19.png"/><Relationship Id="rId14" Type="http://schemas.microsoft.com/office/2007/relationships/hdphoto" Target="../media/hdphoto5.wdp"/><Relationship Id="rId22" Type="http://schemas.microsoft.com/office/2007/relationships/hdphoto" Target="../media/hdphoto9.wdp"/><Relationship Id="rId27" Type="http://schemas.openxmlformats.org/officeDocument/2006/relationships/image" Target="../media/image28.png"/><Relationship Id="rId30" Type="http://schemas.microsoft.com/office/2007/relationships/hdphoto" Target="../media/hdphoto13.wdp"/><Relationship Id="rId35" Type="http://schemas.openxmlformats.org/officeDocument/2006/relationships/image" Target="../media/image32.png"/></Relationships>
</file>

<file path=ppt/slides/_rels/slide6.xml.rels><?xml version="1.0" encoding="UTF-8" standalone="yes"?>
<Relationships xmlns="http://schemas.openxmlformats.org/package/2006/relationships"><Relationship Id="rId13" Type="http://schemas.openxmlformats.org/officeDocument/2006/relationships/image" Target="../media/image48.png"/><Relationship Id="rId18" Type="http://schemas.openxmlformats.org/officeDocument/2006/relationships/image" Target="../media/image38.emf"/><Relationship Id="rId26" Type="http://schemas.openxmlformats.org/officeDocument/2006/relationships/image" Target="../media/image55.tif"/><Relationship Id="rId39" Type="http://schemas.openxmlformats.org/officeDocument/2006/relationships/image" Target="../media/image68.tif"/><Relationship Id="rId21" Type="http://schemas.openxmlformats.org/officeDocument/2006/relationships/image" Target="../media/image50.tif"/><Relationship Id="rId34" Type="http://schemas.openxmlformats.org/officeDocument/2006/relationships/image" Target="../media/image63.tif"/><Relationship Id="rId42" Type="http://schemas.openxmlformats.org/officeDocument/2006/relationships/image" Target="../media/image71.tif"/><Relationship Id="rId47" Type="http://schemas.openxmlformats.org/officeDocument/2006/relationships/image" Target="../media/image76.tif"/><Relationship Id="rId50" Type="http://schemas.openxmlformats.org/officeDocument/2006/relationships/image" Target="../media/image79.tif"/><Relationship Id="rId55" Type="http://schemas.openxmlformats.org/officeDocument/2006/relationships/image" Target="../media/image84.tif"/><Relationship Id="rId63" Type="http://schemas.openxmlformats.org/officeDocument/2006/relationships/image" Target="../media/image92.tif"/><Relationship Id="rId7" Type="http://schemas.openxmlformats.org/officeDocument/2006/relationships/image" Target="../media/image42.png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37.emf"/><Relationship Id="rId20" Type="http://schemas.openxmlformats.org/officeDocument/2006/relationships/image" Target="../media/image39.emf"/><Relationship Id="rId29" Type="http://schemas.openxmlformats.org/officeDocument/2006/relationships/image" Target="../media/image58.tif"/><Relationship Id="rId41" Type="http://schemas.openxmlformats.org/officeDocument/2006/relationships/image" Target="../media/image70.tif"/><Relationship Id="rId54" Type="http://schemas.openxmlformats.org/officeDocument/2006/relationships/image" Target="../media/image83.tif"/><Relationship Id="rId62" Type="http://schemas.openxmlformats.org/officeDocument/2006/relationships/image" Target="../media/image91.png"/><Relationship Id="rId1" Type="http://schemas.openxmlformats.org/officeDocument/2006/relationships/vmlDrawing" Target="../drawings/vmlDrawing4.vml"/><Relationship Id="rId6" Type="http://schemas.openxmlformats.org/officeDocument/2006/relationships/image" Target="../media/image36.emf"/><Relationship Id="rId11" Type="http://schemas.openxmlformats.org/officeDocument/2006/relationships/image" Target="../media/image46.png"/><Relationship Id="rId24" Type="http://schemas.openxmlformats.org/officeDocument/2006/relationships/image" Target="../media/image53.tif"/><Relationship Id="rId32" Type="http://schemas.openxmlformats.org/officeDocument/2006/relationships/image" Target="../media/image61.tif"/><Relationship Id="rId37" Type="http://schemas.openxmlformats.org/officeDocument/2006/relationships/image" Target="../media/image66.tif"/><Relationship Id="rId40" Type="http://schemas.openxmlformats.org/officeDocument/2006/relationships/image" Target="../media/image69.tif"/><Relationship Id="rId45" Type="http://schemas.openxmlformats.org/officeDocument/2006/relationships/image" Target="../media/image74.tif"/><Relationship Id="rId53" Type="http://schemas.openxmlformats.org/officeDocument/2006/relationships/image" Target="../media/image82.tif"/><Relationship Id="rId58" Type="http://schemas.openxmlformats.org/officeDocument/2006/relationships/image" Target="../media/image87.tif"/><Relationship Id="rId5" Type="http://schemas.openxmlformats.org/officeDocument/2006/relationships/oleObject" Target="../embeddings/oleObject8.bin"/><Relationship Id="rId15" Type="http://schemas.openxmlformats.org/officeDocument/2006/relationships/oleObject" Target="../embeddings/oleObject9.bin"/><Relationship Id="rId23" Type="http://schemas.openxmlformats.org/officeDocument/2006/relationships/image" Target="../media/image52.tif"/><Relationship Id="rId28" Type="http://schemas.openxmlformats.org/officeDocument/2006/relationships/image" Target="../media/image57.tif"/><Relationship Id="rId36" Type="http://schemas.openxmlformats.org/officeDocument/2006/relationships/image" Target="../media/image65.tif"/><Relationship Id="rId49" Type="http://schemas.openxmlformats.org/officeDocument/2006/relationships/image" Target="../media/image78.tif"/><Relationship Id="rId57" Type="http://schemas.openxmlformats.org/officeDocument/2006/relationships/image" Target="../media/image86.tif"/><Relationship Id="rId61" Type="http://schemas.openxmlformats.org/officeDocument/2006/relationships/image" Target="../media/image90.tif"/><Relationship Id="rId10" Type="http://schemas.openxmlformats.org/officeDocument/2006/relationships/image" Target="../media/image45.png"/><Relationship Id="rId19" Type="http://schemas.openxmlformats.org/officeDocument/2006/relationships/oleObject" Target="../embeddings/oleObject11.bin"/><Relationship Id="rId31" Type="http://schemas.openxmlformats.org/officeDocument/2006/relationships/image" Target="../media/image60.tif"/><Relationship Id="rId44" Type="http://schemas.openxmlformats.org/officeDocument/2006/relationships/image" Target="../media/image73.tif"/><Relationship Id="rId52" Type="http://schemas.openxmlformats.org/officeDocument/2006/relationships/image" Target="../media/image81.tif"/><Relationship Id="rId60" Type="http://schemas.openxmlformats.org/officeDocument/2006/relationships/image" Target="../media/image89.tif"/><Relationship Id="rId4" Type="http://schemas.openxmlformats.org/officeDocument/2006/relationships/image" Target="../media/image41.png"/><Relationship Id="rId9" Type="http://schemas.openxmlformats.org/officeDocument/2006/relationships/image" Target="../media/image44.png"/><Relationship Id="rId14" Type="http://schemas.openxmlformats.org/officeDocument/2006/relationships/image" Target="../media/image49.png"/><Relationship Id="rId22" Type="http://schemas.openxmlformats.org/officeDocument/2006/relationships/image" Target="../media/image51.tif"/><Relationship Id="rId27" Type="http://schemas.openxmlformats.org/officeDocument/2006/relationships/image" Target="../media/image56.tif"/><Relationship Id="rId30" Type="http://schemas.openxmlformats.org/officeDocument/2006/relationships/image" Target="../media/image59.tif"/><Relationship Id="rId35" Type="http://schemas.openxmlformats.org/officeDocument/2006/relationships/image" Target="../media/image64.tif"/><Relationship Id="rId43" Type="http://schemas.openxmlformats.org/officeDocument/2006/relationships/image" Target="../media/image72.tif"/><Relationship Id="rId48" Type="http://schemas.openxmlformats.org/officeDocument/2006/relationships/image" Target="../media/image77.tif"/><Relationship Id="rId56" Type="http://schemas.openxmlformats.org/officeDocument/2006/relationships/image" Target="../media/image85.tif"/><Relationship Id="rId64" Type="http://schemas.openxmlformats.org/officeDocument/2006/relationships/image" Target="../media/image93.tif"/><Relationship Id="rId8" Type="http://schemas.openxmlformats.org/officeDocument/2006/relationships/image" Target="../media/image43.png"/><Relationship Id="rId51" Type="http://schemas.openxmlformats.org/officeDocument/2006/relationships/image" Target="../media/image80.tif"/><Relationship Id="rId3" Type="http://schemas.openxmlformats.org/officeDocument/2006/relationships/image" Target="../media/image40.png"/><Relationship Id="rId12" Type="http://schemas.openxmlformats.org/officeDocument/2006/relationships/image" Target="../media/image47.png"/><Relationship Id="rId17" Type="http://schemas.openxmlformats.org/officeDocument/2006/relationships/oleObject" Target="../embeddings/oleObject10.bin"/><Relationship Id="rId25" Type="http://schemas.openxmlformats.org/officeDocument/2006/relationships/image" Target="../media/image54.tif"/><Relationship Id="rId33" Type="http://schemas.openxmlformats.org/officeDocument/2006/relationships/image" Target="../media/image62.tif"/><Relationship Id="rId38" Type="http://schemas.openxmlformats.org/officeDocument/2006/relationships/image" Target="../media/image67.tif"/><Relationship Id="rId46" Type="http://schemas.openxmlformats.org/officeDocument/2006/relationships/image" Target="../media/image75.tif"/><Relationship Id="rId59" Type="http://schemas.openxmlformats.org/officeDocument/2006/relationships/image" Target="../media/image88.tif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94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Textfeld 44"/>
          <p:cNvSpPr txBox="1"/>
          <p:nvPr/>
        </p:nvSpPr>
        <p:spPr>
          <a:xfrm>
            <a:off x="227023" y="117063"/>
            <a:ext cx="23317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upplementary Table 1</a:t>
            </a:r>
            <a:endParaRPr lang="en-US" dirty="0"/>
          </a:p>
        </p:txBody>
      </p:sp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81433250"/>
              </p:ext>
            </p:extLst>
          </p:nvPr>
        </p:nvGraphicFramePr>
        <p:xfrm>
          <a:off x="381000" y="609600"/>
          <a:ext cx="3657600" cy="6659880"/>
        </p:xfrm>
        <a:graphic>
          <a:graphicData uri="http://schemas.openxmlformats.org/drawingml/2006/table">
            <a:tbl>
              <a:tblPr/>
              <a:tblGrid>
                <a:gridCol w="609600">
                  <a:extLst>
                    <a:ext uri="{9D8B030D-6E8A-4147-A177-3AD203B41FA5}">
                      <a16:colId xmlns:a16="http://schemas.microsoft.com/office/drawing/2014/main" val="3495552508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4112483281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323591003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3555386843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3149610625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2069926721"/>
                    </a:ext>
                  </a:extLst>
                </a:gridCol>
              </a:tblGrid>
              <a:tr h="502920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reatment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imal ID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ex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core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edian all animal scanned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edian animal used**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80872989"/>
                  </a:ext>
                </a:extLst>
              </a:tr>
              <a:tr h="198120">
                <a:tc rowSpan="13"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aline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4 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13"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4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13"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94901569"/>
                  </a:ext>
                </a:extLst>
              </a:tr>
              <a:tr h="19812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2 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271416618"/>
                  </a:ext>
                </a:extLst>
              </a:tr>
              <a:tr h="19812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8 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75654347"/>
                  </a:ext>
                </a:extLst>
              </a:tr>
              <a:tr h="19812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12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660707662"/>
                  </a:ext>
                </a:extLst>
              </a:tr>
              <a:tr h="19812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5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94001720"/>
                  </a:ext>
                </a:extLst>
              </a:tr>
              <a:tr h="19812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9 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72933328"/>
                  </a:ext>
                </a:extLst>
              </a:tr>
              <a:tr h="19812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5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922097268"/>
                  </a:ext>
                </a:extLst>
              </a:tr>
              <a:tr h="19812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7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237006213"/>
                  </a:ext>
                </a:extLst>
              </a:tr>
              <a:tr h="19812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6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265820908"/>
                  </a:ext>
                </a:extLst>
              </a:tr>
              <a:tr h="19812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4*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900712376"/>
                  </a:ext>
                </a:extLst>
              </a:tr>
              <a:tr h="19812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3*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960474512"/>
                  </a:ext>
                </a:extLst>
              </a:tr>
              <a:tr h="19812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2*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789413094"/>
                  </a:ext>
                </a:extLst>
              </a:tr>
              <a:tr h="20574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3*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121631561"/>
                  </a:ext>
                </a:extLst>
              </a:tr>
              <a:tr h="198120">
                <a:tc rowSpan="13"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lemastine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1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13"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7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13"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1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66099139"/>
                  </a:ext>
                </a:extLst>
              </a:tr>
              <a:tr h="19812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11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863590373"/>
                  </a:ext>
                </a:extLst>
              </a:tr>
              <a:tr h="19812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9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765031058"/>
                  </a:ext>
                </a:extLst>
              </a:tr>
              <a:tr h="19812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1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549805287"/>
                  </a:ext>
                </a:extLst>
              </a:tr>
              <a:tr h="19812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7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92422364"/>
                  </a:ext>
                </a:extLst>
              </a:tr>
              <a:tr h="19812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4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334359685"/>
                  </a:ext>
                </a:extLst>
              </a:tr>
              <a:tr h="19812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1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5921294"/>
                  </a:ext>
                </a:extLst>
              </a:tr>
              <a:tr h="19812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5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63388830"/>
                  </a:ext>
                </a:extLst>
              </a:tr>
              <a:tr h="19812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11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35763884"/>
                  </a:ext>
                </a:extLst>
              </a:tr>
              <a:tr h="19812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6*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699927145"/>
                  </a:ext>
                </a:extLst>
              </a:tr>
              <a:tr h="19812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7*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512154878"/>
                  </a:ext>
                </a:extLst>
              </a:tr>
              <a:tr h="19812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4*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36995110"/>
                  </a:ext>
                </a:extLst>
              </a:tr>
              <a:tr h="20574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10*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59740721"/>
                  </a:ext>
                </a:extLst>
              </a:tr>
              <a:tr h="594360">
                <a:tc gridSpan="5">
                  <a:txBody>
                    <a:bodyPr/>
                    <a:lstStyle/>
                    <a:p>
                      <a:pPr algn="l" rtl="0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animal exclude for behavior analisys due to low/high score for the corresponding treatment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73742410"/>
                  </a:ext>
                </a:extLst>
              </a:tr>
              <a:tr h="396240">
                <a:tc gridSpan="5">
                  <a:txBody>
                    <a:bodyPr/>
                    <a:lstStyle/>
                    <a:p>
                      <a:pPr algn="l" rtl="0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*median only for those animals used for behavior test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7340262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95596109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Textfeld 44"/>
          <p:cNvSpPr txBox="1"/>
          <p:nvPr/>
        </p:nvSpPr>
        <p:spPr>
          <a:xfrm>
            <a:off x="101517" y="269463"/>
            <a:ext cx="21621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upplementary Fig</a:t>
            </a:r>
            <a:r>
              <a:rPr lang="en-US" dirty="0"/>
              <a:t>. </a:t>
            </a:r>
            <a:r>
              <a:rPr lang="en-US" dirty="0" smtClean="0"/>
              <a:t>1</a:t>
            </a:r>
            <a:endParaRPr lang="en-US" dirty="0"/>
          </a:p>
        </p:txBody>
      </p:sp>
      <p:sp>
        <p:nvSpPr>
          <p:cNvPr id="4" name="TextBox 3"/>
          <p:cNvSpPr txBox="1"/>
          <p:nvPr/>
        </p:nvSpPr>
        <p:spPr>
          <a:xfrm>
            <a:off x="41472" y="792765"/>
            <a:ext cx="27122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a</a:t>
            </a:r>
            <a:endParaRPr lang="en-US" sz="1400" dirty="0"/>
          </a:p>
        </p:txBody>
      </p:sp>
      <p:sp>
        <p:nvSpPr>
          <p:cNvPr id="5" name="TextBox 4"/>
          <p:cNvSpPr txBox="1"/>
          <p:nvPr/>
        </p:nvSpPr>
        <p:spPr>
          <a:xfrm>
            <a:off x="2786031" y="792764"/>
            <a:ext cx="27924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b</a:t>
            </a:r>
            <a:endParaRPr lang="en-US" sz="1400" dirty="0"/>
          </a:p>
        </p:txBody>
      </p:sp>
      <p:sp>
        <p:nvSpPr>
          <p:cNvPr id="10" name="TextBox 9"/>
          <p:cNvSpPr txBox="1"/>
          <p:nvPr/>
        </p:nvSpPr>
        <p:spPr>
          <a:xfrm>
            <a:off x="4661408" y="792763"/>
            <a:ext cx="2600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c</a:t>
            </a:r>
            <a:endParaRPr lang="en-US" sz="1400" dirty="0"/>
          </a:p>
        </p:txBody>
      </p:sp>
      <p:sp>
        <p:nvSpPr>
          <p:cNvPr id="2" name="TextBox 1"/>
          <p:cNvSpPr txBox="1"/>
          <p:nvPr/>
        </p:nvSpPr>
        <p:spPr>
          <a:xfrm>
            <a:off x="3729789" y="792763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dirty="0"/>
          </a:p>
        </p:txBody>
      </p:sp>
      <p:graphicFrame>
        <p:nvGraphicFramePr>
          <p:cNvPr id="11" name="Object 10"/>
          <p:cNvGraphicFramePr>
            <a:graphicFrameLocks noChangeAspect="1"/>
          </p:cNvGraphicFramePr>
          <p:nvPr>
            <p:extLst/>
          </p:nvPr>
        </p:nvGraphicFramePr>
        <p:xfrm>
          <a:off x="2499761" y="1076476"/>
          <a:ext cx="4441733" cy="19208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41" name="Prism 10" r:id="rId3" imgW="7265677" imgH="3140665" progId="Prism10.Document">
                  <p:embed/>
                </p:oleObj>
              </mc:Choice>
              <mc:Fallback>
                <p:oleObj name="Prism 10" r:id="rId3" imgW="7265677" imgH="3140665" progId="Prism10.Document">
                  <p:embed/>
                  <p:pic>
                    <p:nvPicPr>
                      <p:cNvPr id="11" name="Object 10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499761" y="1076476"/>
                        <a:ext cx="4441733" cy="19208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Object 11"/>
          <p:cNvGraphicFramePr>
            <a:graphicFrameLocks noChangeAspect="1"/>
          </p:cNvGraphicFramePr>
          <p:nvPr>
            <p:extLst/>
          </p:nvPr>
        </p:nvGraphicFramePr>
        <p:xfrm>
          <a:off x="-11192" y="1126457"/>
          <a:ext cx="2198688" cy="17970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42" name="Prism 10" r:id="rId5" imgW="3079769" imgH="2515772" progId="Prism10.Document">
                  <p:embed/>
                </p:oleObj>
              </mc:Choice>
              <mc:Fallback>
                <p:oleObj name="Prism 10" r:id="rId5" imgW="3079769" imgH="2515772" progId="Prism10.Document">
                  <p:embed/>
                  <p:pic>
                    <p:nvPicPr>
                      <p:cNvPr id="12" name="Object 11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-11192" y="1126457"/>
                        <a:ext cx="2198688" cy="17970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" name="Object 13"/>
          <p:cNvGraphicFramePr>
            <a:graphicFrameLocks noChangeAspect="1"/>
          </p:cNvGraphicFramePr>
          <p:nvPr>
            <p:extLst/>
          </p:nvPr>
        </p:nvGraphicFramePr>
        <p:xfrm>
          <a:off x="973138" y="6599238"/>
          <a:ext cx="4738687" cy="31892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43" name="Prism 10" r:id="rId7" imgW="4739158" imgH="3189260" progId="Prism10.Document">
                  <p:embed/>
                </p:oleObj>
              </mc:Choice>
              <mc:Fallback>
                <p:oleObj name="Prism 10" r:id="rId7" imgW="4739158" imgH="3189260" progId="Prism10.Document">
                  <p:embed/>
                  <p:pic>
                    <p:nvPicPr>
                      <p:cNvPr id="14" name="Object 13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973138" y="6599238"/>
                        <a:ext cx="4738687" cy="31892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5" name="TextBox 14"/>
          <p:cNvSpPr txBox="1"/>
          <p:nvPr/>
        </p:nvSpPr>
        <p:spPr>
          <a:xfrm>
            <a:off x="37766" y="3597572"/>
            <a:ext cx="27924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d</a:t>
            </a:r>
            <a:endParaRPr lang="en-US" sz="1400" dirty="0"/>
          </a:p>
        </p:txBody>
      </p:sp>
      <p:sp>
        <p:nvSpPr>
          <p:cNvPr id="16" name="TextBox 15"/>
          <p:cNvSpPr txBox="1"/>
          <p:nvPr/>
        </p:nvSpPr>
        <p:spPr>
          <a:xfrm>
            <a:off x="3635276" y="3597571"/>
            <a:ext cx="2744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e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54226" y="6591465"/>
            <a:ext cx="23916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f</a:t>
            </a:r>
          </a:p>
        </p:txBody>
      </p:sp>
      <p:graphicFrame>
        <p:nvGraphicFramePr>
          <p:cNvPr id="19" name="Object 18"/>
          <p:cNvGraphicFramePr>
            <a:graphicFrameLocks noChangeAspect="1"/>
          </p:cNvGraphicFramePr>
          <p:nvPr>
            <p:extLst/>
          </p:nvPr>
        </p:nvGraphicFramePr>
        <p:xfrm>
          <a:off x="0" y="3997325"/>
          <a:ext cx="3406775" cy="24685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44" name="Prism 10" r:id="rId9" imgW="6166737" imgH="4472523" progId="Prism10.Document">
                  <p:embed/>
                </p:oleObj>
              </mc:Choice>
              <mc:Fallback>
                <p:oleObj name="Prism 10" r:id="rId9" imgW="6166737" imgH="4472523" progId="Prism10.Document">
                  <p:embed/>
                  <p:pic>
                    <p:nvPicPr>
                      <p:cNvPr id="19" name="Object 18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0" y="3997325"/>
                        <a:ext cx="3406775" cy="24685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0" name="Object 19"/>
          <p:cNvGraphicFramePr>
            <a:graphicFrameLocks noChangeAspect="1"/>
          </p:cNvGraphicFramePr>
          <p:nvPr>
            <p:extLst/>
          </p:nvPr>
        </p:nvGraphicFramePr>
        <p:xfrm>
          <a:off x="3635375" y="3997325"/>
          <a:ext cx="3187700" cy="24685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45" name="Prism 10" r:id="rId11" imgW="5767548" imgH="4466404" progId="Prism10.Document">
                  <p:embed/>
                </p:oleObj>
              </mc:Choice>
              <mc:Fallback>
                <p:oleObj name="Prism 10" r:id="rId11" imgW="5767548" imgH="4466404" progId="Prism10.Document">
                  <p:embed/>
                  <p:pic>
                    <p:nvPicPr>
                      <p:cNvPr id="20" name="Object 19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3635375" y="3997325"/>
                        <a:ext cx="3187700" cy="24685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05296597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Textfeld 44"/>
          <p:cNvSpPr txBox="1"/>
          <p:nvPr/>
        </p:nvSpPr>
        <p:spPr>
          <a:xfrm>
            <a:off x="202431" y="333631"/>
            <a:ext cx="21621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upplementary Fig</a:t>
            </a:r>
            <a:r>
              <a:rPr lang="en-US" dirty="0"/>
              <a:t>. </a:t>
            </a:r>
            <a:r>
              <a:rPr lang="en-US" dirty="0" smtClean="0"/>
              <a:t>2</a:t>
            </a:r>
            <a:endParaRPr lang="en-US" dirty="0"/>
          </a:p>
        </p:txBody>
      </p:sp>
      <p:graphicFrame>
        <p:nvGraphicFramePr>
          <p:cNvPr id="4" name="Objec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918168"/>
              </p:ext>
            </p:extLst>
          </p:nvPr>
        </p:nvGraphicFramePr>
        <p:xfrm>
          <a:off x="122238" y="1046163"/>
          <a:ext cx="3230562" cy="21351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01" name="Prism 10" r:id="rId3" imgW="4045886" imgH="2672715" progId="Prism10.Document">
                  <p:embed/>
                </p:oleObj>
              </mc:Choice>
              <mc:Fallback>
                <p:oleObj name="Prism 10" r:id="rId3" imgW="4045886" imgH="2672715" progId="Prism10.Document">
                  <p:embed/>
                  <p:pic>
                    <p:nvPicPr>
                      <p:cNvPr id="4" name="Object 3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22238" y="1046163"/>
                        <a:ext cx="3230562" cy="21351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10" name="Group 9"/>
          <p:cNvGrpSpPr/>
          <p:nvPr/>
        </p:nvGrpSpPr>
        <p:grpSpPr>
          <a:xfrm>
            <a:off x="3352800" y="1222539"/>
            <a:ext cx="1264968" cy="798489"/>
            <a:chOff x="2025296" y="665991"/>
            <a:chExt cx="1264968" cy="798489"/>
          </a:xfrm>
        </p:grpSpPr>
        <p:sp>
          <p:nvSpPr>
            <p:cNvPr id="11" name="TextBox 10"/>
            <p:cNvSpPr txBox="1"/>
            <p:nvPr/>
          </p:nvSpPr>
          <p:spPr>
            <a:xfrm>
              <a:off x="2039112" y="1074186"/>
              <a:ext cx="800219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Vehicle/HI</a:t>
              </a:r>
              <a:endParaRPr lang="en-US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2039112" y="799988"/>
              <a:ext cx="1018227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Vehicle/Sham</a:t>
              </a:r>
              <a:endParaRPr lang="en-US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2039601" y="944568"/>
              <a:ext cx="1250663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lemastine/Sham</a:t>
              </a:r>
              <a:endParaRPr lang="en-US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Oval 13"/>
            <p:cNvSpPr/>
            <p:nvPr/>
          </p:nvSpPr>
          <p:spPr>
            <a:xfrm>
              <a:off x="2029968" y="1193294"/>
              <a:ext cx="53353" cy="48459"/>
            </a:xfrm>
            <a:prstGeom prst="ellipse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5" name="Rectangle 14"/>
            <p:cNvSpPr/>
            <p:nvPr/>
          </p:nvSpPr>
          <p:spPr>
            <a:xfrm>
              <a:off x="2028942" y="1319708"/>
              <a:ext cx="45719" cy="4571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2035851" y="665991"/>
              <a:ext cx="537327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ham</a:t>
              </a:r>
              <a:endParaRPr lang="en-US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2039112" y="1210564"/>
              <a:ext cx="1032655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lemastine/HI</a:t>
              </a:r>
              <a:endParaRPr lang="en-US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Oval 17"/>
            <p:cNvSpPr/>
            <p:nvPr/>
          </p:nvSpPr>
          <p:spPr>
            <a:xfrm>
              <a:off x="2029331" y="768720"/>
              <a:ext cx="53353" cy="48459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9" name="Isosceles Triangle 18"/>
            <p:cNvSpPr/>
            <p:nvPr/>
          </p:nvSpPr>
          <p:spPr>
            <a:xfrm rot="10800000">
              <a:off x="2025296" y="896112"/>
              <a:ext cx="73152" cy="73152"/>
            </a:xfrm>
            <a:prstGeom prst="triangle">
              <a:avLst/>
            </a:prstGeom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0" name="Isosceles Triangle 19"/>
            <p:cNvSpPr/>
            <p:nvPr/>
          </p:nvSpPr>
          <p:spPr>
            <a:xfrm>
              <a:off x="2031181" y="1027603"/>
              <a:ext cx="73152" cy="73152"/>
            </a:xfrm>
            <a:prstGeom prst="triangle">
              <a:avLst/>
            </a:prstGeom>
            <a:solidFill>
              <a:schemeClr val="accent1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162776095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91731" y="237731"/>
            <a:ext cx="21621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upplementary Fig. 3</a:t>
            </a:r>
            <a:endParaRPr lang="en-US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13913" t="13948" r="29739" b="39344"/>
          <a:stretch/>
        </p:blipFill>
        <p:spPr>
          <a:xfrm>
            <a:off x="369597" y="606466"/>
            <a:ext cx="3864334" cy="2242268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233983" y="978010"/>
            <a:ext cx="27122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a</a:t>
            </a:r>
            <a:endParaRPr lang="en-US" sz="1400" dirty="0"/>
          </a:p>
        </p:txBody>
      </p:sp>
      <p:sp>
        <p:nvSpPr>
          <p:cNvPr id="5" name="TextBox 4"/>
          <p:cNvSpPr txBox="1"/>
          <p:nvPr/>
        </p:nvSpPr>
        <p:spPr>
          <a:xfrm>
            <a:off x="298035" y="2594220"/>
            <a:ext cx="27924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b</a:t>
            </a:r>
            <a:endParaRPr lang="en-US" sz="1400" dirty="0"/>
          </a:p>
        </p:txBody>
      </p:sp>
      <p:sp>
        <p:nvSpPr>
          <p:cNvPr id="12" name="TextBox 11"/>
          <p:cNvSpPr txBox="1"/>
          <p:nvPr/>
        </p:nvSpPr>
        <p:spPr>
          <a:xfrm>
            <a:off x="687513" y="2938443"/>
            <a:ext cx="10759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err="1" smtClean="0"/>
              <a:t>Bregma</a:t>
            </a:r>
            <a:r>
              <a:rPr lang="en-US" sz="1000" dirty="0" smtClean="0"/>
              <a:t> 0.70 mm</a:t>
            </a:r>
            <a:endParaRPr lang="de-DE" sz="1000" dirty="0"/>
          </a:p>
        </p:txBody>
      </p:sp>
      <p:sp>
        <p:nvSpPr>
          <p:cNvPr id="13" name="TextBox 12"/>
          <p:cNvSpPr txBox="1"/>
          <p:nvPr/>
        </p:nvSpPr>
        <p:spPr>
          <a:xfrm rot="16200000">
            <a:off x="-55540" y="4608563"/>
            <a:ext cx="11272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HI/</a:t>
            </a:r>
            <a:r>
              <a:rPr lang="en-US" sz="1200" dirty="0" err="1" smtClean="0"/>
              <a:t>Clemastine</a:t>
            </a:r>
            <a:r>
              <a:rPr lang="en-US" sz="1200" dirty="0" smtClean="0"/>
              <a:t> </a:t>
            </a:r>
            <a:endParaRPr lang="de-DE" sz="1200" dirty="0"/>
          </a:p>
        </p:txBody>
      </p:sp>
      <p:sp>
        <p:nvSpPr>
          <p:cNvPr id="14" name="TextBox 13"/>
          <p:cNvSpPr txBox="1"/>
          <p:nvPr/>
        </p:nvSpPr>
        <p:spPr>
          <a:xfrm rot="16200000">
            <a:off x="94351" y="3526312"/>
            <a:ext cx="82749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HI/Vehicle </a:t>
            </a:r>
            <a:endParaRPr lang="de-DE" sz="1200" dirty="0"/>
          </a:p>
        </p:txBody>
      </p:sp>
      <p:sp>
        <p:nvSpPr>
          <p:cNvPr id="15" name="TextBox 14"/>
          <p:cNvSpPr txBox="1"/>
          <p:nvPr/>
        </p:nvSpPr>
        <p:spPr>
          <a:xfrm>
            <a:off x="1980723" y="2938444"/>
            <a:ext cx="115896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Bregma - 0.40 mm</a:t>
            </a:r>
            <a:endParaRPr lang="de-DE" sz="1000" dirty="0"/>
          </a:p>
        </p:txBody>
      </p:sp>
      <p:sp>
        <p:nvSpPr>
          <p:cNvPr id="16" name="TextBox 15"/>
          <p:cNvSpPr txBox="1"/>
          <p:nvPr/>
        </p:nvSpPr>
        <p:spPr>
          <a:xfrm>
            <a:off x="3251027" y="2938444"/>
            <a:ext cx="115896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err="1" smtClean="0"/>
              <a:t>Bregma</a:t>
            </a:r>
            <a:r>
              <a:rPr lang="en-US" sz="1000" dirty="0" smtClean="0"/>
              <a:t> - 2.80 mm</a:t>
            </a:r>
            <a:endParaRPr lang="de-DE" sz="1000" dirty="0"/>
          </a:p>
        </p:txBody>
      </p:sp>
      <p:sp>
        <p:nvSpPr>
          <p:cNvPr id="17" name="TextBox 16"/>
          <p:cNvSpPr txBox="1"/>
          <p:nvPr/>
        </p:nvSpPr>
        <p:spPr>
          <a:xfrm>
            <a:off x="4586951" y="2938444"/>
            <a:ext cx="121463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err="1" smtClean="0"/>
              <a:t>Bregma</a:t>
            </a:r>
            <a:r>
              <a:rPr lang="en-US" sz="1000" dirty="0" smtClean="0"/>
              <a:t> - 4.30 mm</a:t>
            </a:r>
            <a:endParaRPr lang="de-DE" sz="1000" dirty="0"/>
          </a:p>
        </p:txBody>
      </p:sp>
      <p:pic>
        <p:nvPicPr>
          <p:cNvPr id="18" name="Picture 17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650917" y="4288292"/>
            <a:ext cx="1188720" cy="985585"/>
          </a:xfrm>
          <a:prstGeom prst="rect">
            <a:avLst/>
          </a:prstGeom>
        </p:spPr>
      </p:pic>
      <p:pic>
        <p:nvPicPr>
          <p:cNvPr id="19" name="Picture 18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950972" y="4289164"/>
            <a:ext cx="1188721" cy="984713"/>
          </a:xfrm>
          <a:prstGeom prst="rect">
            <a:avLst/>
          </a:prstGeom>
        </p:spPr>
      </p:pic>
      <p:pic>
        <p:nvPicPr>
          <p:cNvPr id="20" name="Picture 19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251028" y="4288291"/>
            <a:ext cx="1188721" cy="985585"/>
          </a:xfrm>
          <a:prstGeom prst="rect">
            <a:avLst/>
          </a:prstGeom>
        </p:spPr>
      </p:pic>
      <p:pic>
        <p:nvPicPr>
          <p:cNvPr id="21" name="Picture 20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551084" y="4288749"/>
            <a:ext cx="1188720" cy="985127"/>
          </a:xfrm>
          <a:prstGeom prst="rect">
            <a:avLst/>
          </a:prstGeom>
        </p:spPr>
      </p:pic>
      <p:pic>
        <p:nvPicPr>
          <p:cNvPr id="22" name="Picture 21"/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t="4762"/>
          <a:stretch/>
        </p:blipFill>
        <p:spPr>
          <a:xfrm>
            <a:off x="650917" y="3197840"/>
            <a:ext cx="1188720" cy="985585"/>
          </a:xfrm>
          <a:prstGeom prst="rect">
            <a:avLst/>
          </a:prstGeom>
        </p:spPr>
      </p:pic>
      <p:pic>
        <p:nvPicPr>
          <p:cNvPr id="23" name="Picture 22"/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950972" y="3197839"/>
            <a:ext cx="1188720" cy="985585"/>
          </a:xfrm>
          <a:prstGeom prst="rect">
            <a:avLst/>
          </a:prstGeom>
        </p:spPr>
      </p:pic>
      <p:pic>
        <p:nvPicPr>
          <p:cNvPr id="24" name="Picture 23"/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251027" y="3197838"/>
            <a:ext cx="1188720" cy="985586"/>
          </a:xfrm>
          <a:prstGeom prst="rect">
            <a:avLst/>
          </a:prstGeom>
        </p:spPr>
      </p:pic>
      <p:pic>
        <p:nvPicPr>
          <p:cNvPr id="25" name="Picture 24"/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551082" y="3197837"/>
            <a:ext cx="1188720" cy="985587"/>
          </a:xfrm>
          <a:prstGeom prst="rect">
            <a:avLst/>
          </a:prstGeom>
        </p:spPr>
      </p:pic>
      <p:sp>
        <p:nvSpPr>
          <p:cNvPr id="26" name="Freeform 25"/>
          <p:cNvSpPr/>
          <p:nvPr/>
        </p:nvSpPr>
        <p:spPr>
          <a:xfrm>
            <a:off x="992310" y="4620867"/>
            <a:ext cx="159327" cy="236005"/>
          </a:xfrm>
          <a:custGeom>
            <a:avLst/>
            <a:gdLst>
              <a:gd name="connsiteX0" fmla="*/ 100445 w 159327"/>
              <a:gd name="connsiteY0" fmla="*/ 20782 h 236005"/>
              <a:gd name="connsiteX1" fmla="*/ 83127 w 159327"/>
              <a:gd name="connsiteY1" fmla="*/ 13854 h 236005"/>
              <a:gd name="connsiteX2" fmla="*/ 72736 w 159327"/>
              <a:gd name="connsiteY2" fmla="*/ 10391 h 236005"/>
              <a:gd name="connsiteX3" fmla="*/ 51955 w 159327"/>
              <a:gd name="connsiteY3" fmla="*/ 0 h 236005"/>
              <a:gd name="connsiteX4" fmla="*/ 24245 w 159327"/>
              <a:gd name="connsiteY4" fmla="*/ 3463 h 236005"/>
              <a:gd name="connsiteX5" fmla="*/ 17318 w 159327"/>
              <a:gd name="connsiteY5" fmla="*/ 10391 h 236005"/>
              <a:gd name="connsiteX6" fmla="*/ 6927 w 159327"/>
              <a:gd name="connsiteY6" fmla="*/ 31173 h 236005"/>
              <a:gd name="connsiteX7" fmla="*/ 0 w 159327"/>
              <a:gd name="connsiteY7" fmla="*/ 41563 h 236005"/>
              <a:gd name="connsiteX8" fmla="*/ 3464 w 159327"/>
              <a:gd name="connsiteY8" fmla="*/ 69273 h 236005"/>
              <a:gd name="connsiteX9" fmla="*/ 6927 w 159327"/>
              <a:gd name="connsiteY9" fmla="*/ 79663 h 236005"/>
              <a:gd name="connsiteX10" fmla="*/ 17318 w 159327"/>
              <a:gd name="connsiteY10" fmla="*/ 83127 h 236005"/>
              <a:gd name="connsiteX11" fmla="*/ 34636 w 159327"/>
              <a:gd name="connsiteY11" fmla="*/ 90054 h 236005"/>
              <a:gd name="connsiteX12" fmla="*/ 51955 w 159327"/>
              <a:gd name="connsiteY12" fmla="*/ 121227 h 236005"/>
              <a:gd name="connsiteX13" fmla="*/ 58882 w 159327"/>
              <a:gd name="connsiteY13" fmla="*/ 159327 h 236005"/>
              <a:gd name="connsiteX14" fmla="*/ 69273 w 159327"/>
              <a:gd name="connsiteY14" fmla="*/ 187036 h 236005"/>
              <a:gd name="connsiteX15" fmla="*/ 72736 w 159327"/>
              <a:gd name="connsiteY15" fmla="*/ 204354 h 236005"/>
              <a:gd name="connsiteX16" fmla="*/ 83127 w 159327"/>
              <a:gd name="connsiteY16" fmla="*/ 211282 h 236005"/>
              <a:gd name="connsiteX17" fmla="*/ 107373 w 159327"/>
              <a:gd name="connsiteY17" fmla="*/ 221673 h 236005"/>
              <a:gd name="connsiteX18" fmla="*/ 159327 w 159327"/>
              <a:gd name="connsiteY18" fmla="*/ 232063 h 236005"/>
              <a:gd name="connsiteX19" fmla="*/ 155864 w 159327"/>
              <a:gd name="connsiteY19" fmla="*/ 207818 h 236005"/>
              <a:gd name="connsiteX20" fmla="*/ 152400 w 159327"/>
              <a:gd name="connsiteY20" fmla="*/ 197427 h 236005"/>
              <a:gd name="connsiteX21" fmla="*/ 148936 w 159327"/>
              <a:gd name="connsiteY21" fmla="*/ 173182 h 236005"/>
              <a:gd name="connsiteX22" fmla="*/ 142009 w 159327"/>
              <a:gd name="connsiteY22" fmla="*/ 110836 h 236005"/>
              <a:gd name="connsiteX23" fmla="*/ 138545 w 159327"/>
              <a:gd name="connsiteY23" fmla="*/ 100445 h 236005"/>
              <a:gd name="connsiteX24" fmla="*/ 142009 w 159327"/>
              <a:gd name="connsiteY24" fmla="*/ 90054 h 236005"/>
              <a:gd name="connsiteX25" fmla="*/ 142009 w 159327"/>
              <a:gd name="connsiteY25" fmla="*/ 45027 h 236005"/>
              <a:gd name="connsiteX26" fmla="*/ 131618 w 159327"/>
              <a:gd name="connsiteY26" fmla="*/ 34636 h 236005"/>
              <a:gd name="connsiteX27" fmla="*/ 110836 w 159327"/>
              <a:gd name="connsiteY27" fmla="*/ 20782 h 236005"/>
              <a:gd name="connsiteX28" fmla="*/ 100445 w 159327"/>
              <a:gd name="connsiteY28" fmla="*/ 20782 h 23600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159327" h="236005">
                <a:moveTo>
                  <a:pt x="100445" y="20782"/>
                </a:moveTo>
                <a:cubicBezTo>
                  <a:pt x="94672" y="18473"/>
                  <a:pt x="88949" y="16037"/>
                  <a:pt x="83127" y="13854"/>
                </a:cubicBezTo>
                <a:cubicBezTo>
                  <a:pt x="79709" y="12572"/>
                  <a:pt x="75867" y="12269"/>
                  <a:pt x="72736" y="10391"/>
                </a:cubicBezTo>
                <a:cubicBezTo>
                  <a:pt x="50678" y="-2844"/>
                  <a:pt x="86127" y="8542"/>
                  <a:pt x="51955" y="0"/>
                </a:cubicBezTo>
                <a:cubicBezTo>
                  <a:pt x="42718" y="1154"/>
                  <a:pt x="33161" y="788"/>
                  <a:pt x="24245" y="3463"/>
                </a:cubicBezTo>
                <a:cubicBezTo>
                  <a:pt x="21117" y="4401"/>
                  <a:pt x="19358" y="7841"/>
                  <a:pt x="17318" y="10391"/>
                </a:cubicBezTo>
                <a:cubicBezTo>
                  <a:pt x="4082" y="26937"/>
                  <a:pt x="15464" y="14099"/>
                  <a:pt x="6927" y="31173"/>
                </a:cubicBezTo>
                <a:cubicBezTo>
                  <a:pt x="5065" y="34896"/>
                  <a:pt x="2309" y="38100"/>
                  <a:pt x="0" y="41563"/>
                </a:cubicBezTo>
                <a:cubicBezTo>
                  <a:pt x="1155" y="50800"/>
                  <a:pt x="1799" y="60115"/>
                  <a:pt x="3464" y="69273"/>
                </a:cubicBezTo>
                <a:cubicBezTo>
                  <a:pt x="4117" y="72865"/>
                  <a:pt x="4346" y="77082"/>
                  <a:pt x="6927" y="79663"/>
                </a:cubicBezTo>
                <a:cubicBezTo>
                  <a:pt x="9509" y="82245"/>
                  <a:pt x="13899" y="81845"/>
                  <a:pt x="17318" y="83127"/>
                </a:cubicBezTo>
                <a:cubicBezTo>
                  <a:pt x="23139" y="85310"/>
                  <a:pt x="28863" y="87745"/>
                  <a:pt x="34636" y="90054"/>
                </a:cubicBezTo>
                <a:cubicBezTo>
                  <a:pt x="43113" y="115483"/>
                  <a:pt x="36401" y="105673"/>
                  <a:pt x="51955" y="121227"/>
                </a:cubicBezTo>
                <a:cubicBezTo>
                  <a:pt x="59897" y="145057"/>
                  <a:pt x="51049" y="116246"/>
                  <a:pt x="58882" y="159327"/>
                </a:cubicBezTo>
                <a:cubicBezTo>
                  <a:pt x="59788" y="164311"/>
                  <a:pt x="68691" y="185580"/>
                  <a:pt x="69273" y="187036"/>
                </a:cubicBezTo>
                <a:cubicBezTo>
                  <a:pt x="70427" y="192809"/>
                  <a:pt x="69815" y="199243"/>
                  <a:pt x="72736" y="204354"/>
                </a:cubicBezTo>
                <a:cubicBezTo>
                  <a:pt x="74801" y="207968"/>
                  <a:pt x="79876" y="208681"/>
                  <a:pt x="83127" y="211282"/>
                </a:cubicBezTo>
                <a:cubicBezTo>
                  <a:pt x="97913" y="223110"/>
                  <a:pt x="80192" y="216236"/>
                  <a:pt x="107373" y="221673"/>
                </a:cubicBezTo>
                <a:cubicBezTo>
                  <a:pt x="136854" y="241326"/>
                  <a:pt x="119880" y="236447"/>
                  <a:pt x="159327" y="232063"/>
                </a:cubicBezTo>
                <a:cubicBezTo>
                  <a:pt x="158173" y="223981"/>
                  <a:pt x="157465" y="215823"/>
                  <a:pt x="155864" y="207818"/>
                </a:cubicBezTo>
                <a:cubicBezTo>
                  <a:pt x="155148" y="204238"/>
                  <a:pt x="153116" y="201007"/>
                  <a:pt x="152400" y="197427"/>
                </a:cubicBezTo>
                <a:cubicBezTo>
                  <a:pt x="150799" y="189422"/>
                  <a:pt x="149838" y="181296"/>
                  <a:pt x="148936" y="173182"/>
                </a:cubicBezTo>
                <a:cubicBezTo>
                  <a:pt x="146745" y="153458"/>
                  <a:pt x="145989" y="130737"/>
                  <a:pt x="142009" y="110836"/>
                </a:cubicBezTo>
                <a:cubicBezTo>
                  <a:pt x="141293" y="107256"/>
                  <a:pt x="139700" y="103909"/>
                  <a:pt x="138545" y="100445"/>
                </a:cubicBezTo>
                <a:cubicBezTo>
                  <a:pt x="139700" y="96981"/>
                  <a:pt x="141123" y="93596"/>
                  <a:pt x="142009" y="90054"/>
                </a:cubicBezTo>
                <a:cubicBezTo>
                  <a:pt x="146019" y="74015"/>
                  <a:pt x="148226" y="62124"/>
                  <a:pt x="142009" y="45027"/>
                </a:cubicBezTo>
                <a:cubicBezTo>
                  <a:pt x="140335" y="40424"/>
                  <a:pt x="135485" y="37643"/>
                  <a:pt x="131618" y="34636"/>
                </a:cubicBezTo>
                <a:cubicBezTo>
                  <a:pt x="125046" y="29525"/>
                  <a:pt x="119161" y="20782"/>
                  <a:pt x="110836" y="20782"/>
                </a:cubicBezTo>
                <a:lnTo>
                  <a:pt x="100445" y="20782"/>
                </a:lnTo>
                <a:close/>
              </a:path>
            </a:pathLst>
          </a:custGeom>
          <a:noFill/>
          <a:ln>
            <a:solidFill>
              <a:schemeClr val="accent4">
                <a:lumMod val="60000"/>
                <a:lumOff val="40000"/>
              </a:schemeClr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27" name="Freeform 26"/>
          <p:cNvSpPr/>
          <p:nvPr/>
        </p:nvSpPr>
        <p:spPr>
          <a:xfrm>
            <a:off x="988846" y="3540212"/>
            <a:ext cx="169883" cy="233154"/>
          </a:xfrm>
          <a:custGeom>
            <a:avLst/>
            <a:gdLst>
              <a:gd name="connsiteX0" fmla="*/ 152400 w 169883"/>
              <a:gd name="connsiteY0" fmla="*/ 232064 h 233154"/>
              <a:gd name="connsiteX1" fmla="*/ 148937 w 169883"/>
              <a:gd name="connsiteY1" fmla="*/ 214746 h 233154"/>
              <a:gd name="connsiteX2" fmla="*/ 159328 w 169883"/>
              <a:gd name="connsiteY2" fmla="*/ 190500 h 233154"/>
              <a:gd name="connsiteX3" fmla="*/ 166255 w 169883"/>
              <a:gd name="connsiteY3" fmla="*/ 166255 h 233154"/>
              <a:gd name="connsiteX4" fmla="*/ 166255 w 169883"/>
              <a:gd name="connsiteY4" fmla="*/ 96982 h 233154"/>
              <a:gd name="connsiteX5" fmla="*/ 159328 w 169883"/>
              <a:gd name="connsiteY5" fmla="*/ 65809 h 233154"/>
              <a:gd name="connsiteX6" fmla="*/ 152400 w 169883"/>
              <a:gd name="connsiteY6" fmla="*/ 58882 h 233154"/>
              <a:gd name="connsiteX7" fmla="*/ 148937 w 169883"/>
              <a:gd name="connsiteY7" fmla="*/ 48491 h 233154"/>
              <a:gd name="connsiteX8" fmla="*/ 128155 w 169883"/>
              <a:gd name="connsiteY8" fmla="*/ 31173 h 233154"/>
              <a:gd name="connsiteX9" fmla="*/ 117764 w 169883"/>
              <a:gd name="connsiteY9" fmla="*/ 20782 h 233154"/>
              <a:gd name="connsiteX10" fmla="*/ 107373 w 169883"/>
              <a:gd name="connsiteY10" fmla="*/ 17318 h 233154"/>
              <a:gd name="connsiteX11" fmla="*/ 83128 w 169883"/>
              <a:gd name="connsiteY11" fmla="*/ 3464 h 233154"/>
              <a:gd name="connsiteX12" fmla="*/ 69273 w 169883"/>
              <a:gd name="connsiteY12" fmla="*/ 0 h 233154"/>
              <a:gd name="connsiteX13" fmla="*/ 24246 w 169883"/>
              <a:gd name="connsiteY13" fmla="*/ 3464 h 233154"/>
              <a:gd name="connsiteX14" fmla="*/ 10391 w 169883"/>
              <a:gd name="connsiteY14" fmla="*/ 24246 h 233154"/>
              <a:gd name="connsiteX15" fmla="*/ 0 w 169883"/>
              <a:gd name="connsiteY15" fmla="*/ 45028 h 233154"/>
              <a:gd name="connsiteX16" fmla="*/ 3464 w 169883"/>
              <a:gd name="connsiteY16" fmla="*/ 72737 h 233154"/>
              <a:gd name="connsiteX17" fmla="*/ 31173 w 169883"/>
              <a:gd name="connsiteY17" fmla="*/ 90055 h 233154"/>
              <a:gd name="connsiteX18" fmla="*/ 41564 w 169883"/>
              <a:gd name="connsiteY18" fmla="*/ 96982 h 233154"/>
              <a:gd name="connsiteX19" fmla="*/ 55419 w 169883"/>
              <a:gd name="connsiteY19" fmla="*/ 121228 h 233154"/>
              <a:gd name="connsiteX20" fmla="*/ 58882 w 169883"/>
              <a:gd name="connsiteY20" fmla="*/ 131618 h 233154"/>
              <a:gd name="connsiteX21" fmla="*/ 65809 w 169883"/>
              <a:gd name="connsiteY21" fmla="*/ 138546 h 233154"/>
              <a:gd name="connsiteX22" fmla="*/ 69273 w 169883"/>
              <a:gd name="connsiteY22" fmla="*/ 193964 h 233154"/>
              <a:gd name="connsiteX23" fmla="*/ 72737 w 169883"/>
              <a:gd name="connsiteY23" fmla="*/ 204355 h 233154"/>
              <a:gd name="connsiteX24" fmla="*/ 83128 w 169883"/>
              <a:gd name="connsiteY24" fmla="*/ 211282 h 233154"/>
              <a:gd name="connsiteX25" fmla="*/ 86591 w 169883"/>
              <a:gd name="connsiteY25" fmla="*/ 221673 h 233154"/>
              <a:gd name="connsiteX26" fmla="*/ 152400 w 169883"/>
              <a:gd name="connsiteY26" fmla="*/ 232064 h 23315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</a:cxnLst>
            <a:rect l="l" t="t" r="r" b="b"/>
            <a:pathLst>
              <a:path w="169883" h="233154">
                <a:moveTo>
                  <a:pt x="152400" y="232064"/>
                </a:moveTo>
                <a:cubicBezTo>
                  <a:pt x="162791" y="230910"/>
                  <a:pt x="148937" y="220633"/>
                  <a:pt x="148937" y="214746"/>
                </a:cubicBezTo>
                <a:cubicBezTo>
                  <a:pt x="148937" y="209327"/>
                  <a:pt x="157974" y="193660"/>
                  <a:pt x="159328" y="190500"/>
                </a:cubicBezTo>
                <a:cubicBezTo>
                  <a:pt x="162306" y="183550"/>
                  <a:pt x="164499" y="173276"/>
                  <a:pt x="166255" y="166255"/>
                </a:cubicBezTo>
                <a:cubicBezTo>
                  <a:pt x="170943" y="128755"/>
                  <a:pt x="171240" y="141841"/>
                  <a:pt x="166255" y="96982"/>
                </a:cubicBezTo>
                <a:cubicBezTo>
                  <a:pt x="165842" y="93268"/>
                  <a:pt x="163113" y="72117"/>
                  <a:pt x="159328" y="65809"/>
                </a:cubicBezTo>
                <a:cubicBezTo>
                  <a:pt x="157648" y="63009"/>
                  <a:pt x="154709" y="61191"/>
                  <a:pt x="152400" y="58882"/>
                </a:cubicBezTo>
                <a:cubicBezTo>
                  <a:pt x="151246" y="55418"/>
                  <a:pt x="150962" y="51529"/>
                  <a:pt x="148937" y="48491"/>
                </a:cubicBezTo>
                <a:cubicBezTo>
                  <a:pt x="141348" y="37107"/>
                  <a:pt x="137739" y="39160"/>
                  <a:pt x="128155" y="31173"/>
                </a:cubicBezTo>
                <a:cubicBezTo>
                  <a:pt x="124392" y="28037"/>
                  <a:pt x="121840" y="23499"/>
                  <a:pt x="117764" y="20782"/>
                </a:cubicBezTo>
                <a:cubicBezTo>
                  <a:pt x="114726" y="18757"/>
                  <a:pt x="110639" y="18951"/>
                  <a:pt x="107373" y="17318"/>
                </a:cubicBezTo>
                <a:cubicBezTo>
                  <a:pt x="87278" y="7271"/>
                  <a:pt x="107413" y="12571"/>
                  <a:pt x="83128" y="3464"/>
                </a:cubicBezTo>
                <a:cubicBezTo>
                  <a:pt x="78671" y="1792"/>
                  <a:pt x="73891" y="1155"/>
                  <a:pt x="69273" y="0"/>
                </a:cubicBezTo>
                <a:lnTo>
                  <a:pt x="24246" y="3464"/>
                </a:lnTo>
                <a:cubicBezTo>
                  <a:pt x="16547" y="6634"/>
                  <a:pt x="15009" y="17319"/>
                  <a:pt x="10391" y="24246"/>
                </a:cubicBezTo>
                <a:cubicBezTo>
                  <a:pt x="1439" y="37674"/>
                  <a:pt x="4780" y="30689"/>
                  <a:pt x="0" y="45028"/>
                </a:cubicBezTo>
                <a:cubicBezTo>
                  <a:pt x="1155" y="54264"/>
                  <a:pt x="1015" y="63757"/>
                  <a:pt x="3464" y="72737"/>
                </a:cubicBezTo>
                <a:cubicBezTo>
                  <a:pt x="8080" y="89663"/>
                  <a:pt x="17600" y="81007"/>
                  <a:pt x="31173" y="90055"/>
                </a:cubicBezTo>
                <a:lnTo>
                  <a:pt x="41564" y="96982"/>
                </a:lnTo>
                <a:cubicBezTo>
                  <a:pt x="49208" y="135199"/>
                  <a:pt x="37751" y="99143"/>
                  <a:pt x="55419" y="121228"/>
                </a:cubicBezTo>
                <a:cubicBezTo>
                  <a:pt x="57699" y="124079"/>
                  <a:pt x="57004" y="128488"/>
                  <a:pt x="58882" y="131618"/>
                </a:cubicBezTo>
                <a:cubicBezTo>
                  <a:pt x="60562" y="134418"/>
                  <a:pt x="63500" y="136237"/>
                  <a:pt x="65809" y="138546"/>
                </a:cubicBezTo>
                <a:cubicBezTo>
                  <a:pt x="66964" y="157019"/>
                  <a:pt x="67335" y="175557"/>
                  <a:pt x="69273" y="193964"/>
                </a:cubicBezTo>
                <a:cubicBezTo>
                  <a:pt x="69655" y="197595"/>
                  <a:pt x="70456" y="201504"/>
                  <a:pt x="72737" y="204355"/>
                </a:cubicBezTo>
                <a:cubicBezTo>
                  <a:pt x="75338" y="207606"/>
                  <a:pt x="79664" y="208973"/>
                  <a:pt x="83128" y="211282"/>
                </a:cubicBezTo>
                <a:cubicBezTo>
                  <a:pt x="84282" y="214746"/>
                  <a:pt x="84009" y="219091"/>
                  <a:pt x="86591" y="221673"/>
                </a:cubicBezTo>
                <a:cubicBezTo>
                  <a:pt x="101262" y="236344"/>
                  <a:pt x="142009" y="233218"/>
                  <a:pt x="152400" y="232064"/>
                </a:cubicBezTo>
                <a:close/>
              </a:path>
            </a:pathLst>
          </a:custGeom>
          <a:noFill/>
          <a:ln>
            <a:solidFill>
              <a:schemeClr val="accent4">
                <a:lumMod val="60000"/>
                <a:lumOff val="40000"/>
              </a:schemeClr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28" name="Freeform 27"/>
          <p:cNvSpPr/>
          <p:nvPr/>
        </p:nvSpPr>
        <p:spPr>
          <a:xfrm>
            <a:off x="2195539" y="3506355"/>
            <a:ext cx="316774" cy="306122"/>
          </a:xfrm>
          <a:custGeom>
            <a:avLst/>
            <a:gdLst>
              <a:gd name="connsiteX0" fmla="*/ 118903 w 316774"/>
              <a:gd name="connsiteY0" fmla="*/ 3320 h 306122"/>
              <a:gd name="connsiteX1" fmla="*/ 100915 w 316774"/>
              <a:gd name="connsiteY1" fmla="*/ 9317 h 306122"/>
              <a:gd name="connsiteX2" fmla="*/ 88923 w 316774"/>
              <a:gd name="connsiteY2" fmla="*/ 12315 h 306122"/>
              <a:gd name="connsiteX3" fmla="*/ 79929 w 316774"/>
              <a:gd name="connsiteY3" fmla="*/ 21309 h 306122"/>
              <a:gd name="connsiteX4" fmla="*/ 70935 w 316774"/>
              <a:gd name="connsiteY4" fmla="*/ 24307 h 306122"/>
              <a:gd name="connsiteX5" fmla="*/ 58943 w 316774"/>
              <a:gd name="connsiteY5" fmla="*/ 30303 h 306122"/>
              <a:gd name="connsiteX6" fmla="*/ 43953 w 316774"/>
              <a:gd name="connsiteY6" fmla="*/ 42295 h 306122"/>
              <a:gd name="connsiteX7" fmla="*/ 28962 w 316774"/>
              <a:gd name="connsiteY7" fmla="*/ 57285 h 306122"/>
              <a:gd name="connsiteX8" fmla="*/ 19968 w 316774"/>
              <a:gd name="connsiteY8" fmla="*/ 66279 h 306122"/>
              <a:gd name="connsiteX9" fmla="*/ 4978 w 316774"/>
              <a:gd name="connsiteY9" fmla="*/ 90263 h 306122"/>
              <a:gd name="connsiteX10" fmla="*/ 4978 w 316774"/>
              <a:gd name="connsiteY10" fmla="*/ 159218 h 306122"/>
              <a:gd name="connsiteX11" fmla="*/ 16970 w 316774"/>
              <a:gd name="connsiteY11" fmla="*/ 180204 h 306122"/>
              <a:gd name="connsiteX12" fmla="*/ 25964 w 316774"/>
              <a:gd name="connsiteY12" fmla="*/ 183202 h 306122"/>
              <a:gd name="connsiteX13" fmla="*/ 37957 w 316774"/>
              <a:gd name="connsiteY13" fmla="*/ 192197 h 306122"/>
              <a:gd name="connsiteX14" fmla="*/ 49949 w 316774"/>
              <a:gd name="connsiteY14" fmla="*/ 204189 h 306122"/>
              <a:gd name="connsiteX15" fmla="*/ 64939 w 316774"/>
              <a:gd name="connsiteY15" fmla="*/ 222177 h 306122"/>
              <a:gd name="connsiteX16" fmla="*/ 76931 w 316774"/>
              <a:gd name="connsiteY16" fmla="*/ 237167 h 306122"/>
              <a:gd name="connsiteX17" fmla="*/ 91921 w 316774"/>
              <a:gd name="connsiteY17" fmla="*/ 261151 h 306122"/>
              <a:gd name="connsiteX18" fmla="*/ 97917 w 316774"/>
              <a:gd name="connsiteY18" fmla="*/ 267147 h 306122"/>
              <a:gd name="connsiteX19" fmla="*/ 106911 w 316774"/>
              <a:gd name="connsiteY19" fmla="*/ 261151 h 306122"/>
              <a:gd name="connsiteX20" fmla="*/ 118903 w 316774"/>
              <a:gd name="connsiteY20" fmla="*/ 264149 h 306122"/>
              <a:gd name="connsiteX21" fmla="*/ 142888 w 316774"/>
              <a:gd name="connsiteY21" fmla="*/ 282138 h 306122"/>
              <a:gd name="connsiteX22" fmla="*/ 148884 w 316774"/>
              <a:gd name="connsiteY22" fmla="*/ 291132 h 306122"/>
              <a:gd name="connsiteX23" fmla="*/ 166872 w 316774"/>
              <a:gd name="connsiteY23" fmla="*/ 297128 h 306122"/>
              <a:gd name="connsiteX24" fmla="*/ 199850 w 316774"/>
              <a:gd name="connsiteY24" fmla="*/ 306122 h 306122"/>
              <a:gd name="connsiteX25" fmla="*/ 208844 w 316774"/>
              <a:gd name="connsiteY25" fmla="*/ 300126 h 306122"/>
              <a:gd name="connsiteX26" fmla="*/ 211842 w 316774"/>
              <a:gd name="connsiteY26" fmla="*/ 291132 h 306122"/>
              <a:gd name="connsiteX27" fmla="*/ 214841 w 316774"/>
              <a:gd name="connsiteY27" fmla="*/ 258153 h 306122"/>
              <a:gd name="connsiteX28" fmla="*/ 217839 w 316774"/>
              <a:gd name="connsiteY28" fmla="*/ 249159 h 306122"/>
              <a:gd name="connsiteX29" fmla="*/ 226833 w 316774"/>
              <a:gd name="connsiteY29" fmla="*/ 243163 h 306122"/>
              <a:gd name="connsiteX30" fmla="*/ 238825 w 316774"/>
              <a:gd name="connsiteY30" fmla="*/ 234169 h 306122"/>
              <a:gd name="connsiteX31" fmla="*/ 259811 w 316774"/>
              <a:gd name="connsiteY31" fmla="*/ 228173 h 306122"/>
              <a:gd name="connsiteX32" fmla="*/ 268805 w 316774"/>
              <a:gd name="connsiteY32" fmla="*/ 222177 h 306122"/>
              <a:gd name="connsiteX33" fmla="*/ 277799 w 316774"/>
              <a:gd name="connsiteY33" fmla="*/ 213183 h 306122"/>
              <a:gd name="connsiteX34" fmla="*/ 286793 w 316774"/>
              <a:gd name="connsiteY34" fmla="*/ 210185 h 306122"/>
              <a:gd name="connsiteX35" fmla="*/ 295787 w 316774"/>
              <a:gd name="connsiteY35" fmla="*/ 201191 h 306122"/>
              <a:gd name="connsiteX36" fmla="*/ 304781 w 316774"/>
              <a:gd name="connsiteY36" fmla="*/ 195195 h 306122"/>
              <a:gd name="connsiteX37" fmla="*/ 307780 w 316774"/>
              <a:gd name="connsiteY37" fmla="*/ 186200 h 306122"/>
              <a:gd name="connsiteX38" fmla="*/ 316774 w 316774"/>
              <a:gd name="connsiteY38" fmla="*/ 174208 h 306122"/>
              <a:gd name="connsiteX39" fmla="*/ 313776 w 316774"/>
              <a:gd name="connsiteY39" fmla="*/ 126240 h 306122"/>
              <a:gd name="connsiteX40" fmla="*/ 310778 w 316774"/>
              <a:gd name="connsiteY40" fmla="*/ 117246 h 306122"/>
              <a:gd name="connsiteX41" fmla="*/ 304781 w 316774"/>
              <a:gd name="connsiteY41" fmla="*/ 111250 h 306122"/>
              <a:gd name="connsiteX42" fmla="*/ 301783 w 316774"/>
              <a:gd name="connsiteY42" fmla="*/ 99258 h 306122"/>
              <a:gd name="connsiteX43" fmla="*/ 289791 w 316774"/>
              <a:gd name="connsiteY43" fmla="*/ 96260 h 306122"/>
              <a:gd name="connsiteX44" fmla="*/ 283795 w 316774"/>
              <a:gd name="connsiteY44" fmla="*/ 90263 h 306122"/>
              <a:gd name="connsiteX45" fmla="*/ 262809 w 316774"/>
              <a:gd name="connsiteY45" fmla="*/ 75273 h 306122"/>
              <a:gd name="connsiteX46" fmla="*/ 253815 w 316774"/>
              <a:gd name="connsiteY46" fmla="*/ 72275 h 306122"/>
              <a:gd name="connsiteX47" fmla="*/ 244821 w 316774"/>
              <a:gd name="connsiteY47" fmla="*/ 63281 h 306122"/>
              <a:gd name="connsiteX48" fmla="*/ 235827 w 316774"/>
              <a:gd name="connsiteY48" fmla="*/ 57285 h 306122"/>
              <a:gd name="connsiteX49" fmla="*/ 223835 w 316774"/>
              <a:gd name="connsiteY49" fmla="*/ 36299 h 306122"/>
              <a:gd name="connsiteX50" fmla="*/ 205846 w 316774"/>
              <a:gd name="connsiteY50" fmla="*/ 27305 h 306122"/>
              <a:gd name="connsiteX51" fmla="*/ 169870 w 316774"/>
              <a:gd name="connsiteY51" fmla="*/ 9317 h 306122"/>
              <a:gd name="connsiteX52" fmla="*/ 157878 w 316774"/>
              <a:gd name="connsiteY52" fmla="*/ 6319 h 306122"/>
              <a:gd name="connsiteX53" fmla="*/ 148884 w 316774"/>
              <a:gd name="connsiteY53" fmla="*/ 3320 h 306122"/>
              <a:gd name="connsiteX54" fmla="*/ 136892 w 316774"/>
              <a:gd name="connsiteY54" fmla="*/ 322 h 306122"/>
              <a:gd name="connsiteX55" fmla="*/ 118903 w 316774"/>
              <a:gd name="connsiteY55" fmla="*/ 3320 h 30612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</a:cxnLst>
            <a:rect l="l" t="t" r="r" b="b"/>
            <a:pathLst>
              <a:path w="316774" h="306122">
                <a:moveTo>
                  <a:pt x="118903" y="3320"/>
                </a:moveTo>
                <a:cubicBezTo>
                  <a:pt x="112907" y="4819"/>
                  <a:pt x="106969" y="7501"/>
                  <a:pt x="100915" y="9317"/>
                </a:cubicBezTo>
                <a:cubicBezTo>
                  <a:pt x="96968" y="10501"/>
                  <a:pt x="92500" y="10271"/>
                  <a:pt x="88923" y="12315"/>
                </a:cubicBezTo>
                <a:cubicBezTo>
                  <a:pt x="85242" y="14419"/>
                  <a:pt x="83457" y="18957"/>
                  <a:pt x="79929" y="21309"/>
                </a:cubicBezTo>
                <a:cubicBezTo>
                  <a:pt x="77300" y="23062"/>
                  <a:pt x="73840" y="23062"/>
                  <a:pt x="70935" y="24307"/>
                </a:cubicBezTo>
                <a:cubicBezTo>
                  <a:pt x="66827" y="26067"/>
                  <a:pt x="62940" y="28304"/>
                  <a:pt x="58943" y="30303"/>
                </a:cubicBezTo>
                <a:cubicBezTo>
                  <a:pt x="43333" y="53718"/>
                  <a:pt x="63260" y="27815"/>
                  <a:pt x="43953" y="42295"/>
                </a:cubicBezTo>
                <a:cubicBezTo>
                  <a:pt x="38300" y="46535"/>
                  <a:pt x="33959" y="52288"/>
                  <a:pt x="28962" y="57285"/>
                </a:cubicBezTo>
                <a:cubicBezTo>
                  <a:pt x="25964" y="60283"/>
                  <a:pt x="21864" y="62487"/>
                  <a:pt x="19968" y="66279"/>
                </a:cubicBezTo>
                <a:cubicBezTo>
                  <a:pt x="11737" y="82740"/>
                  <a:pt x="16653" y="74696"/>
                  <a:pt x="4978" y="90263"/>
                </a:cubicBezTo>
                <a:cubicBezTo>
                  <a:pt x="-1954" y="117995"/>
                  <a:pt x="-1359" y="110633"/>
                  <a:pt x="4978" y="159218"/>
                </a:cubicBezTo>
                <a:cubicBezTo>
                  <a:pt x="5236" y="161195"/>
                  <a:pt x="14420" y="178164"/>
                  <a:pt x="16970" y="180204"/>
                </a:cubicBezTo>
                <a:cubicBezTo>
                  <a:pt x="19438" y="182178"/>
                  <a:pt x="22966" y="182203"/>
                  <a:pt x="25964" y="183202"/>
                </a:cubicBezTo>
                <a:cubicBezTo>
                  <a:pt x="29962" y="186200"/>
                  <a:pt x="34758" y="188358"/>
                  <a:pt x="37957" y="192197"/>
                </a:cubicBezTo>
                <a:cubicBezTo>
                  <a:pt x="50257" y="206956"/>
                  <a:pt x="29655" y="197424"/>
                  <a:pt x="49949" y="204189"/>
                </a:cubicBezTo>
                <a:cubicBezTo>
                  <a:pt x="62220" y="222596"/>
                  <a:pt x="48780" y="203710"/>
                  <a:pt x="64939" y="222177"/>
                </a:cubicBezTo>
                <a:cubicBezTo>
                  <a:pt x="69153" y="226993"/>
                  <a:pt x="72934" y="232170"/>
                  <a:pt x="76931" y="237167"/>
                </a:cubicBezTo>
                <a:cubicBezTo>
                  <a:pt x="84066" y="258573"/>
                  <a:pt x="77668" y="251649"/>
                  <a:pt x="91921" y="261151"/>
                </a:cubicBezTo>
                <a:cubicBezTo>
                  <a:pt x="97620" y="289645"/>
                  <a:pt x="92017" y="274522"/>
                  <a:pt x="97917" y="267147"/>
                </a:cubicBezTo>
                <a:cubicBezTo>
                  <a:pt x="100168" y="264333"/>
                  <a:pt x="103913" y="263150"/>
                  <a:pt x="106911" y="261151"/>
                </a:cubicBezTo>
                <a:cubicBezTo>
                  <a:pt x="110908" y="262150"/>
                  <a:pt x="115475" y="261863"/>
                  <a:pt x="118903" y="264149"/>
                </a:cubicBezTo>
                <a:cubicBezTo>
                  <a:pt x="153353" y="287116"/>
                  <a:pt x="119487" y="274338"/>
                  <a:pt x="142888" y="282138"/>
                </a:cubicBezTo>
                <a:cubicBezTo>
                  <a:pt x="144887" y="285136"/>
                  <a:pt x="145829" y="289222"/>
                  <a:pt x="148884" y="291132"/>
                </a:cubicBezTo>
                <a:cubicBezTo>
                  <a:pt x="154244" y="294482"/>
                  <a:pt x="161613" y="293622"/>
                  <a:pt x="166872" y="297128"/>
                </a:cubicBezTo>
                <a:cubicBezTo>
                  <a:pt x="182570" y="307593"/>
                  <a:pt x="172291" y="302677"/>
                  <a:pt x="199850" y="306122"/>
                </a:cubicBezTo>
                <a:cubicBezTo>
                  <a:pt x="202848" y="304123"/>
                  <a:pt x="206593" y="302940"/>
                  <a:pt x="208844" y="300126"/>
                </a:cubicBezTo>
                <a:cubicBezTo>
                  <a:pt x="210818" y="297658"/>
                  <a:pt x="211395" y="294260"/>
                  <a:pt x="211842" y="291132"/>
                </a:cubicBezTo>
                <a:cubicBezTo>
                  <a:pt x="213403" y="280205"/>
                  <a:pt x="213280" y="269080"/>
                  <a:pt x="214841" y="258153"/>
                </a:cubicBezTo>
                <a:cubicBezTo>
                  <a:pt x="215288" y="255025"/>
                  <a:pt x="215865" y="251627"/>
                  <a:pt x="217839" y="249159"/>
                </a:cubicBezTo>
                <a:cubicBezTo>
                  <a:pt x="220090" y="246345"/>
                  <a:pt x="223901" y="245257"/>
                  <a:pt x="226833" y="243163"/>
                </a:cubicBezTo>
                <a:cubicBezTo>
                  <a:pt x="230899" y="240259"/>
                  <a:pt x="234487" y="236648"/>
                  <a:pt x="238825" y="234169"/>
                </a:cubicBezTo>
                <a:cubicBezTo>
                  <a:pt x="242170" y="232257"/>
                  <a:pt x="257215" y="228822"/>
                  <a:pt x="259811" y="228173"/>
                </a:cubicBezTo>
                <a:cubicBezTo>
                  <a:pt x="262809" y="226174"/>
                  <a:pt x="266037" y="224484"/>
                  <a:pt x="268805" y="222177"/>
                </a:cubicBezTo>
                <a:cubicBezTo>
                  <a:pt x="272062" y="219463"/>
                  <a:pt x="274271" y="215535"/>
                  <a:pt x="277799" y="213183"/>
                </a:cubicBezTo>
                <a:cubicBezTo>
                  <a:pt x="280428" y="211430"/>
                  <a:pt x="283795" y="211184"/>
                  <a:pt x="286793" y="210185"/>
                </a:cubicBezTo>
                <a:cubicBezTo>
                  <a:pt x="289791" y="207187"/>
                  <a:pt x="292530" y="203905"/>
                  <a:pt x="295787" y="201191"/>
                </a:cubicBezTo>
                <a:cubicBezTo>
                  <a:pt x="298555" y="198884"/>
                  <a:pt x="302530" y="198009"/>
                  <a:pt x="304781" y="195195"/>
                </a:cubicBezTo>
                <a:cubicBezTo>
                  <a:pt x="306755" y="192727"/>
                  <a:pt x="306212" y="188944"/>
                  <a:pt x="307780" y="186200"/>
                </a:cubicBezTo>
                <a:cubicBezTo>
                  <a:pt x="310259" y="181862"/>
                  <a:pt x="313776" y="178205"/>
                  <a:pt x="316774" y="174208"/>
                </a:cubicBezTo>
                <a:cubicBezTo>
                  <a:pt x="315775" y="158219"/>
                  <a:pt x="315453" y="142173"/>
                  <a:pt x="313776" y="126240"/>
                </a:cubicBezTo>
                <a:cubicBezTo>
                  <a:pt x="313445" y="123097"/>
                  <a:pt x="312404" y="119956"/>
                  <a:pt x="310778" y="117246"/>
                </a:cubicBezTo>
                <a:cubicBezTo>
                  <a:pt x="309324" y="114822"/>
                  <a:pt x="306780" y="113249"/>
                  <a:pt x="304781" y="111250"/>
                </a:cubicBezTo>
                <a:cubicBezTo>
                  <a:pt x="303782" y="107253"/>
                  <a:pt x="304697" y="102172"/>
                  <a:pt x="301783" y="99258"/>
                </a:cubicBezTo>
                <a:cubicBezTo>
                  <a:pt x="298869" y="96344"/>
                  <a:pt x="293476" y="98103"/>
                  <a:pt x="289791" y="96260"/>
                </a:cubicBezTo>
                <a:cubicBezTo>
                  <a:pt x="287263" y="94996"/>
                  <a:pt x="285967" y="92073"/>
                  <a:pt x="283795" y="90263"/>
                </a:cubicBezTo>
                <a:cubicBezTo>
                  <a:pt x="281758" y="88566"/>
                  <a:pt x="266703" y="77220"/>
                  <a:pt x="262809" y="75273"/>
                </a:cubicBezTo>
                <a:cubicBezTo>
                  <a:pt x="259982" y="73860"/>
                  <a:pt x="256813" y="73274"/>
                  <a:pt x="253815" y="72275"/>
                </a:cubicBezTo>
                <a:cubicBezTo>
                  <a:pt x="250817" y="69277"/>
                  <a:pt x="248078" y="65995"/>
                  <a:pt x="244821" y="63281"/>
                </a:cubicBezTo>
                <a:cubicBezTo>
                  <a:pt x="242053" y="60974"/>
                  <a:pt x="238375" y="59833"/>
                  <a:pt x="235827" y="57285"/>
                </a:cubicBezTo>
                <a:cubicBezTo>
                  <a:pt x="224007" y="45465"/>
                  <a:pt x="235592" y="50407"/>
                  <a:pt x="223835" y="36299"/>
                </a:cubicBezTo>
                <a:cubicBezTo>
                  <a:pt x="219364" y="30934"/>
                  <a:pt x="211985" y="29351"/>
                  <a:pt x="205846" y="27305"/>
                </a:cubicBezTo>
                <a:cubicBezTo>
                  <a:pt x="185172" y="13523"/>
                  <a:pt x="192438" y="16087"/>
                  <a:pt x="169870" y="9317"/>
                </a:cubicBezTo>
                <a:cubicBezTo>
                  <a:pt x="165923" y="8133"/>
                  <a:pt x="161840" y="7451"/>
                  <a:pt x="157878" y="6319"/>
                </a:cubicBezTo>
                <a:cubicBezTo>
                  <a:pt x="154839" y="5451"/>
                  <a:pt x="151923" y="4188"/>
                  <a:pt x="148884" y="3320"/>
                </a:cubicBezTo>
                <a:cubicBezTo>
                  <a:pt x="144922" y="2188"/>
                  <a:pt x="140577" y="2165"/>
                  <a:pt x="136892" y="322"/>
                </a:cubicBezTo>
                <a:cubicBezTo>
                  <a:pt x="134364" y="-942"/>
                  <a:pt x="124899" y="1821"/>
                  <a:pt x="118903" y="3320"/>
                </a:cubicBezTo>
                <a:close/>
              </a:path>
            </a:pathLst>
          </a:custGeom>
          <a:noFill/>
          <a:ln>
            <a:solidFill>
              <a:schemeClr val="accent4">
                <a:lumMod val="60000"/>
                <a:lumOff val="40000"/>
              </a:schemeClr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29" name="Freeform 28"/>
          <p:cNvSpPr/>
          <p:nvPr/>
        </p:nvSpPr>
        <p:spPr>
          <a:xfrm>
            <a:off x="2281464" y="4609954"/>
            <a:ext cx="221855" cy="251834"/>
          </a:xfrm>
          <a:custGeom>
            <a:avLst/>
            <a:gdLst>
              <a:gd name="connsiteX0" fmla="*/ 131914 w 221855"/>
              <a:gd name="connsiteY0" fmla="*/ 14990 h 251834"/>
              <a:gd name="connsiteX1" fmla="*/ 98935 w 221855"/>
              <a:gd name="connsiteY1" fmla="*/ 5996 h 251834"/>
              <a:gd name="connsiteX2" fmla="*/ 80947 w 221855"/>
              <a:gd name="connsiteY2" fmla="*/ 0 h 251834"/>
              <a:gd name="connsiteX3" fmla="*/ 56963 w 221855"/>
              <a:gd name="connsiteY3" fmla="*/ 2998 h 251834"/>
              <a:gd name="connsiteX4" fmla="*/ 41973 w 221855"/>
              <a:gd name="connsiteY4" fmla="*/ 17988 h 251834"/>
              <a:gd name="connsiteX5" fmla="*/ 29980 w 221855"/>
              <a:gd name="connsiteY5" fmla="*/ 32978 h 251834"/>
              <a:gd name="connsiteX6" fmla="*/ 26982 w 221855"/>
              <a:gd name="connsiteY6" fmla="*/ 41972 h 251834"/>
              <a:gd name="connsiteX7" fmla="*/ 17988 w 221855"/>
              <a:gd name="connsiteY7" fmla="*/ 47968 h 251834"/>
              <a:gd name="connsiteX8" fmla="*/ 5996 w 221855"/>
              <a:gd name="connsiteY8" fmla="*/ 65956 h 251834"/>
              <a:gd name="connsiteX9" fmla="*/ 0 w 221855"/>
              <a:gd name="connsiteY9" fmla="*/ 83944 h 251834"/>
              <a:gd name="connsiteX10" fmla="*/ 5996 w 221855"/>
              <a:gd name="connsiteY10" fmla="*/ 104931 h 251834"/>
              <a:gd name="connsiteX11" fmla="*/ 26982 w 221855"/>
              <a:gd name="connsiteY11" fmla="*/ 122919 h 251834"/>
              <a:gd name="connsiteX12" fmla="*/ 29980 w 221855"/>
              <a:gd name="connsiteY12" fmla="*/ 131913 h 251834"/>
              <a:gd name="connsiteX13" fmla="*/ 41973 w 221855"/>
              <a:gd name="connsiteY13" fmla="*/ 146903 h 251834"/>
              <a:gd name="connsiteX14" fmla="*/ 56963 w 221855"/>
              <a:gd name="connsiteY14" fmla="*/ 173885 h 251834"/>
              <a:gd name="connsiteX15" fmla="*/ 65957 w 221855"/>
              <a:gd name="connsiteY15" fmla="*/ 179881 h 251834"/>
              <a:gd name="connsiteX16" fmla="*/ 71953 w 221855"/>
              <a:gd name="connsiteY16" fmla="*/ 197870 h 251834"/>
              <a:gd name="connsiteX17" fmla="*/ 92939 w 221855"/>
              <a:gd name="connsiteY17" fmla="*/ 221854 h 251834"/>
              <a:gd name="connsiteX18" fmla="*/ 98935 w 221855"/>
              <a:gd name="connsiteY18" fmla="*/ 230848 h 251834"/>
              <a:gd name="connsiteX19" fmla="*/ 119921 w 221855"/>
              <a:gd name="connsiteY19" fmla="*/ 248836 h 251834"/>
              <a:gd name="connsiteX20" fmla="*/ 128916 w 221855"/>
              <a:gd name="connsiteY20" fmla="*/ 251834 h 251834"/>
              <a:gd name="connsiteX21" fmla="*/ 155898 w 221855"/>
              <a:gd name="connsiteY21" fmla="*/ 236844 h 251834"/>
              <a:gd name="connsiteX22" fmla="*/ 164892 w 221855"/>
              <a:gd name="connsiteY22" fmla="*/ 227850 h 251834"/>
              <a:gd name="connsiteX23" fmla="*/ 167890 w 221855"/>
              <a:gd name="connsiteY23" fmla="*/ 164891 h 251834"/>
              <a:gd name="connsiteX24" fmla="*/ 173886 w 221855"/>
              <a:gd name="connsiteY24" fmla="*/ 155897 h 251834"/>
              <a:gd name="connsiteX25" fmla="*/ 185878 w 221855"/>
              <a:gd name="connsiteY25" fmla="*/ 152899 h 251834"/>
              <a:gd name="connsiteX26" fmla="*/ 203866 w 221855"/>
              <a:gd name="connsiteY26" fmla="*/ 140907 h 251834"/>
              <a:gd name="connsiteX27" fmla="*/ 221855 w 221855"/>
              <a:gd name="connsiteY27" fmla="*/ 128915 h 251834"/>
              <a:gd name="connsiteX28" fmla="*/ 218856 w 221855"/>
              <a:gd name="connsiteY28" fmla="*/ 68954 h 251834"/>
              <a:gd name="connsiteX29" fmla="*/ 209862 w 221855"/>
              <a:gd name="connsiteY29" fmla="*/ 62958 h 251834"/>
              <a:gd name="connsiteX30" fmla="*/ 203866 w 221855"/>
              <a:gd name="connsiteY30" fmla="*/ 53964 h 251834"/>
              <a:gd name="connsiteX31" fmla="*/ 194872 w 221855"/>
              <a:gd name="connsiteY31" fmla="*/ 47968 h 251834"/>
              <a:gd name="connsiteX32" fmla="*/ 173886 w 221855"/>
              <a:gd name="connsiteY32" fmla="*/ 41972 h 251834"/>
              <a:gd name="connsiteX33" fmla="*/ 164892 w 221855"/>
              <a:gd name="connsiteY33" fmla="*/ 35976 h 251834"/>
              <a:gd name="connsiteX34" fmla="*/ 131914 w 221855"/>
              <a:gd name="connsiteY34" fmla="*/ 14990 h 25183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</a:cxnLst>
            <a:rect l="l" t="t" r="r" b="b"/>
            <a:pathLst>
              <a:path w="221855" h="251834">
                <a:moveTo>
                  <a:pt x="131914" y="14990"/>
                </a:moveTo>
                <a:cubicBezTo>
                  <a:pt x="120921" y="9993"/>
                  <a:pt x="135177" y="15056"/>
                  <a:pt x="98935" y="5996"/>
                </a:cubicBezTo>
                <a:cubicBezTo>
                  <a:pt x="92803" y="4463"/>
                  <a:pt x="80947" y="0"/>
                  <a:pt x="80947" y="0"/>
                </a:cubicBezTo>
                <a:cubicBezTo>
                  <a:pt x="72952" y="999"/>
                  <a:pt x="64736" y="878"/>
                  <a:pt x="56963" y="2998"/>
                </a:cubicBezTo>
                <a:cubicBezTo>
                  <a:pt x="47759" y="5508"/>
                  <a:pt x="47179" y="11481"/>
                  <a:pt x="41973" y="17988"/>
                </a:cubicBezTo>
                <a:cubicBezTo>
                  <a:pt x="34535" y="27285"/>
                  <a:pt x="36133" y="20672"/>
                  <a:pt x="29980" y="32978"/>
                </a:cubicBezTo>
                <a:cubicBezTo>
                  <a:pt x="28567" y="35805"/>
                  <a:pt x="28956" y="39504"/>
                  <a:pt x="26982" y="41972"/>
                </a:cubicBezTo>
                <a:cubicBezTo>
                  <a:pt x="24731" y="44786"/>
                  <a:pt x="20986" y="45969"/>
                  <a:pt x="17988" y="47968"/>
                </a:cubicBezTo>
                <a:cubicBezTo>
                  <a:pt x="13991" y="53964"/>
                  <a:pt x="8275" y="59120"/>
                  <a:pt x="5996" y="65956"/>
                </a:cubicBezTo>
                <a:lnTo>
                  <a:pt x="0" y="83944"/>
                </a:lnTo>
                <a:cubicBezTo>
                  <a:pt x="400" y="85543"/>
                  <a:pt x="4275" y="102350"/>
                  <a:pt x="5996" y="104931"/>
                </a:cubicBezTo>
                <a:cubicBezTo>
                  <a:pt x="10172" y="111195"/>
                  <a:pt x="21440" y="118763"/>
                  <a:pt x="26982" y="122919"/>
                </a:cubicBezTo>
                <a:cubicBezTo>
                  <a:pt x="27981" y="125917"/>
                  <a:pt x="28567" y="129086"/>
                  <a:pt x="29980" y="131913"/>
                </a:cubicBezTo>
                <a:cubicBezTo>
                  <a:pt x="33763" y="139478"/>
                  <a:pt x="36395" y="141326"/>
                  <a:pt x="41973" y="146903"/>
                </a:cubicBezTo>
                <a:cubicBezTo>
                  <a:pt x="47766" y="164282"/>
                  <a:pt x="44535" y="163529"/>
                  <a:pt x="56963" y="173885"/>
                </a:cubicBezTo>
                <a:cubicBezTo>
                  <a:pt x="59731" y="176192"/>
                  <a:pt x="62959" y="177882"/>
                  <a:pt x="65957" y="179881"/>
                </a:cubicBezTo>
                <a:cubicBezTo>
                  <a:pt x="67956" y="185877"/>
                  <a:pt x="67484" y="193401"/>
                  <a:pt x="71953" y="197870"/>
                </a:cubicBezTo>
                <a:cubicBezTo>
                  <a:pt x="83047" y="208964"/>
                  <a:pt x="81959" y="207213"/>
                  <a:pt x="92939" y="221854"/>
                </a:cubicBezTo>
                <a:cubicBezTo>
                  <a:pt x="95101" y="224737"/>
                  <a:pt x="96628" y="228080"/>
                  <a:pt x="98935" y="230848"/>
                </a:cubicBezTo>
                <a:cubicBezTo>
                  <a:pt x="103768" y="236647"/>
                  <a:pt x="113605" y="245227"/>
                  <a:pt x="119921" y="248836"/>
                </a:cubicBezTo>
                <a:cubicBezTo>
                  <a:pt x="122665" y="250404"/>
                  <a:pt x="125918" y="250835"/>
                  <a:pt x="128916" y="251834"/>
                </a:cubicBezTo>
                <a:cubicBezTo>
                  <a:pt x="149533" y="238089"/>
                  <a:pt x="140068" y="242121"/>
                  <a:pt x="155898" y="236844"/>
                </a:cubicBezTo>
                <a:cubicBezTo>
                  <a:pt x="158896" y="233846"/>
                  <a:pt x="164195" y="232032"/>
                  <a:pt x="164892" y="227850"/>
                </a:cubicBezTo>
                <a:cubicBezTo>
                  <a:pt x="168346" y="207126"/>
                  <a:pt x="165284" y="185739"/>
                  <a:pt x="167890" y="164891"/>
                </a:cubicBezTo>
                <a:cubicBezTo>
                  <a:pt x="168337" y="161316"/>
                  <a:pt x="170888" y="157896"/>
                  <a:pt x="173886" y="155897"/>
                </a:cubicBezTo>
                <a:cubicBezTo>
                  <a:pt x="177314" y="153611"/>
                  <a:pt x="181881" y="153898"/>
                  <a:pt x="185878" y="152899"/>
                </a:cubicBezTo>
                <a:cubicBezTo>
                  <a:pt x="191874" y="148902"/>
                  <a:pt x="198770" y="146003"/>
                  <a:pt x="203866" y="140907"/>
                </a:cubicBezTo>
                <a:cubicBezTo>
                  <a:pt x="215095" y="129678"/>
                  <a:pt x="208838" y="133254"/>
                  <a:pt x="221855" y="128915"/>
                </a:cubicBezTo>
                <a:cubicBezTo>
                  <a:pt x="220855" y="108928"/>
                  <a:pt x="222436" y="88643"/>
                  <a:pt x="218856" y="68954"/>
                </a:cubicBezTo>
                <a:cubicBezTo>
                  <a:pt x="218211" y="65409"/>
                  <a:pt x="212410" y="65506"/>
                  <a:pt x="209862" y="62958"/>
                </a:cubicBezTo>
                <a:cubicBezTo>
                  <a:pt x="207314" y="60410"/>
                  <a:pt x="206414" y="56512"/>
                  <a:pt x="203866" y="53964"/>
                </a:cubicBezTo>
                <a:cubicBezTo>
                  <a:pt x="201318" y="51416"/>
                  <a:pt x="198184" y="49387"/>
                  <a:pt x="194872" y="47968"/>
                </a:cubicBezTo>
                <a:cubicBezTo>
                  <a:pt x="181424" y="42205"/>
                  <a:pt x="185554" y="47806"/>
                  <a:pt x="173886" y="41972"/>
                </a:cubicBezTo>
                <a:cubicBezTo>
                  <a:pt x="170663" y="40361"/>
                  <a:pt x="168310" y="37115"/>
                  <a:pt x="164892" y="35976"/>
                </a:cubicBezTo>
                <a:cubicBezTo>
                  <a:pt x="138922" y="27319"/>
                  <a:pt x="142907" y="19987"/>
                  <a:pt x="131914" y="14990"/>
                </a:cubicBezTo>
                <a:close/>
              </a:path>
            </a:pathLst>
          </a:custGeom>
          <a:noFill/>
          <a:ln>
            <a:solidFill>
              <a:schemeClr val="accent4">
                <a:lumMod val="60000"/>
                <a:lumOff val="40000"/>
              </a:schemeClr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30" name="Freeform 29"/>
          <p:cNvSpPr/>
          <p:nvPr/>
        </p:nvSpPr>
        <p:spPr>
          <a:xfrm>
            <a:off x="3300795" y="3353778"/>
            <a:ext cx="509666" cy="512663"/>
          </a:xfrm>
          <a:custGeom>
            <a:avLst/>
            <a:gdLst>
              <a:gd name="connsiteX0" fmla="*/ 296805 w 509666"/>
              <a:gd name="connsiteY0" fmla="*/ 1055 h 510720"/>
              <a:gd name="connsiteX1" fmla="*/ 320790 w 509666"/>
              <a:gd name="connsiteY1" fmla="*/ 37031 h 510720"/>
              <a:gd name="connsiteX2" fmla="*/ 323788 w 509666"/>
              <a:gd name="connsiteY2" fmla="*/ 49023 h 510720"/>
              <a:gd name="connsiteX3" fmla="*/ 311796 w 509666"/>
              <a:gd name="connsiteY3" fmla="*/ 85000 h 510720"/>
              <a:gd name="connsiteX4" fmla="*/ 335780 w 509666"/>
              <a:gd name="connsiteY4" fmla="*/ 105986 h 510720"/>
              <a:gd name="connsiteX5" fmla="*/ 344774 w 509666"/>
              <a:gd name="connsiteY5" fmla="*/ 111982 h 510720"/>
              <a:gd name="connsiteX6" fmla="*/ 371756 w 509666"/>
              <a:gd name="connsiteY6" fmla="*/ 105986 h 510720"/>
              <a:gd name="connsiteX7" fmla="*/ 389745 w 509666"/>
              <a:gd name="connsiteY7" fmla="*/ 96992 h 510720"/>
              <a:gd name="connsiteX8" fmla="*/ 407733 w 509666"/>
              <a:gd name="connsiteY8" fmla="*/ 102988 h 510720"/>
              <a:gd name="connsiteX9" fmla="*/ 416727 w 509666"/>
              <a:gd name="connsiteY9" fmla="*/ 105986 h 510720"/>
              <a:gd name="connsiteX10" fmla="*/ 425721 w 509666"/>
              <a:gd name="connsiteY10" fmla="*/ 114980 h 510720"/>
              <a:gd name="connsiteX11" fmla="*/ 443709 w 509666"/>
              <a:gd name="connsiteY11" fmla="*/ 132968 h 510720"/>
              <a:gd name="connsiteX12" fmla="*/ 449705 w 509666"/>
              <a:gd name="connsiteY12" fmla="*/ 150956 h 510720"/>
              <a:gd name="connsiteX13" fmla="*/ 452703 w 509666"/>
              <a:gd name="connsiteY13" fmla="*/ 162949 h 510720"/>
              <a:gd name="connsiteX14" fmla="*/ 461697 w 509666"/>
              <a:gd name="connsiteY14" fmla="*/ 177939 h 510720"/>
              <a:gd name="connsiteX15" fmla="*/ 476687 w 509666"/>
              <a:gd name="connsiteY15" fmla="*/ 213915 h 510720"/>
              <a:gd name="connsiteX16" fmla="*/ 491678 w 509666"/>
              <a:gd name="connsiteY16" fmla="*/ 240897 h 510720"/>
              <a:gd name="connsiteX17" fmla="*/ 503670 w 509666"/>
              <a:gd name="connsiteY17" fmla="*/ 261884 h 510720"/>
              <a:gd name="connsiteX18" fmla="*/ 506668 w 509666"/>
              <a:gd name="connsiteY18" fmla="*/ 273876 h 510720"/>
              <a:gd name="connsiteX19" fmla="*/ 509666 w 509666"/>
              <a:gd name="connsiteY19" fmla="*/ 282870 h 510720"/>
              <a:gd name="connsiteX20" fmla="*/ 506668 w 509666"/>
              <a:gd name="connsiteY20" fmla="*/ 324842 h 510720"/>
              <a:gd name="connsiteX21" fmla="*/ 494676 w 509666"/>
              <a:gd name="connsiteY21" fmla="*/ 339833 h 510720"/>
              <a:gd name="connsiteX22" fmla="*/ 479685 w 509666"/>
              <a:gd name="connsiteY22" fmla="*/ 357821 h 510720"/>
              <a:gd name="connsiteX23" fmla="*/ 467693 w 509666"/>
              <a:gd name="connsiteY23" fmla="*/ 360819 h 510720"/>
              <a:gd name="connsiteX24" fmla="*/ 428719 w 509666"/>
              <a:gd name="connsiteY24" fmla="*/ 369813 h 510720"/>
              <a:gd name="connsiteX25" fmla="*/ 407733 w 509666"/>
              <a:gd name="connsiteY25" fmla="*/ 363817 h 510720"/>
              <a:gd name="connsiteX26" fmla="*/ 386746 w 509666"/>
              <a:gd name="connsiteY26" fmla="*/ 351825 h 510720"/>
              <a:gd name="connsiteX27" fmla="*/ 335780 w 509666"/>
              <a:gd name="connsiteY27" fmla="*/ 354823 h 510720"/>
              <a:gd name="connsiteX28" fmla="*/ 311796 w 509666"/>
              <a:gd name="connsiteY28" fmla="*/ 360819 h 510720"/>
              <a:gd name="connsiteX29" fmla="*/ 302802 w 509666"/>
              <a:gd name="connsiteY29" fmla="*/ 366815 h 510720"/>
              <a:gd name="connsiteX30" fmla="*/ 281815 w 509666"/>
              <a:gd name="connsiteY30" fmla="*/ 378807 h 510720"/>
              <a:gd name="connsiteX31" fmla="*/ 263827 w 509666"/>
              <a:gd name="connsiteY31" fmla="*/ 393797 h 510720"/>
              <a:gd name="connsiteX32" fmla="*/ 257831 w 509666"/>
              <a:gd name="connsiteY32" fmla="*/ 402791 h 510720"/>
              <a:gd name="connsiteX33" fmla="*/ 251835 w 509666"/>
              <a:gd name="connsiteY33" fmla="*/ 423777 h 510720"/>
              <a:gd name="connsiteX34" fmla="*/ 248837 w 509666"/>
              <a:gd name="connsiteY34" fmla="*/ 438768 h 510720"/>
              <a:gd name="connsiteX35" fmla="*/ 242841 w 509666"/>
              <a:gd name="connsiteY35" fmla="*/ 447762 h 510720"/>
              <a:gd name="connsiteX36" fmla="*/ 239843 w 509666"/>
              <a:gd name="connsiteY36" fmla="*/ 459754 h 510720"/>
              <a:gd name="connsiteX37" fmla="*/ 221855 w 509666"/>
              <a:gd name="connsiteY37" fmla="*/ 471746 h 510720"/>
              <a:gd name="connsiteX38" fmla="*/ 200868 w 509666"/>
              <a:gd name="connsiteY38" fmla="*/ 468748 h 510720"/>
              <a:gd name="connsiteX39" fmla="*/ 185878 w 509666"/>
              <a:gd name="connsiteY39" fmla="*/ 465750 h 510720"/>
              <a:gd name="connsiteX40" fmla="*/ 131914 w 509666"/>
              <a:gd name="connsiteY40" fmla="*/ 468748 h 510720"/>
              <a:gd name="connsiteX41" fmla="*/ 119922 w 509666"/>
              <a:gd name="connsiteY41" fmla="*/ 474744 h 510720"/>
              <a:gd name="connsiteX42" fmla="*/ 101933 w 509666"/>
              <a:gd name="connsiteY42" fmla="*/ 477742 h 510720"/>
              <a:gd name="connsiteX43" fmla="*/ 89941 w 509666"/>
              <a:gd name="connsiteY43" fmla="*/ 480740 h 510720"/>
              <a:gd name="connsiteX44" fmla="*/ 83945 w 509666"/>
              <a:gd name="connsiteY44" fmla="*/ 489734 h 510720"/>
              <a:gd name="connsiteX45" fmla="*/ 74951 w 509666"/>
              <a:gd name="connsiteY45" fmla="*/ 495730 h 510720"/>
              <a:gd name="connsiteX46" fmla="*/ 53965 w 509666"/>
              <a:gd name="connsiteY46" fmla="*/ 510720 h 510720"/>
              <a:gd name="connsiteX47" fmla="*/ 32979 w 509666"/>
              <a:gd name="connsiteY47" fmla="*/ 507722 h 510720"/>
              <a:gd name="connsiteX48" fmla="*/ 26983 w 509666"/>
              <a:gd name="connsiteY48" fmla="*/ 489734 h 510720"/>
              <a:gd name="connsiteX49" fmla="*/ 23985 w 509666"/>
              <a:gd name="connsiteY49" fmla="*/ 480740 h 510720"/>
              <a:gd name="connsiteX50" fmla="*/ 14990 w 509666"/>
              <a:gd name="connsiteY50" fmla="*/ 435770 h 510720"/>
              <a:gd name="connsiteX51" fmla="*/ 8994 w 509666"/>
              <a:gd name="connsiteY51" fmla="*/ 426775 h 510720"/>
              <a:gd name="connsiteX52" fmla="*/ 2998 w 509666"/>
              <a:gd name="connsiteY52" fmla="*/ 372811 h 510720"/>
              <a:gd name="connsiteX53" fmla="*/ 0 w 509666"/>
              <a:gd name="connsiteY53" fmla="*/ 363817 h 510720"/>
              <a:gd name="connsiteX54" fmla="*/ 2998 w 509666"/>
              <a:gd name="connsiteY54" fmla="*/ 285868 h 510720"/>
              <a:gd name="connsiteX55" fmla="*/ 8994 w 509666"/>
              <a:gd name="connsiteY55" fmla="*/ 264882 h 510720"/>
              <a:gd name="connsiteX56" fmla="*/ 14990 w 509666"/>
              <a:gd name="connsiteY56" fmla="*/ 255888 h 510720"/>
              <a:gd name="connsiteX57" fmla="*/ 20986 w 509666"/>
              <a:gd name="connsiteY57" fmla="*/ 237899 h 510720"/>
              <a:gd name="connsiteX58" fmla="*/ 26983 w 509666"/>
              <a:gd name="connsiteY58" fmla="*/ 231903 h 510720"/>
              <a:gd name="connsiteX59" fmla="*/ 44971 w 509666"/>
              <a:gd name="connsiteY59" fmla="*/ 204921 h 510720"/>
              <a:gd name="connsiteX60" fmla="*/ 50967 w 509666"/>
              <a:gd name="connsiteY60" fmla="*/ 195927 h 510720"/>
              <a:gd name="connsiteX61" fmla="*/ 56963 w 509666"/>
              <a:gd name="connsiteY61" fmla="*/ 186933 h 510720"/>
              <a:gd name="connsiteX62" fmla="*/ 65957 w 509666"/>
              <a:gd name="connsiteY62" fmla="*/ 177939 h 510720"/>
              <a:gd name="connsiteX63" fmla="*/ 86943 w 509666"/>
              <a:gd name="connsiteY63" fmla="*/ 153954 h 510720"/>
              <a:gd name="connsiteX64" fmla="*/ 98935 w 509666"/>
              <a:gd name="connsiteY64" fmla="*/ 138964 h 510720"/>
              <a:gd name="connsiteX65" fmla="*/ 119922 w 509666"/>
              <a:gd name="connsiteY65" fmla="*/ 117978 h 510720"/>
              <a:gd name="connsiteX66" fmla="*/ 131914 w 509666"/>
              <a:gd name="connsiteY66" fmla="*/ 105986 h 510720"/>
              <a:gd name="connsiteX67" fmla="*/ 140908 w 509666"/>
              <a:gd name="connsiteY67" fmla="*/ 87998 h 510720"/>
              <a:gd name="connsiteX68" fmla="*/ 158896 w 509666"/>
              <a:gd name="connsiteY68" fmla="*/ 70010 h 510720"/>
              <a:gd name="connsiteX69" fmla="*/ 167890 w 509666"/>
              <a:gd name="connsiteY69" fmla="*/ 61015 h 510720"/>
              <a:gd name="connsiteX70" fmla="*/ 188876 w 509666"/>
              <a:gd name="connsiteY70" fmla="*/ 55019 h 510720"/>
              <a:gd name="connsiteX71" fmla="*/ 206865 w 509666"/>
              <a:gd name="connsiteY71" fmla="*/ 46025 h 510720"/>
              <a:gd name="connsiteX72" fmla="*/ 236845 w 509666"/>
              <a:gd name="connsiteY72" fmla="*/ 31035 h 510720"/>
              <a:gd name="connsiteX73" fmla="*/ 245839 w 509666"/>
              <a:gd name="connsiteY73" fmla="*/ 28037 h 510720"/>
              <a:gd name="connsiteX74" fmla="*/ 257831 w 509666"/>
              <a:gd name="connsiteY74" fmla="*/ 10049 h 510720"/>
              <a:gd name="connsiteX75" fmla="*/ 296805 w 509666"/>
              <a:gd name="connsiteY75" fmla="*/ 1055 h 51072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  <a:cxn ang="0">
                <a:pos x="connsiteX75" y="connsiteY75"/>
              </a:cxn>
            </a:cxnLst>
            <a:rect l="l" t="t" r="r" b="b"/>
            <a:pathLst>
              <a:path w="509666" h="510720">
                <a:moveTo>
                  <a:pt x="296805" y="1055"/>
                </a:moveTo>
                <a:cubicBezTo>
                  <a:pt x="307298" y="5552"/>
                  <a:pt x="306139" y="17497"/>
                  <a:pt x="320790" y="37031"/>
                </a:cubicBezTo>
                <a:cubicBezTo>
                  <a:pt x="321789" y="41028"/>
                  <a:pt x="324104" y="44915"/>
                  <a:pt x="323788" y="49023"/>
                </a:cubicBezTo>
                <a:cubicBezTo>
                  <a:pt x="322020" y="72009"/>
                  <a:pt x="320944" y="71278"/>
                  <a:pt x="311796" y="85000"/>
                </a:cubicBezTo>
                <a:cubicBezTo>
                  <a:pt x="321789" y="99990"/>
                  <a:pt x="314794" y="91995"/>
                  <a:pt x="335780" y="105986"/>
                </a:cubicBezTo>
                <a:lnTo>
                  <a:pt x="344774" y="111982"/>
                </a:lnTo>
                <a:cubicBezTo>
                  <a:pt x="351683" y="110831"/>
                  <a:pt x="364376" y="109676"/>
                  <a:pt x="371756" y="105986"/>
                </a:cubicBezTo>
                <a:cubicBezTo>
                  <a:pt x="395001" y="94364"/>
                  <a:pt x="367138" y="104527"/>
                  <a:pt x="389745" y="96992"/>
                </a:cubicBezTo>
                <a:lnTo>
                  <a:pt x="407733" y="102988"/>
                </a:lnTo>
                <a:lnTo>
                  <a:pt x="416727" y="105986"/>
                </a:lnTo>
                <a:cubicBezTo>
                  <a:pt x="419725" y="108984"/>
                  <a:pt x="422502" y="112221"/>
                  <a:pt x="425721" y="114980"/>
                </a:cubicBezTo>
                <a:cubicBezTo>
                  <a:pt x="435193" y="123099"/>
                  <a:pt x="438837" y="122007"/>
                  <a:pt x="443709" y="132968"/>
                </a:cubicBezTo>
                <a:cubicBezTo>
                  <a:pt x="446276" y="138744"/>
                  <a:pt x="448172" y="144824"/>
                  <a:pt x="449705" y="150956"/>
                </a:cubicBezTo>
                <a:cubicBezTo>
                  <a:pt x="450704" y="154954"/>
                  <a:pt x="451029" y="159183"/>
                  <a:pt x="452703" y="162949"/>
                </a:cubicBezTo>
                <a:cubicBezTo>
                  <a:pt x="455070" y="168274"/>
                  <a:pt x="458699" y="172942"/>
                  <a:pt x="461697" y="177939"/>
                </a:cubicBezTo>
                <a:cubicBezTo>
                  <a:pt x="468400" y="211452"/>
                  <a:pt x="459213" y="202266"/>
                  <a:pt x="476687" y="213915"/>
                </a:cubicBezTo>
                <a:cubicBezTo>
                  <a:pt x="484025" y="235925"/>
                  <a:pt x="478215" y="227434"/>
                  <a:pt x="491678" y="240897"/>
                </a:cubicBezTo>
                <a:cubicBezTo>
                  <a:pt x="499561" y="272433"/>
                  <a:pt x="487794" y="234100"/>
                  <a:pt x="503670" y="261884"/>
                </a:cubicBezTo>
                <a:cubicBezTo>
                  <a:pt x="505714" y="265461"/>
                  <a:pt x="505536" y="269914"/>
                  <a:pt x="506668" y="273876"/>
                </a:cubicBezTo>
                <a:cubicBezTo>
                  <a:pt x="507536" y="276915"/>
                  <a:pt x="508667" y="279872"/>
                  <a:pt x="509666" y="282870"/>
                </a:cubicBezTo>
                <a:cubicBezTo>
                  <a:pt x="508667" y="296861"/>
                  <a:pt x="509106" y="311029"/>
                  <a:pt x="506668" y="324842"/>
                </a:cubicBezTo>
                <a:cubicBezTo>
                  <a:pt x="505673" y="330482"/>
                  <a:pt x="498066" y="335764"/>
                  <a:pt x="494676" y="339833"/>
                </a:cubicBezTo>
                <a:cubicBezTo>
                  <a:pt x="493979" y="340669"/>
                  <a:pt x="483562" y="355883"/>
                  <a:pt x="479685" y="357821"/>
                </a:cubicBezTo>
                <a:cubicBezTo>
                  <a:pt x="476000" y="359664"/>
                  <a:pt x="471551" y="359372"/>
                  <a:pt x="467693" y="360819"/>
                </a:cubicBezTo>
                <a:cubicBezTo>
                  <a:pt x="438093" y="371919"/>
                  <a:pt x="479408" y="364181"/>
                  <a:pt x="428719" y="369813"/>
                </a:cubicBezTo>
                <a:cubicBezTo>
                  <a:pt x="422634" y="368292"/>
                  <a:pt x="413754" y="366398"/>
                  <a:pt x="407733" y="363817"/>
                </a:cubicBezTo>
                <a:cubicBezTo>
                  <a:pt x="397084" y="359253"/>
                  <a:pt x="395778" y="357846"/>
                  <a:pt x="386746" y="351825"/>
                </a:cubicBezTo>
                <a:cubicBezTo>
                  <a:pt x="369757" y="352824"/>
                  <a:pt x="352728" y="353282"/>
                  <a:pt x="335780" y="354823"/>
                </a:cubicBezTo>
                <a:cubicBezTo>
                  <a:pt x="331599" y="355203"/>
                  <a:pt x="316999" y="358218"/>
                  <a:pt x="311796" y="360819"/>
                </a:cubicBezTo>
                <a:cubicBezTo>
                  <a:pt x="308573" y="362430"/>
                  <a:pt x="305930" y="365027"/>
                  <a:pt x="302802" y="366815"/>
                </a:cubicBezTo>
                <a:cubicBezTo>
                  <a:pt x="293470" y="372147"/>
                  <a:pt x="289784" y="372166"/>
                  <a:pt x="281815" y="378807"/>
                </a:cubicBezTo>
                <a:cubicBezTo>
                  <a:pt x="258731" y="398043"/>
                  <a:pt x="286157" y="378910"/>
                  <a:pt x="263827" y="393797"/>
                </a:cubicBezTo>
                <a:cubicBezTo>
                  <a:pt x="261828" y="396795"/>
                  <a:pt x="259442" y="399568"/>
                  <a:pt x="257831" y="402791"/>
                </a:cubicBezTo>
                <a:cubicBezTo>
                  <a:pt x="255828" y="406797"/>
                  <a:pt x="252603" y="420319"/>
                  <a:pt x="251835" y="423777"/>
                </a:cubicBezTo>
                <a:cubicBezTo>
                  <a:pt x="250730" y="428752"/>
                  <a:pt x="250626" y="433996"/>
                  <a:pt x="248837" y="438768"/>
                </a:cubicBezTo>
                <a:cubicBezTo>
                  <a:pt x="247572" y="442142"/>
                  <a:pt x="244840" y="444764"/>
                  <a:pt x="242841" y="447762"/>
                </a:cubicBezTo>
                <a:cubicBezTo>
                  <a:pt x="241842" y="451759"/>
                  <a:pt x="241887" y="456177"/>
                  <a:pt x="239843" y="459754"/>
                </a:cubicBezTo>
                <a:cubicBezTo>
                  <a:pt x="234559" y="469001"/>
                  <a:pt x="230440" y="468884"/>
                  <a:pt x="221855" y="471746"/>
                </a:cubicBezTo>
                <a:cubicBezTo>
                  <a:pt x="214859" y="470747"/>
                  <a:pt x="207839" y="469910"/>
                  <a:pt x="200868" y="468748"/>
                </a:cubicBezTo>
                <a:cubicBezTo>
                  <a:pt x="195842" y="467910"/>
                  <a:pt x="190974" y="465750"/>
                  <a:pt x="185878" y="465750"/>
                </a:cubicBezTo>
                <a:cubicBezTo>
                  <a:pt x="167862" y="465750"/>
                  <a:pt x="149902" y="467749"/>
                  <a:pt x="131914" y="468748"/>
                </a:cubicBezTo>
                <a:cubicBezTo>
                  <a:pt x="127917" y="470747"/>
                  <a:pt x="124203" y="473460"/>
                  <a:pt x="119922" y="474744"/>
                </a:cubicBezTo>
                <a:cubicBezTo>
                  <a:pt x="114099" y="476491"/>
                  <a:pt x="107894" y="476550"/>
                  <a:pt x="101933" y="477742"/>
                </a:cubicBezTo>
                <a:cubicBezTo>
                  <a:pt x="97893" y="478550"/>
                  <a:pt x="93938" y="479741"/>
                  <a:pt x="89941" y="480740"/>
                </a:cubicBezTo>
                <a:cubicBezTo>
                  <a:pt x="87942" y="483738"/>
                  <a:pt x="86493" y="487186"/>
                  <a:pt x="83945" y="489734"/>
                </a:cubicBezTo>
                <a:cubicBezTo>
                  <a:pt x="81397" y="492282"/>
                  <a:pt x="77883" y="493636"/>
                  <a:pt x="74951" y="495730"/>
                </a:cubicBezTo>
                <a:cubicBezTo>
                  <a:pt x="48921" y="514323"/>
                  <a:pt x="75161" y="496589"/>
                  <a:pt x="53965" y="510720"/>
                </a:cubicBezTo>
                <a:cubicBezTo>
                  <a:pt x="46970" y="509721"/>
                  <a:pt x="38557" y="512060"/>
                  <a:pt x="32979" y="507722"/>
                </a:cubicBezTo>
                <a:cubicBezTo>
                  <a:pt x="27990" y="503842"/>
                  <a:pt x="28982" y="495730"/>
                  <a:pt x="26983" y="489734"/>
                </a:cubicBezTo>
                <a:lnTo>
                  <a:pt x="23985" y="480740"/>
                </a:lnTo>
                <a:cubicBezTo>
                  <a:pt x="22825" y="470304"/>
                  <a:pt x="22076" y="446400"/>
                  <a:pt x="14990" y="435770"/>
                </a:cubicBezTo>
                <a:lnTo>
                  <a:pt x="8994" y="426775"/>
                </a:lnTo>
                <a:cubicBezTo>
                  <a:pt x="7183" y="403232"/>
                  <a:pt x="7934" y="392556"/>
                  <a:pt x="2998" y="372811"/>
                </a:cubicBezTo>
                <a:cubicBezTo>
                  <a:pt x="2232" y="369745"/>
                  <a:pt x="999" y="366815"/>
                  <a:pt x="0" y="363817"/>
                </a:cubicBezTo>
                <a:cubicBezTo>
                  <a:pt x="999" y="337834"/>
                  <a:pt x="1268" y="311813"/>
                  <a:pt x="2998" y="285868"/>
                </a:cubicBezTo>
                <a:cubicBezTo>
                  <a:pt x="3146" y="283651"/>
                  <a:pt x="7467" y="267936"/>
                  <a:pt x="8994" y="264882"/>
                </a:cubicBezTo>
                <a:cubicBezTo>
                  <a:pt x="10605" y="261659"/>
                  <a:pt x="13527" y="259181"/>
                  <a:pt x="14990" y="255888"/>
                </a:cubicBezTo>
                <a:cubicBezTo>
                  <a:pt x="17557" y="250112"/>
                  <a:pt x="16516" y="242368"/>
                  <a:pt x="20986" y="237899"/>
                </a:cubicBezTo>
                <a:cubicBezTo>
                  <a:pt x="22985" y="235900"/>
                  <a:pt x="25287" y="234164"/>
                  <a:pt x="26983" y="231903"/>
                </a:cubicBezTo>
                <a:lnTo>
                  <a:pt x="44971" y="204921"/>
                </a:lnTo>
                <a:lnTo>
                  <a:pt x="50967" y="195927"/>
                </a:lnTo>
                <a:cubicBezTo>
                  <a:pt x="52966" y="192929"/>
                  <a:pt x="54415" y="189481"/>
                  <a:pt x="56963" y="186933"/>
                </a:cubicBezTo>
                <a:cubicBezTo>
                  <a:pt x="59961" y="183935"/>
                  <a:pt x="63354" y="181286"/>
                  <a:pt x="65957" y="177939"/>
                </a:cubicBezTo>
                <a:cubicBezTo>
                  <a:pt x="84792" y="153723"/>
                  <a:pt x="69531" y="165564"/>
                  <a:pt x="86943" y="153954"/>
                </a:cubicBezTo>
                <a:cubicBezTo>
                  <a:pt x="93694" y="133700"/>
                  <a:pt x="84331" y="155654"/>
                  <a:pt x="98935" y="138964"/>
                </a:cubicBezTo>
                <a:cubicBezTo>
                  <a:pt x="118744" y="116325"/>
                  <a:pt x="101431" y="124141"/>
                  <a:pt x="119922" y="117978"/>
                </a:cubicBezTo>
                <a:cubicBezTo>
                  <a:pt x="123919" y="113981"/>
                  <a:pt x="128628" y="110586"/>
                  <a:pt x="131914" y="105986"/>
                </a:cubicBezTo>
                <a:cubicBezTo>
                  <a:pt x="150856" y="79467"/>
                  <a:pt x="116279" y="115705"/>
                  <a:pt x="140908" y="87998"/>
                </a:cubicBezTo>
                <a:cubicBezTo>
                  <a:pt x="146542" y="81660"/>
                  <a:pt x="152900" y="76006"/>
                  <a:pt x="158896" y="70010"/>
                </a:cubicBezTo>
                <a:cubicBezTo>
                  <a:pt x="161894" y="67012"/>
                  <a:pt x="163777" y="62043"/>
                  <a:pt x="167890" y="61015"/>
                </a:cubicBezTo>
                <a:cubicBezTo>
                  <a:pt x="171732" y="60054"/>
                  <a:pt x="184575" y="57169"/>
                  <a:pt x="188876" y="55019"/>
                </a:cubicBezTo>
                <a:cubicBezTo>
                  <a:pt x="212121" y="43397"/>
                  <a:pt x="184258" y="53560"/>
                  <a:pt x="206865" y="46025"/>
                </a:cubicBezTo>
                <a:cubicBezTo>
                  <a:pt x="223913" y="33239"/>
                  <a:pt x="214117" y="38611"/>
                  <a:pt x="236845" y="31035"/>
                </a:cubicBezTo>
                <a:lnTo>
                  <a:pt x="245839" y="28037"/>
                </a:lnTo>
                <a:cubicBezTo>
                  <a:pt x="249534" y="16952"/>
                  <a:pt x="247466" y="18686"/>
                  <a:pt x="257831" y="10049"/>
                </a:cubicBezTo>
                <a:cubicBezTo>
                  <a:pt x="260599" y="7742"/>
                  <a:pt x="286312" y="-3442"/>
                  <a:pt x="296805" y="1055"/>
                </a:cubicBezTo>
                <a:close/>
              </a:path>
            </a:pathLst>
          </a:custGeom>
          <a:noFill/>
          <a:ln>
            <a:solidFill>
              <a:schemeClr val="accent4">
                <a:lumMod val="60000"/>
                <a:lumOff val="40000"/>
              </a:schemeClr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31" name="Freeform 30"/>
          <p:cNvSpPr/>
          <p:nvPr/>
        </p:nvSpPr>
        <p:spPr>
          <a:xfrm>
            <a:off x="3488238" y="4526009"/>
            <a:ext cx="303785" cy="242840"/>
          </a:xfrm>
          <a:custGeom>
            <a:avLst/>
            <a:gdLst>
              <a:gd name="connsiteX0" fmla="*/ 271256 w 303785"/>
              <a:gd name="connsiteY0" fmla="*/ 95937 h 242840"/>
              <a:gd name="connsiteX1" fmla="*/ 256266 w 303785"/>
              <a:gd name="connsiteY1" fmla="*/ 86943 h 242840"/>
              <a:gd name="connsiteX2" fmla="*/ 241276 w 303785"/>
              <a:gd name="connsiteY2" fmla="*/ 68954 h 242840"/>
              <a:gd name="connsiteX3" fmla="*/ 232282 w 303785"/>
              <a:gd name="connsiteY3" fmla="*/ 59960 h 242840"/>
              <a:gd name="connsiteX4" fmla="*/ 220290 w 303785"/>
              <a:gd name="connsiteY4" fmla="*/ 35976 h 242840"/>
              <a:gd name="connsiteX5" fmla="*/ 214294 w 303785"/>
              <a:gd name="connsiteY5" fmla="*/ 11992 h 242840"/>
              <a:gd name="connsiteX6" fmla="*/ 205300 w 303785"/>
              <a:gd name="connsiteY6" fmla="*/ 5996 h 242840"/>
              <a:gd name="connsiteX7" fmla="*/ 181315 w 303785"/>
              <a:gd name="connsiteY7" fmla="*/ 0 h 242840"/>
              <a:gd name="connsiteX8" fmla="*/ 124353 w 303785"/>
              <a:gd name="connsiteY8" fmla="*/ 5996 h 242840"/>
              <a:gd name="connsiteX9" fmla="*/ 109362 w 303785"/>
              <a:gd name="connsiteY9" fmla="*/ 17988 h 242840"/>
              <a:gd name="connsiteX10" fmla="*/ 100368 w 303785"/>
              <a:gd name="connsiteY10" fmla="*/ 20986 h 242840"/>
              <a:gd name="connsiteX11" fmla="*/ 91374 w 303785"/>
              <a:gd name="connsiteY11" fmla="*/ 29980 h 242840"/>
              <a:gd name="connsiteX12" fmla="*/ 73386 w 303785"/>
              <a:gd name="connsiteY12" fmla="*/ 44970 h 242840"/>
              <a:gd name="connsiteX13" fmla="*/ 58396 w 303785"/>
              <a:gd name="connsiteY13" fmla="*/ 71952 h 242840"/>
              <a:gd name="connsiteX14" fmla="*/ 49402 w 303785"/>
              <a:gd name="connsiteY14" fmla="*/ 83945 h 242840"/>
              <a:gd name="connsiteX15" fmla="*/ 40408 w 303785"/>
              <a:gd name="connsiteY15" fmla="*/ 89941 h 242840"/>
              <a:gd name="connsiteX16" fmla="*/ 16423 w 303785"/>
              <a:gd name="connsiteY16" fmla="*/ 110927 h 242840"/>
              <a:gd name="connsiteX17" fmla="*/ 7429 w 303785"/>
              <a:gd name="connsiteY17" fmla="*/ 116923 h 242840"/>
              <a:gd name="connsiteX18" fmla="*/ 4431 w 303785"/>
              <a:gd name="connsiteY18" fmla="*/ 125917 h 242840"/>
              <a:gd name="connsiteX19" fmla="*/ 4431 w 303785"/>
              <a:gd name="connsiteY19" fmla="*/ 188876 h 242840"/>
              <a:gd name="connsiteX20" fmla="*/ 10427 w 303785"/>
              <a:gd name="connsiteY20" fmla="*/ 197870 h 242840"/>
              <a:gd name="connsiteX21" fmla="*/ 19422 w 303785"/>
              <a:gd name="connsiteY21" fmla="*/ 200868 h 242840"/>
              <a:gd name="connsiteX22" fmla="*/ 34412 w 303785"/>
              <a:gd name="connsiteY22" fmla="*/ 215858 h 242840"/>
              <a:gd name="connsiteX23" fmla="*/ 43406 w 303785"/>
              <a:gd name="connsiteY23" fmla="*/ 221854 h 242840"/>
              <a:gd name="connsiteX24" fmla="*/ 52400 w 303785"/>
              <a:gd name="connsiteY24" fmla="*/ 230848 h 242840"/>
              <a:gd name="connsiteX25" fmla="*/ 55398 w 303785"/>
              <a:gd name="connsiteY25" fmla="*/ 239842 h 242840"/>
              <a:gd name="connsiteX26" fmla="*/ 64392 w 303785"/>
              <a:gd name="connsiteY26" fmla="*/ 242840 h 242840"/>
              <a:gd name="connsiteX27" fmla="*/ 91374 w 303785"/>
              <a:gd name="connsiteY27" fmla="*/ 239842 h 242840"/>
              <a:gd name="connsiteX28" fmla="*/ 100368 w 303785"/>
              <a:gd name="connsiteY28" fmla="*/ 233846 h 242840"/>
              <a:gd name="connsiteX29" fmla="*/ 109362 w 303785"/>
              <a:gd name="connsiteY29" fmla="*/ 230848 h 242840"/>
              <a:gd name="connsiteX30" fmla="*/ 118357 w 303785"/>
              <a:gd name="connsiteY30" fmla="*/ 221854 h 242840"/>
              <a:gd name="connsiteX31" fmla="*/ 121355 w 303785"/>
              <a:gd name="connsiteY31" fmla="*/ 212860 h 242840"/>
              <a:gd name="connsiteX32" fmla="*/ 127351 w 303785"/>
              <a:gd name="connsiteY32" fmla="*/ 203866 h 242840"/>
              <a:gd name="connsiteX33" fmla="*/ 133347 w 303785"/>
              <a:gd name="connsiteY33" fmla="*/ 173886 h 242840"/>
              <a:gd name="connsiteX34" fmla="*/ 139343 w 303785"/>
              <a:gd name="connsiteY34" fmla="*/ 167889 h 242840"/>
              <a:gd name="connsiteX35" fmla="*/ 142341 w 303785"/>
              <a:gd name="connsiteY35" fmla="*/ 158895 h 242840"/>
              <a:gd name="connsiteX36" fmla="*/ 136345 w 303785"/>
              <a:gd name="connsiteY36" fmla="*/ 137909 h 242840"/>
              <a:gd name="connsiteX37" fmla="*/ 127351 w 303785"/>
              <a:gd name="connsiteY37" fmla="*/ 104931 h 242840"/>
              <a:gd name="connsiteX38" fmla="*/ 136345 w 303785"/>
              <a:gd name="connsiteY38" fmla="*/ 80946 h 242840"/>
              <a:gd name="connsiteX39" fmla="*/ 145339 w 303785"/>
              <a:gd name="connsiteY39" fmla="*/ 77948 h 242840"/>
              <a:gd name="connsiteX40" fmla="*/ 160329 w 303785"/>
              <a:gd name="connsiteY40" fmla="*/ 92939 h 242840"/>
              <a:gd name="connsiteX41" fmla="*/ 169323 w 303785"/>
              <a:gd name="connsiteY41" fmla="*/ 101933 h 242840"/>
              <a:gd name="connsiteX42" fmla="*/ 175319 w 303785"/>
              <a:gd name="connsiteY42" fmla="*/ 110927 h 242840"/>
              <a:gd name="connsiteX43" fmla="*/ 193307 w 303785"/>
              <a:gd name="connsiteY43" fmla="*/ 116923 h 242840"/>
              <a:gd name="connsiteX44" fmla="*/ 205300 w 303785"/>
              <a:gd name="connsiteY44" fmla="*/ 125917 h 242840"/>
              <a:gd name="connsiteX45" fmla="*/ 235280 w 303785"/>
              <a:gd name="connsiteY45" fmla="*/ 131913 h 242840"/>
              <a:gd name="connsiteX46" fmla="*/ 244274 w 303785"/>
              <a:gd name="connsiteY46" fmla="*/ 134911 h 242840"/>
              <a:gd name="connsiteX47" fmla="*/ 265260 w 303785"/>
              <a:gd name="connsiteY47" fmla="*/ 140907 h 242840"/>
              <a:gd name="connsiteX48" fmla="*/ 295241 w 303785"/>
              <a:gd name="connsiteY48" fmla="*/ 134911 h 242840"/>
              <a:gd name="connsiteX49" fmla="*/ 283248 w 303785"/>
              <a:gd name="connsiteY49" fmla="*/ 98935 h 242840"/>
              <a:gd name="connsiteX50" fmla="*/ 271256 w 303785"/>
              <a:gd name="connsiteY50" fmla="*/ 95937 h 24284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</a:cxnLst>
            <a:rect l="l" t="t" r="r" b="b"/>
            <a:pathLst>
              <a:path w="303785" h="242840">
                <a:moveTo>
                  <a:pt x="271256" y="95937"/>
                </a:moveTo>
                <a:cubicBezTo>
                  <a:pt x="266759" y="93938"/>
                  <a:pt x="260928" y="90439"/>
                  <a:pt x="256266" y="86943"/>
                </a:cubicBezTo>
                <a:cubicBezTo>
                  <a:pt x="244589" y="78185"/>
                  <a:pt x="249739" y="79109"/>
                  <a:pt x="241276" y="68954"/>
                </a:cubicBezTo>
                <a:cubicBezTo>
                  <a:pt x="238562" y="65697"/>
                  <a:pt x="235280" y="62958"/>
                  <a:pt x="232282" y="59960"/>
                </a:cubicBezTo>
                <a:cubicBezTo>
                  <a:pt x="223406" y="15579"/>
                  <a:pt x="237086" y="69568"/>
                  <a:pt x="220290" y="35976"/>
                </a:cubicBezTo>
                <a:cubicBezTo>
                  <a:pt x="219543" y="34483"/>
                  <a:pt x="217123" y="15528"/>
                  <a:pt x="214294" y="11992"/>
                </a:cubicBezTo>
                <a:cubicBezTo>
                  <a:pt x="212043" y="9178"/>
                  <a:pt x="208686" y="7227"/>
                  <a:pt x="205300" y="5996"/>
                </a:cubicBezTo>
                <a:cubicBezTo>
                  <a:pt x="197555" y="3180"/>
                  <a:pt x="181315" y="0"/>
                  <a:pt x="181315" y="0"/>
                </a:cubicBezTo>
                <a:cubicBezTo>
                  <a:pt x="179202" y="192"/>
                  <a:pt x="130904" y="4209"/>
                  <a:pt x="124353" y="5996"/>
                </a:cubicBezTo>
                <a:cubicBezTo>
                  <a:pt x="113356" y="8995"/>
                  <a:pt x="117633" y="13026"/>
                  <a:pt x="109362" y="17988"/>
                </a:cubicBezTo>
                <a:cubicBezTo>
                  <a:pt x="106652" y="19614"/>
                  <a:pt x="103366" y="19987"/>
                  <a:pt x="100368" y="20986"/>
                </a:cubicBezTo>
                <a:cubicBezTo>
                  <a:pt x="97370" y="23984"/>
                  <a:pt x="94631" y="27266"/>
                  <a:pt x="91374" y="29980"/>
                </a:cubicBezTo>
                <a:cubicBezTo>
                  <a:pt x="66331" y="50850"/>
                  <a:pt x="99662" y="18694"/>
                  <a:pt x="73386" y="44970"/>
                </a:cubicBezTo>
                <a:cubicBezTo>
                  <a:pt x="68712" y="58993"/>
                  <a:pt x="70767" y="55456"/>
                  <a:pt x="58396" y="71952"/>
                </a:cubicBezTo>
                <a:cubicBezTo>
                  <a:pt x="55398" y="75950"/>
                  <a:pt x="52935" y="80412"/>
                  <a:pt x="49402" y="83945"/>
                </a:cubicBezTo>
                <a:cubicBezTo>
                  <a:pt x="46854" y="86493"/>
                  <a:pt x="43406" y="87942"/>
                  <a:pt x="40408" y="89941"/>
                </a:cubicBezTo>
                <a:cubicBezTo>
                  <a:pt x="30414" y="104931"/>
                  <a:pt x="37410" y="96936"/>
                  <a:pt x="16423" y="110927"/>
                </a:cubicBezTo>
                <a:lnTo>
                  <a:pt x="7429" y="116923"/>
                </a:lnTo>
                <a:cubicBezTo>
                  <a:pt x="6430" y="119921"/>
                  <a:pt x="5299" y="122878"/>
                  <a:pt x="4431" y="125917"/>
                </a:cubicBezTo>
                <a:cubicBezTo>
                  <a:pt x="-2248" y="149292"/>
                  <a:pt x="-655" y="154971"/>
                  <a:pt x="4431" y="188876"/>
                </a:cubicBezTo>
                <a:cubicBezTo>
                  <a:pt x="4965" y="192439"/>
                  <a:pt x="7613" y="195619"/>
                  <a:pt x="10427" y="197870"/>
                </a:cubicBezTo>
                <a:cubicBezTo>
                  <a:pt x="12895" y="199844"/>
                  <a:pt x="16424" y="199869"/>
                  <a:pt x="19422" y="200868"/>
                </a:cubicBezTo>
                <a:cubicBezTo>
                  <a:pt x="43406" y="216857"/>
                  <a:pt x="14425" y="195871"/>
                  <a:pt x="34412" y="215858"/>
                </a:cubicBezTo>
                <a:cubicBezTo>
                  <a:pt x="36960" y="218406"/>
                  <a:pt x="40638" y="219547"/>
                  <a:pt x="43406" y="221854"/>
                </a:cubicBezTo>
                <a:cubicBezTo>
                  <a:pt x="46663" y="224568"/>
                  <a:pt x="49402" y="227850"/>
                  <a:pt x="52400" y="230848"/>
                </a:cubicBezTo>
                <a:cubicBezTo>
                  <a:pt x="53399" y="233846"/>
                  <a:pt x="53163" y="237607"/>
                  <a:pt x="55398" y="239842"/>
                </a:cubicBezTo>
                <a:cubicBezTo>
                  <a:pt x="57633" y="242077"/>
                  <a:pt x="61232" y="242840"/>
                  <a:pt x="64392" y="242840"/>
                </a:cubicBezTo>
                <a:cubicBezTo>
                  <a:pt x="73441" y="242840"/>
                  <a:pt x="82380" y="240841"/>
                  <a:pt x="91374" y="239842"/>
                </a:cubicBezTo>
                <a:cubicBezTo>
                  <a:pt x="94372" y="237843"/>
                  <a:pt x="97145" y="235457"/>
                  <a:pt x="100368" y="233846"/>
                </a:cubicBezTo>
                <a:cubicBezTo>
                  <a:pt x="103195" y="232433"/>
                  <a:pt x="106733" y="232601"/>
                  <a:pt x="109362" y="230848"/>
                </a:cubicBezTo>
                <a:cubicBezTo>
                  <a:pt x="112890" y="228496"/>
                  <a:pt x="115359" y="224852"/>
                  <a:pt x="118357" y="221854"/>
                </a:cubicBezTo>
                <a:cubicBezTo>
                  <a:pt x="119356" y="218856"/>
                  <a:pt x="119942" y="215687"/>
                  <a:pt x="121355" y="212860"/>
                </a:cubicBezTo>
                <a:cubicBezTo>
                  <a:pt x="122966" y="209637"/>
                  <a:pt x="126212" y="207284"/>
                  <a:pt x="127351" y="203866"/>
                </a:cubicBezTo>
                <a:cubicBezTo>
                  <a:pt x="128857" y="199348"/>
                  <a:pt x="130345" y="179890"/>
                  <a:pt x="133347" y="173886"/>
                </a:cubicBezTo>
                <a:cubicBezTo>
                  <a:pt x="134611" y="171358"/>
                  <a:pt x="137344" y="169888"/>
                  <a:pt x="139343" y="167889"/>
                </a:cubicBezTo>
                <a:cubicBezTo>
                  <a:pt x="140342" y="164891"/>
                  <a:pt x="142341" y="162055"/>
                  <a:pt x="142341" y="158895"/>
                </a:cubicBezTo>
                <a:cubicBezTo>
                  <a:pt x="142341" y="153902"/>
                  <a:pt x="137759" y="143093"/>
                  <a:pt x="136345" y="137909"/>
                </a:cubicBezTo>
                <a:cubicBezTo>
                  <a:pt x="126201" y="100716"/>
                  <a:pt x="134252" y="125633"/>
                  <a:pt x="127351" y="104931"/>
                </a:cubicBezTo>
                <a:cubicBezTo>
                  <a:pt x="129174" y="93996"/>
                  <a:pt x="126814" y="86665"/>
                  <a:pt x="136345" y="80946"/>
                </a:cubicBezTo>
                <a:cubicBezTo>
                  <a:pt x="139055" y="79320"/>
                  <a:pt x="142341" y="78947"/>
                  <a:pt x="145339" y="77948"/>
                </a:cubicBezTo>
                <a:lnTo>
                  <a:pt x="160329" y="92939"/>
                </a:lnTo>
                <a:cubicBezTo>
                  <a:pt x="163327" y="95937"/>
                  <a:pt x="166971" y="98405"/>
                  <a:pt x="169323" y="101933"/>
                </a:cubicBezTo>
                <a:cubicBezTo>
                  <a:pt x="171322" y="104931"/>
                  <a:pt x="172264" y="109017"/>
                  <a:pt x="175319" y="110927"/>
                </a:cubicBezTo>
                <a:cubicBezTo>
                  <a:pt x="180679" y="114277"/>
                  <a:pt x="193307" y="116923"/>
                  <a:pt x="193307" y="116923"/>
                </a:cubicBezTo>
                <a:cubicBezTo>
                  <a:pt x="197305" y="119921"/>
                  <a:pt x="200961" y="123438"/>
                  <a:pt x="205300" y="125917"/>
                </a:cubicBezTo>
                <a:cubicBezTo>
                  <a:pt x="212277" y="129904"/>
                  <a:pt x="230665" y="131254"/>
                  <a:pt x="235280" y="131913"/>
                </a:cubicBezTo>
                <a:cubicBezTo>
                  <a:pt x="238278" y="132912"/>
                  <a:pt x="241235" y="134043"/>
                  <a:pt x="244274" y="134911"/>
                </a:cubicBezTo>
                <a:cubicBezTo>
                  <a:pt x="270625" y="142440"/>
                  <a:pt x="243695" y="133719"/>
                  <a:pt x="265260" y="140907"/>
                </a:cubicBezTo>
                <a:cubicBezTo>
                  <a:pt x="275254" y="138908"/>
                  <a:pt x="289440" y="143290"/>
                  <a:pt x="295241" y="134911"/>
                </a:cubicBezTo>
                <a:cubicBezTo>
                  <a:pt x="314945" y="106449"/>
                  <a:pt x="296132" y="103230"/>
                  <a:pt x="283248" y="98935"/>
                </a:cubicBezTo>
                <a:cubicBezTo>
                  <a:pt x="269317" y="102418"/>
                  <a:pt x="275753" y="97936"/>
                  <a:pt x="271256" y="95937"/>
                </a:cubicBezTo>
                <a:close/>
              </a:path>
            </a:pathLst>
          </a:custGeom>
          <a:noFill/>
          <a:ln>
            <a:solidFill>
              <a:schemeClr val="accent4">
                <a:lumMod val="60000"/>
                <a:lumOff val="40000"/>
              </a:schemeClr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32" name="Freeform 31"/>
          <p:cNvSpPr/>
          <p:nvPr/>
        </p:nvSpPr>
        <p:spPr>
          <a:xfrm>
            <a:off x="4586951" y="3338788"/>
            <a:ext cx="504048" cy="554636"/>
          </a:xfrm>
          <a:custGeom>
            <a:avLst/>
            <a:gdLst>
              <a:gd name="connsiteX0" fmla="*/ 314794 w 504048"/>
              <a:gd name="connsiteY0" fmla="*/ 320789 h 554636"/>
              <a:gd name="connsiteX1" fmla="*/ 311796 w 504048"/>
              <a:gd name="connsiteY1" fmla="*/ 335779 h 554636"/>
              <a:gd name="connsiteX2" fmla="*/ 308798 w 504048"/>
              <a:gd name="connsiteY2" fmla="*/ 347771 h 554636"/>
              <a:gd name="connsiteX3" fmla="*/ 299804 w 504048"/>
              <a:gd name="connsiteY3" fmla="*/ 392742 h 554636"/>
              <a:gd name="connsiteX4" fmla="*/ 296806 w 504048"/>
              <a:gd name="connsiteY4" fmla="*/ 401736 h 554636"/>
              <a:gd name="connsiteX5" fmla="*/ 284813 w 504048"/>
              <a:gd name="connsiteY5" fmla="*/ 419724 h 554636"/>
              <a:gd name="connsiteX6" fmla="*/ 278817 w 504048"/>
              <a:gd name="connsiteY6" fmla="*/ 428718 h 554636"/>
              <a:gd name="connsiteX7" fmla="*/ 275819 w 504048"/>
              <a:gd name="connsiteY7" fmla="*/ 437712 h 554636"/>
              <a:gd name="connsiteX8" fmla="*/ 272821 w 504048"/>
              <a:gd name="connsiteY8" fmla="*/ 455701 h 554636"/>
              <a:gd name="connsiteX9" fmla="*/ 269823 w 504048"/>
              <a:gd name="connsiteY9" fmla="*/ 476687 h 554636"/>
              <a:gd name="connsiteX10" fmla="*/ 266825 w 504048"/>
              <a:gd name="connsiteY10" fmla="*/ 485681 h 554636"/>
              <a:gd name="connsiteX11" fmla="*/ 269823 w 504048"/>
              <a:gd name="connsiteY11" fmla="*/ 506667 h 554636"/>
              <a:gd name="connsiteX12" fmla="*/ 269823 w 504048"/>
              <a:gd name="connsiteY12" fmla="*/ 551638 h 554636"/>
              <a:gd name="connsiteX13" fmla="*/ 257831 w 504048"/>
              <a:gd name="connsiteY13" fmla="*/ 554636 h 554636"/>
              <a:gd name="connsiteX14" fmla="*/ 224853 w 504048"/>
              <a:gd name="connsiteY14" fmla="*/ 551638 h 554636"/>
              <a:gd name="connsiteX15" fmla="*/ 206865 w 504048"/>
              <a:gd name="connsiteY15" fmla="*/ 545642 h 554636"/>
              <a:gd name="connsiteX16" fmla="*/ 197870 w 504048"/>
              <a:gd name="connsiteY16" fmla="*/ 542644 h 554636"/>
              <a:gd name="connsiteX17" fmla="*/ 173886 w 504048"/>
              <a:gd name="connsiteY17" fmla="*/ 521657 h 554636"/>
              <a:gd name="connsiteX18" fmla="*/ 155898 w 504048"/>
              <a:gd name="connsiteY18" fmla="*/ 515661 h 554636"/>
              <a:gd name="connsiteX19" fmla="*/ 137910 w 504048"/>
              <a:gd name="connsiteY19" fmla="*/ 503669 h 554636"/>
              <a:gd name="connsiteX20" fmla="*/ 95937 w 504048"/>
              <a:gd name="connsiteY20" fmla="*/ 500671 h 554636"/>
              <a:gd name="connsiteX21" fmla="*/ 86943 w 504048"/>
              <a:gd name="connsiteY21" fmla="*/ 488679 h 554636"/>
              <a:gd name="connsiteX22" fmla="*/ 80947 w 504048"/>
              <a:gd name="connsiteY22" fmla="*/ 479685 h 554636"/>
              <a:gd name="connsiteX23" fmla="*/ 62959 w 504048"/>
              <a:gd name="connsiteY23" fmla="*/ 467693 h 554636"/>
              <a:gd name="connsiteX24" fmla="*/ 50967 w 504048"/>
              <a:gd name="connsiteY24" fmla="*/ 470691 h 554636"/>
              <a:gd name="connsiteX25" fmla="*/ 38975 w 504048"/>
              <a:gd name="connsiteY25" fmla="*/ 518659 h 554636"/>
              <a:gd name="connsiteX26" fmla="*/ 29981 w 504048"/>
              <a:gd name="connsiteY26" fmla="*/ 509665 h 554636"/>
              <a:gd name="connsiteX27" fmla="*/ 23985 w 504048"/>
              <a:gd name="connsiteY27" fmla="*/ 476687 h 554636"/>
              <a:gd name="connsiteX28" fmla="*/ 17989 w 504048"/>
              <a:gd name="connsiteY28" fmla="*/ 467693 h 554636"/>
              <a:gd name="connsiteX29" fmla="*/ 11992 w 504048"/>
              <a:gd name="connsiteY29" fmla="*/ 443708 h 554636"/>
              <a:gd name="connsiteX30" fmla="*/ 5996 w 504048"/>
              <a:gd name="connsiteY30" fmla="*/ 398738 h 554636"/>
              <a:gd name="connsiteX31" fmla="*/ 0 w 504048"/>
              <a:gd name="connsiteY31" fmla="*/ 389744 h 554636"/>
              <a:gd name="connsiteX32" fmla="*/ 5996 w 504048"/>
              <a:gd name="connsiteY32" fmla="*/ 326785 h 554636"/>
              <a:gd name="connsiteX33" fmla="*/ 8994 w 504048"/>
              <a:gd name="connsiteY33" fmla="*/ 308797 h 554636"/>
              <a:gd name="connsiteX34" fmla="*/ 17989 w 504048"/>
              <a:gd name="connsiteY34" fmla="*/ 287811 h 554636"/>
              <a:gd name="connsiteX35" fmla="*/ 26983 w 504048"/>
              <a:gd name="connsiteY35" fmla="*/ 269823 h 554636"/>
              <a:gd name="connsiteX36" fmla="*/ 35977 w 504048"/>
              <a:gd name="connsiteY36" fmla="*/ 242840 h 554636"/>
              <a:gd name="connsiteX37" fmla="*/ 38975 w 504048"/>
              <a:gd name="connsiteY37" fmla="*/ 233846 h 554636"/>
              <a:gd name="connsiteX38" fmla="*/ 44971 w 504048"/>
              <a:gd name="connsiteY38" fmla="*/ 218856 h 554636"/>
              <a:gd name="connsiteX39" fmla="*/ 53965 w 504048"/>
              <a:gd name="connsiteY39" fmla="*/ 197870 h 554636"/>
              <a:gd name="connsiteX40" fmla="*/ 74951 w 504048"/>
              <a:gd name="connsiteY40" fmla="*/ 170887 h 554636"/>
              <a:gd name="connsiteX41" fmla="*/ 89941 w 504048"/>
              <a:gd name="connsiteY41" fmla="*/ 143905 h 554636"/>
              <a:gd name="connsiteX42" fmla="*/ 101933 w 504048"/>
              <a:gd name="connsiteY42" fmla="*/ 116923 h 554636"/>
              <a:gd name="connsiteX43" fmla="*/ 107929 w 504048"/>
              <a:gd name="connsiteY43" fmla="*/ 104931 h 554636"/>
              <a:gd name="connsiteX44" fmla="*/ 116924 w 504048"/>
              <a:gd name="connsiteY44" fmla="*/ 101933 h 554636"/>
              <a:gd name="connsiteX45" fmla="*/ 128916 w 504048"/>
              <a:gd name="connsiteY45" fmla="*/ 83945 h 554636"/>
              <a:gd name="connsiteX46" fmla="*/ 134912 w 504048"/>
              <a:gd name="connsiteY46" fmla="*/ 77948 h 554636"/>
              <a:gd name="connsiteX47" fmla="*/ 146904 w 504048"/>
              <a:gd name="connsiteY47" fmla="*/ 74950 h 554636"/>
              <a:gd name="connsiteX48" fmla="*/ 173886 w 504048"/>
              <a:gd name="connsiteY48" fmla="*/ 53964 h 554636"/>
              <a:gd name="connsiteX49" fmla="*/ 182880 w 504048"/>
              <a:gd name="connsiteY49" fmla="*/ 50966 h 554636"/>
              <a:gd name="connsiteX50" fmla="*/ 188876 w 504048"/>
              <a:gd name="connsiteY50" fmla="*/ 41972 h 554636"/>
              <a:gd name="connsiteX51" fmla="*/ 206865 w 504048"/>
              <a:gd name="connsiteY51" fmla="*/ 32978 h 554636"/>
              <a:gd name="connsiteX52" fmla="*/ 218857 w 504048"/>
              <a:gd name="connsiteY52" fmla="*/ 26982 h 554636"/>
              <a:gd name="connsiteX53" fmla="*/ 230849 w 504048"/>
              <a:gd name="connsiteY53" fmla="*/ 17988 h 554636"/>
              <a:gd name="connsiteX54" fmla="*/ 260829 w 504048"/>
              <a:gd name="connsiteY54" fmla="*/ 8994 h 554636"/>
              <a:gd name="connsiteX55" fmla="*/ 284813 w 504048"/>
              <a:gd name="connsiteY55" fmla="*/ 0 h 554636"/>
              <a:gd name="connsiteX56" fmla="*/ 311796 w 504048"/>
              <a:gd name="connsiteY56" fmla="*/ 5996 h 554636"/>
              <a:gd name="connsiteX57" fmla="*/ 332782 w 504048"/>
              <a:gd name="connsiteY57" fmla="*/ 32978 h 554636"/>
              <a:gd name="connsiteX58" fmla="*/ 335780 w 504048"/>
              <a:gd name="connsiteY58" fmla="*/ 41972 h 554636"/>
              <a:gd name="connsiteX59" fmla="*/ 347772 w 504048"/>
              <a:gd name="connsiteY59" fmla="*/ 59960 h 554636"/>
              <a:gd name="connsiteX60" fmla="*/ 341776 w 504048"/>
              <a:gd name="connsiteY60" fmla="*/ 92939 h 554636"/>
              <a:gd name="connsiteX61" fmla="*/ 338778 w 504048"/>
              <a:gd name="connsiteY61" fmla="*/ 101933 h 554636"/>
              <a:gd name="connsiteX62" fmla="*/ 356766 w 504048"/>
              <a:gd name="connsiteY62" fmla="*/ 104931 h 554636"/>
              <a:gd name="connsiteX63" fmla="*/ 434715 w 504048"/>
              <a:gd name="connsiteY63" fmla="*/ 104931 h 554636"/>
              <a:gd name="connsiteX64" fmla="*/ 461697 w 504048"/>
              <a:gd name="connsiteY64" fmla="*/ 125917 h 554636"/>
              <a:gd name="connsiteX65" fmla="*/ 479686 w 504048"/>
              <a:gd name="connsiteY65" fmla="*/ 140907 h 554636"/>
              <a:gd name="connsiteX66" fmla="*/ 470691 w 504048"/>
              <a:gd name="connsiteY66" fmla="*/ 164891 h 554636"/>
              <a:gd name="connsiteX67" fmla="*/ 452703 w 504048"/>
              <a:gd name="connsiteY67" fmla="*/ 170887 h 554636"/>
              <a:gd name="connsiteX68" fmla="*/ 377752 w 504048"/>
              <a:gd name="connsiteY68" fmla="*/ 167889 h 554636"/>
              <a:gd name="connsiteX69" fmla="*/ 368758 w 504048"/>
              <a:gd name="connsiteY69" fmla="*/ 161893 h 554636"/>
              <a:gd name="connsiteX70" fmla="*/ 335780 w 504048"/>
              <a:gd name="connsiteY70" fmla="*/ 164891 h 554636"/>
              <a:gd name="connsiteX71" fmla="*/ 326786 w 504048"/>
              <a:gd name="connsiteY71" fmla="*/ 167889 h 554636"/>
              <a:gd name="connsiteX72" fmla="*/ 311796 w 504048"/>
              <a:gd name="connsiteY72" fmla="*/ 170887 h 554636"/>
              <a:gd name="connsiteX73" fmla="*/ 299804 w 504048"/>
              <a:gd name="connsiteY73" fmla="*/ 173886 h 554636"/>
              <a:gd name="connsiteX74" fmla="*/ 293808 w 504048"/>
              <a:gd name="connsiteY74" fmla="*/ 182880 h 554636"/>
              <a:gd name="connsiteX75" fmla="*/ 287811 w 504048"/>
              <a:gd name="connsiteY75" fmla="*/ 188876 h 554636"/>
              <a:gd name="connsiteX76" fmla="*/ 281815 w 504048"/>
              <a:gd name="connsiteY76" fmla="*/ 209862 h 554636"/>
              <a:gd name="connsiteX77" fmla="*/ 275819 w 504048"/>
              <a:gd name="connsiteY77" fmla="*/ 230848 h 554636"/>
              <a:gd name="connsiteX78" fmla="*/ 287811 w 504048"/>
              <a:gd name="connsiteY78" fmla="*/ 254832 h 554636"/>
              <a:gd name="connsiteX79" fmla="*/ 305800 w 504048"/>
              <a:gd name="connsiteY79" fmla="*/ 251834 h 554636"/>
              <a:gd name="connsiteX80" fmla="*/ 314794 w 504048"/>
              <a:gd name="connsiteY80" fmla="*/ 248836 h 554636"/>
              <a:gd name="connsiteX81" fmla="*/ 332782 w 504048"/>
              <a:gd name="connsiteY81" fmla="*/ 236844 h 554636"/>
              <a:gd name="connsiteX82" fmla="*/ 383749 w 504048"/>
              <a:gd name="connsiteY82" fmla="*/ 239842 h 554636"/>
              <a:gd name="connsiteX83" fmla="*/ 401737 w 504048"/>
              <a:gd name="connsiteY83" fmla="*/ 251834 h 554636"/>
              <a:gd name="connsiteX84" fmla="*/ 410731 w 504048"/>
              <a:gd name="connsiteY84" fmla="*/ 254832 h 554636"/>
              <a:gd name="connsiteX85" fmla="*/ 428719 w 504048"/>
              <a:gd name="connsiteY85" fmla="*/ 248836 h 554636"/>
              <a:gd name="connsiteX86" fmla="*/ 446707 w 504048"/>
              <a:gd name="connsiteY86" fmla="*/ 236844 h 554636"/>
              <a:gd name="connsiteX87" fmla="*/ 452703 w 504048"/>
              <a:gd name="connsiteY87" fmla="*/ 227850 h 554636"/>
              <a:gd name="connsiteX88" fmla="*/ 473689 w 504048"/>
              <a:gd name="connsiteY88" fmla="*/ 230848 h 554636"/>
              <a:gd name="connsiteX89" fmla="*/ 497674 w 504048"/>
              <a:gd name="connsiteY89" fmla="*/ 239842 h 554636"/>
              <a:gd name="connsiteX90" fmla="*/ 500672 w 504048"/>
              <a:gd name="connsiteY90" fmla="*/ 263827 h 554636"/>
              <a:gd name="connsiteX91" fmla="*/ 491678 w 504048"/>
              <a:gd name="connsiteY91" fmla="*/ 269823 h 554636"/>
              <a:gd name="connsiteX92" fmla="*/ 473689 w 504048"/>
              <a:gd name="connsiteY92" fmla="*/ 275819 h 554636"/>
              <a:gd name="connsiteX93" fmla="*/ 464695 w 504048"/>
              <a:gd name="connsiteY93" fmla="*/ 284813 h 554636"/>
              <a:gd name="connsiteX94" fmla="*/ 455701 w 504048"/>
              <a:gd name="connsiteY94" fmla="*/ 287811 h 554636"/>
              <a:gd name="connsiteX95" fmla="*/ 449705 w 504048"/>
              <a:gd name="connsiteY95" fmla="*/ 296805 h 554636"/>
              <a:gd name="connsiteX96" fmla="*/ 428719 w 504048"/>
              <a:gd name="connsiteY96" fmla="*/ 305799 h 554636"/>
              <a:gd name="connsiteX97" fmla="*/ 416727 w 504048"/>
              <a:gd name="connsiteY97" fmla="*/ 299803 h 554636"/>
              <a:gd name="connsiteX98" fmla="*/ 395741 w 504048"/>
              <a:gd name="connsiteY98" fmla="*/ 293807 h 554636"/>
              <a:gd name="connsiteX99" fmla="*/ 350770 w 504048"/>
              <a:gd name="connsiteY99" fmla="*/ 302801 h 554636"/>
              <a:gd name="connsiteX100" fmla="*/ 314794 w 504048"/>
              <a:gd name="connsiteY100" fmla="*/ 320789 h 55463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  <a:cxn ang="0">
                <a:pos x="connsiteX75" y="connsiteY75"/>
              </a:cxn>
              <a:cxn ang="0">
                <a:pos x="connsiteX76" y="connsiteY76"/>
              </a:cxn>
              <a:cxn ang="0">
                <a:pos x="connsiteX77" y="connsiteY77"/>
              </a:cxn>
              <a:cxn ang="0">
                <a:pos x="connsiteX78" y="connsiteY78"/>
              </a:cxn>
              <a:cxn ang="0">
                <a:pos x="connsiteX79" y="connsiteY79"/>
              </a:cxn>
              <a:cxn ang="0">
                <a:pos x="connsiteX80" y="connsiteY80"/>
              </a:cxn>
              <a:cxn ang="0">
                <a:pos x="connsiteX81" y="connsiteY81"/>
              </a:cxn>
              <a:cxn ang="0">
                <a:pos x="connsiteX82" y="connsiteY82"/>
              </a:cxn>
              <a:cxn ang="0">
                <a:pos x="connsiteX83" y="connsiteY83"/>
              </a:cxn>
              <a:cxn ang="0">
                <a:pos x="connsiteX84" y="connsiteY84"/>
              </a:cxn>
              <a:cxn ang="0">
                <a:pos x="connsiteX85" y="connsiteY85"/>
              </a:cxn>
              <a:cxn ang="0">
                <a:pos x="connsiteX86" y="connsiteY86"/>
              </a:cxn>
              <a:cxn ang="0">
                <a:pos x="connsiteX87" y="connsiteY87"/>
              </a:cxn>
              <a:cxn ang="0">
                <a:pos x="connsiteX88" y="connsiteY88"/>
              </a:cxn>
              <a:cxn ang="0">
                <a:pos x="connsiteX89" y="connsiteY89"/>
              </a:cxn>
              <a:cxn ang="0">
                <a:pos x="connsiteX90" y="connsiteY90"/>
              </a:cxn>
              <a:cxn ang="0">
                <a:pos x="connsiteX91" y="connsiteY91"/>
              </a:cxn>
              <a:cxn ang="0">
                <a:pos x="connsiteX92" y="connsiteY92"/>
              </a:cxn>
              <a:cxn ang="0">
                <a:pos x="connsiteX93" y="connsiteY93"/>
              </a:cxn>
              <a:cxn ang="0">
                <a:pos x="connsiteX94" y="connsiteY94"/>
              </a:cxn>
              <a:cxn ang="0">
                <a:pos x="connsiteX95" y="connsiteY95"/>
              </a:cxn>
              <a:cxn ang="0">
                <a:pos x="connsiteX96" y="connsiteY96"/>
              </a:cxn>
              <a:cxn ang="0">
                <a:pos x="connsiteX97" y="connsiteY97"/>
              </a:cxn>
              <a:cxn ang="0">
                <a:pos x="connsiteX98" y="connsiteY98"/>
              </a:cxn>
              <a:cxn ang="0">
                <a:pos x="connsiteX99" y="connsiteY99"/>
              </a:cxn>
              <a:cxn ang="0">
                <a:pos x="connsiteX100" y="connsiteY100"/>
              </a:cxn>
            </a:cxnLst>
            <a:rect l="l" t="t" r="r" b="b"/>
            <a:pathLst>
              <a:path w="504048" h="554636">
                <a:moveTo>
                  <a:pt x="314794" y="320789"/>
                </a:moveTo>
                <a:cubicBezTo>
                  <a:pt x="308298" y="326285"/>
                  <a:pt x="312901" y="330805"/>
                  <a:pt x="311796" y="335779"/>
                </a:cubicBezTo>
                <a:cubicBezTo>
                  <a:pt x="310902" y="339801"/>
                  <a:pt x="309425" y="343699"/>
                  <a:pt x="308798" y="347771"/>
                </a:cubicBezTo>
                <a:cubicBezTo>
                  <a:pt x="302462" y="388956"/>
                  <a:pt x="310506" y="360637"/>
                  <a:pt x="299804" y="392742"/>
                </a:cubicBezTo>
                <a:cubicBezTo>
                  <a:pt x="298805" y="395740"/>
                  <a:pt x="298559" y="399107"/>
                  <a:pt x="296806" y="401736"/>
                </a:cubicBezTo>
                <a:lnTo>
                  <a:pt x="284813" y="419724"/>
                </a:lnTo>
                <a:cubicBezTo>
                  <a:pt x="282814" y="422722"/>
                  <a:pt x="279956" y="425300"/>
                  <a:pt x="278817" y="428718"/>
                </a:cubicBezTo>
                <a:lnTo>
                  <a:pt x="275819" y="437712"/>
                </a:lnTo>
                <a:cubicBezTo>
                  <a:pt x="274820" y="443708"/>
                  <a:pt x="273745" y="449693"/>
                  <a:pt x="272821" y="455701"/>
                </a:cubicBezTo>
                <a:cubicBezTo>
                  <a:pt x="271747" y="462685"/>
                  <a:pt x="271209" y="469758"/>
                  <a:pt x="269823" y="476687"/>
                </a:cubicBezTo>
                <a:cubicBezTo>
                  <a:pt x="269203" y="479786"/>
                  <a:pt x="267824" y="482683"/>
                  <a:pt x="266825" y="485681"/>
                </a:cubicBezTo>
                <a:cubicBezTo>
                  <a:pt x="267824" y="492676"/>
                  <a:pt x="268559" y="499715"/>
                  <a:pt x="269823" y="506667"/>
                </a:cubicBezTo>
                <a:cubicBezTo>
                  <a:pt x="273051" y="524420"/>
                  <a:pt x="279751" y="527811"/>
                  <a:pt x="269823" y="551638"/>
                </a:cubicBezTo>
                <a:cubicBezTo>
                  <a:pt x="268238" y="555441"/>
                  <a:pt x="261828" y="553637"/>
                  <a:pt x="257831" y="554636"/>
                </a:cubicBezTo>
                <a:cubicBezTo>
                  <a:pt x="246838" y="553637"/>
                  <a:pt x="235723" y="553556"/>
                  <a:pt x="224853" y="551638"/>
                </a:cubicBezTo>
                <a:cubicBezTo>
                  <a:pt x="218629" y="550540"/>
                  <a:pt x="212861" y="547641"/>
                  <a:pt x="206865" y="545642"/>
                </a:cubicBezTo>
                <a:lnTo>
                  <a:pt x="197870" y="542644"/>
                </a:lnTo>
                <a:cubicBezTo>
                  <a:pt x="190875" y="532150"/>
                  <a:pt x="188877" y="526654"/>
                  <a:pt x="173886" y="521657"/>
                </a:cubicBezTo>
                <a:cubicBezTo>
                  <a:pt x="167890" y="519658"/>
                  <a:pt x="161157" y="519167"/>
                  <a:pt x="155898" y="515661"/>
                </a:cubicBezTo>
                <a:cubicBezTo>
                  <a:pt x="149902" y="511664"/>
                  <a:pt x="145098" y="504182"/>
                  <a:pt x="137910" y="503669"/>
                </a:cubicBezTo>
                <a:lnTo>
                  <a:pt x="95937" y="500671"/>
                </a:lnTo>
                <a:cubicBezTo>
                  <a:pt x="92939" y="496674"/>
                  <a:pt x="89847" y="492745"/>
                  <a:pt x="86943" y="488679"/>
                </a:cubicBezTo>
                <a:cubicBezTo>
                  <a:pt x="84849" y="485747"/>
                  <a:pt x="83659" y="482058"/>
                  <a:pt x="80947" y="479685"/>
                </a:cubicBezTo>
                <a:cubicBezTo>
                  <a:pt x="75524" y="474940"/>
                  <a:pt x="62959" y="467693"/>
                  <a:pt x="62959" y="467693"/>
                </a:cubicBezTo>
                <a:cubicBezTo>
                  <a:pt x="58962" y="468692"/>
                  <a:pt x="52196" y="466758"/>
                  <a:pt x="50967" y="470691"/>
                </a:cubicBezTo>
                <a:cubicBezTo>
                  <a:pt x="34553" y="523216"/>
                  <a:pt x="64999" y="509984"/>
                  <a:pt x="38975" y="518659"/>
                </a:cubicBezTo>
                <a:cubicBezTo>
                  <a:pt x="35977" y="515661"/>
                  <a:pt x="31556" y="513602"/>
                  <a:pt x="29981" y="509665"/>
                </a:cubicBezTo>
                <a:cubicBezTo>
                  <a:pt x="10529" y="461034"/>
                  <a:pt x="37952" y="509276"/>
                  <a:pt x="23985" y="476687"/>
                </a:cubicBezTo>
                <a:cubicBezTo>
                  <a:pt x="22566" y="473375"/>
                  <a:pt x="19601" y="470916"/>
                  <a:pt x="17989" y="467693"/>
                </a:cubicBezTo>
                <a:cubicBezTo>
                  <a:pt x="15235" y="462186"/>
                  <a:pt x="12615" y="448379"/>
                  <a:pt x="11992" y="443708"/>
                </a:cubicBezTo>
                <a:cubicBezTo>
                  <a:pt x="11401" y="439273"/>
                  <a:pt x="9485" y="408043"/>
                  <a:pt x="5996" y="398738"/>
                </a:cubicBezTo>
                <a:cubicBezTo>
                  <a:pt x="4731" y="395364"/>
                  <a:pt x="1999" y="392742"/>
                  <a:pt x="0" y="389744"/>
                </a:cubicBezTo>
                <a:cubicBezTo>
                  <a:pt x="2842" y="349952"/>
                  <a:pt x="1346" y="357007"/>
                  <a:pt x="5996" y="326785"/>
                </a:cubicBezTo>
                <a:cubicBezTo>
                  <a:pt x="6920" y="320777"/>
                  <a:pt x="7675" y="314731"/>
                  <a:pt x="8994" y="308797"/>
                </a:cubicBezTo>
                <a:cubicBezTo>
                  <a:pt x="11158" y="299059"/>
                  <a:pt x="13757" y="297685"/>
                  <a:pt x="17989" y="287811"/>
                </a:cubicBezTo>
                <a:cubicBezTo>
                  <a:pt x="25439" y="270430"/>
                  <a:pt x="15458" y="287111"/>
                  <a:pt x="26983" y="269823"/>
                </a:cubicBezTo>
                <a:lnTo>
                  <a:pt x="35977" y="242840"/>
                </a:lnTo>
                <a:cubicBezTo>
                  <a:pt x="36976" y="239842"/>
                  <a:pt x="37801" y="236780"/>
                  <a:pt x="38975" y="233846"/>
                </a:cubicBezTo>
                <a:cubicBezTo>
                  <a:pt x="40974" y="228849"/>
                  <a:pt x="43081" y="223895"/>
                  <a:pt x="44971" y="218856"/>
                </a:cubicBezTo>
                <a:cubicBezTo>
                  <a:pt x="48061" y="210615"/>
                  <a:pt x="48424" y="205628"/>
                  <a:pt x="53965" y="197870"/>
                </a:cubicBezTo>
                <a:cubicBezTo>
                  <a:pt x="65507" y="181711"/>
                  <a:pt x="64937" y="195921"/>
                  <a:pt x="74951" y="170887"/>
                </a:cubicBezTo>
                <a:cubicBezTo>
                  <a:pt x="82803" y="151258"/>
                  <a:pt x="77718" y="160202"/>
                  <a:pt x="89941" y="143905"/>
                </a:cubicBezTo>
                <a:cubicBezTo>
                  <a:pt x="94829" y="124355"/>
                  <a:pt x="90146" y="138140"/>
                  <a:pt x="101933" y="116923"/>
                </a:cubicBezTo>
                <a:cubicBezTo>
                  <a:pt x="104103" y="113016"/>
                  <a:pt x="104769" y="108091"/>
                  <a:pt x="107929" y="104931"/>
                </a:cubicBezTo>
                <a:cubicBezTo>
                  <a:pt x="110164" y="102696"/>
                  <a:pt x="113926" y="102932"/>
                  <a:pt x="116924" y="101933"/>
                </a:cubicBezTo>
                <a:cubicBezTo>
                  <a:pt x="120921" y="95937"/>
                  <a:pt x="123821" y="89041"/>
                  <a:pt x="128916" y="83945"/>
                </a:cubicBezTo>
                <a:cubicBezTo>
                  <a:pt x="130915" y="81946"/>
                  <a:pt x="132384" y="79212"/>
                  <a:pt x="134912" y="77948"/>
                </a:cubicBezTo>
                <a:cubicBezTo>
                  <a:pt x="138597" y="76105"/>
                  <a:pt x="142907" y="75949"/>
                  <a:pt x="146904" y="74950"/>
                </a:cubicBezTo>
                <a:cubicBezTo>
                  <a:pt x="154664" y="67190"/>
                  <a:pt x="163128" y="57550"/>
                  <a:pt x="173886" y="53964"/>
                </a:cubicBezTo>
                <a:lnTo>
                  <a:pt x="182880" y="50966"/>
                </a:lnTo>
                <a:cubicBezTo>
                  <a:pt x="184879" y="47968"/>
                  <a:pt x="186328" y="44520"/>
                  <a:pt x="188876" y="41972"/>
                </a:cubicBezTo>
                <a:cubicBezTo>
                  <a:pt x="196078" y="34770"/>
                  <a:pt x="198330" y="36636"/>
                  <a:pt x="206865" y="32978"/>
                </a:cubicBezTo>
                <a:cubicBezTo>
                  <a:pt x="210973" y="31218"/>
                  <a:pt x="215067" y="29351"/>
                  <a:pt x="218857" y="26982"/>
                </a:cubicBezTo>
                <a:cubicBezTo>
                  <a:pt x="223094" y="24334"/>
                  <a:pt x="226380" y="20223"/>
                  <a:pt x="230849" y="17988"/>
                </a:cubicBezTo>
                <a:cubicBezTo>
                  <a:pt x="251350" y="7737"/>
                  <a:pt x="243615" y="15449"/>
                  <a:pt x="260829" y="8994"/>
                </a:cubicBezTo>
                <a:cubicBezTo>
                  <a:pt x="292184" y="-2764"/>
                  <a:pt x="254031" y="7695"/>
                  <a:pt x="284813" y="0"/>
                </a:cubicBezTo>
                <a:cubicBezTo>
                  <a:pt x="286990" y="363"/>
                  <a:pt x="306875" y="2716"/>
                  <a:pt x="311796" y="5996"/>
                </a:cubicBezTo>
                <a:cubicBezTo>
                  <a:pt x="318448" y="10430"/>
                  <a:pt x="331080" y="27873"/>
                  <a:pt x="332782" y="32978"/>
                </a:cubicBezTo>
                <a:cubicBezTo>
                  <a:pt x="333781" y="35976"/>
                  <a:pt x="334245" y="39210"/>
                  <a:pt x="335780" y="41972"/>
                </a:cubicBezTo>
                <a:cubicBezTo>
                  <a:pt x="339280" y="48271"/>
                  <a:pt x="347772" y="59960"/>
                  <a:pt x="347772" y="59960"/>
                </a:cubicBezTo>
                <a:cubicBezTo>
                  <a:pt x="345773" y="70953"/>
                  <a:pt x="344117" y="82014"/>
                  <a:pt x="341776" y="92939"/>
                </a:cubicBezTo>
                <a:cubicBezTo>
                  <a:pt x="341114" y="96029"/>
                  <a:pt x="336310" y="99959"/>
                  <a:pt x="338778" y="101933"/>
                </a:cubicBezTo>
                <a:cubicBezTo>
                  <a:pt x="343525" y="105730"/>
                  <a:pt x="350770" y="103932"/>
                  <a:pt x="356766" y="104931"/>
                </a:cubicBezTo>
                <a:cubicBezTo>
                  <a:pt x="384384" y="102169"/>
                  <a:pt x="405921" y="98387"/>
                  <a:pt x="434715" y="104931"/>
                </a:cubicBezTo>
                <a:cubicBezTo>
                  <a:pt x="447217" y="107772"/>
                  <a:pt x="452910" y="118595"/>
                  <a:pt x="461697" y="125917"/>
                </a:cubicBezTo>
                <a:cubicBezTo>
                  <a:pt x="486749" y="146794"/>
                  <a:pt x="453398" y="114622"/>
                  <a:pt x="479686" y="140907"/>
                </a:cubicBezTo>
                <a:cubicBezTo>
                  <a:pt x="478235" y="149611"/>
                  <a:pt x="480051" y="160211"/>
                  <a:pt x="470691" y="164891"/>
                </a:cubicBezTo>
                <a:cubicBezTo>
                  <a:pt x="465038" y="167717"/>
                  <a:pt x="452703" y="170887"/>
                  <a:pt x="452703" y="170887"/>
                </a:cubicBezTo>
                <a:cubicBezTo>
                  <a:pt x="427719" y="169888"/>
                  <a:pt x="402613" y="170553"/>
                  <a:pt x="377752" y="167889"/>
                </a:cubicBezTo>
                <a:cubicBezTo>
                  <a:pt x="374169" y="167505"/>
                  <a:pt x="372352" y="162150"/>
                  <a:pt x="368758" y="161893"/>
                </a:cubicBezTo>
                <a:cubicBezTo>
                  <a:pt x="357748" y="161107"/>
                  <a:pt x="346773" y="163892"/>
                  <a:pt x="335780" y="164891"/>
                </a:cubicBezTo>
                <a:cubicBezTo>
                  <a:pt x="332782" y="165890"/>
                  <a:pt x="329852" y="167123"/>
                  <a:pt x="326786" y="167889"/>
                </a:cubicBezTo>
                <a:cubicBezTo>
                  <a:pt x="321843" y="169125"/>
                  <a:pt x="316770" y="169781"/>
                  <a:pt x="311796" y="170887"/>
                </a:cubicBezTo>
                <a:cubicBezTo>
                  <a:pt x="307774" y="171781"/>
                  <a:pt x="303801" y="172886"/>
                  <a:pt x="299804" y="173886"/>
                </a:cubicBezTo>
                <a:cubicBezTo>
                  <a:pt x="297805" y="176884"/>
                  <a:pt x="296059" y="180067"/>
                  <a:pt x="293808" y="182880"/>
                </a:cubicBezTo>
                <a:cubicBezTo>
                  <a:pt x="292042" y="185087"/>
                  <a:pt x="289265" y="186452"/>
                  <a:pt x="287811" y="188876"/>
                </a:cubicBezTo>
                <a:cubicBezTo>
                  <a:pt x="285896" y="192067"/>
                  <a:pt x="282468" y="207467"/>
                  <a:pt x="281815" y="209862"/>
                </a:cubicBezTo>
                <a:cubicBezTo>
                  <a:pt x="279901" y="216881"/>
                  <a:pt x="277818" y="223853"/>
                  <a:pt x="275819" y="230848"/>
                </a:cubicBezTo>
                <a:cubicBezTo>
                  <a:pt x="277450" y="237373"/>
                  <a:pt x="279472" y="252052"/>
                  <a:pt x="287811" y="254832"/>
                </a:cubicBezTo>
                <a:cubicBezTo>
                  <a:pt x="293578" y="256754"/>
                  <a:pt x="299804" y="252833"/>
                  <a:pt x="305800" y="251834"/>
                </a:cubicBezTo>
                <a:cubicBezTo>
                  <a:pt x="308798" y="250835"/>
                  <a:pt x="312032" y="250371"/>
                  <a:pt x="314794" y="248836"/>
                </a:cubicBezTo>
                <a:cubicBezTo>
                  <a:pt x="321093" y="245336"/>
                  <a:pt x="332782" y="236844"/>
                  <a:pt x="332782" y="236844"/>
                </a:cubicBezTo>
                <a:cubicBezTo>
                  <a:pt x="349771" y="237843"/>
                  <a:pt x="367119" y="236227"/>
                  <a:pt x="383749" y="239842"/>
                </a:cubicBezTo>
                <a:cubicBezTo>
                  <a:pt x="390791" y="241373"/>
                  <a:pt x="394901" y="249555"/>
                  <a:pt x="401737" y="251834"/>
                </a:cubicBezTo>
                <a:lnTo>
                  <a:pt x="410731" y="254832"/>
                </a:lnTo>
                <a:cubicBezTo>
                  <a:pt x="416727" y="252833"/>
                  <a:pt x="423460" y="252342"/>
                  <a:pt x="428719" y="248836"/>
                </a:cubicBezTo>
                <a:lnTo>
                  <a:pt x="446707" y="236844"/>
                </a:lnTo>
                <a:cubicBezTo>
                  <a:pt x="448706" y="233846"/>
                  <a:pt x="449186" y="228632"/>
                  <a:pt x="452703" y="227850"/>
                </a:cubicBezTo>
                <a:cubicBezTo>
                  <a:pt x="459601" y="226317"/>
                  <a:pt x="466760" y="229462"/>
                  <a:pt x="473689" y="230848"/>
                </a:cubicBezTo>
                <a:cubicBezTo>
                  <a:pt x="478392" y="231788"/>
                  <a:pt x="495752" y="239073"/>
                  <a:pt x="497674" y="239842"/>
                </a:cubicBezTo>
                <a:cubicBezTo>
                  <a:pt x="502350" y="249195"/>
                  <a:pt x="507670" y="253330"/>
                  <a:pt x="500672" y="263827"/>
                </a:cubicBezTo>
                <a:cubicBezTo>
                  <a:pt x="498673" y="266825"/>
                  <a:pt x="494971" y="268360"/>
                  <a:pt x="491678" y="269823"/>
                </a:cubicBezTo>
                <a:cubicBezTo>
                  <a:pt x="485902" y="272390"/>
                  <a:pt x="473689" y="275819"/>
                  <a:pt x="473689" y="275819"/>
                </a:cubicBezTo>
                <a:cubicBezTo>
                  <a:pt x="470691" y="278817"/>
                  <a:pt x="468223" y="282461"/>
                  <a:pt x="464695" y="284813"/>
                </a:cubicBezTo>
                <a:cubicBezTo>
                  <a:pt x="462066" y="286566"/>
                  <a:pt x="458169" y="285837"/>
                  <a:pt x="455701" y="287811"/>
                </a:cubicBezTo>
                <a:cubicBezTo>
                  <a:pt x="452887" y="290062"/>
                  <a:pt x="452253" y="294257"/>
                  <a:pt x="449705" y="296805"/>
                </a:cubicBezTo>
                <a:cubicBezTo>
                  <a:pt x="442804" y="303706"/>
                  <a:pt x="437893" y="303505"/>
                  <a:pt x="428719" y="305799"/>
                </a:cubicBezTo>
                <a:cubicBezTo>
                  <a:pt x="424722" y="303800"/>
                  <a:pt x="420835" y="301563"/>
                  <a:pt x="416727" y="299803"/>
                </a:cubicBezTo>
                <a:cubicBezTo>
                  <a:pt x="410706" y="297222"/>
                  <a:pt x="401826" y="295328"/>
                  <a:pt x="395741" y="293807"/>
                </a:cubicBezTo>
                <a:cubicBezTo>
                  <a:pt x="367983" y="296120"/>
                  <a:pt x="366241" y="290424"/>
                  <a:pt x="350770" y="302801"/>
                </a:cubicBezTo>
                <a:cubicBezTo>
                  <a:pt x="348563" y="304567"/>
                  <a:pt x="321290" y="315293"/>
                  <a:pt x="314794" y="320789"/>
                </a:cubicBezTo>
                <a:close/>
              </a:path>
            </a:pathLst>
          </a:custGeom>
          <a:noFill/>
          <a:ln>
            <a:solidFill>
              <a:schemeClr val="accent4">
                <a:lumMod val="60000"/>
                <a:lumOff val="40000"/>
              </a:schemeClr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33" name="Freeform 32"/>
          <p:cNvSpPr/>
          <p:nvPr/>
        </p:nvSpPr>
        <p:spPr>
          <a:xfrm>
            <a:off x="4754558" y="4654893"/>
            <a:ext cx="87248" cy="203897"/>
          </a:xfrm>
          <a:custGeom>
            <a:avLst/>
            <a:gdLst>
              <a:gd name="connsiteX0" fmla="*/ 12275 w 87248"/>
              <a:gd name="connsiteY0" fmla="*/ 6027 h 203897"/>
              <a:gd name="connsiteX1" fmla="*/ 6279 w 87248"/>
              <a:gd name="connsiteY1" fmla="*/ 24015 h 203897"/>
              <a:gd name="connsiteX2" fmla="*/ 6279 w 87248"/>
              <a:gd name="connsiteY2" fmla="*/ 152931 h 203897"/>
              <a:gd name="connsiteX3" fmla="*/ 21269 w 87248"/>
              <a:gd name="connsiteY3" fmla="*/ 170919 h 203897"/>
              <a:gd name="connsiteX4" fmla="*/ 30263 w 87248"/>
              <a:gd name="connsiteY4" fmla="*/ 188907 h 203897"/>
              <a:gd name="connsiteX5" fmla="*/ 39258 w 87248"/>
              <a:gd name="connsiteY5" fmla="*/ 194903 h 203897"/>
              <a:gd name="connsiteX6" fmla="*/ 51250 w 87248"/>
              <a:gd name="connsiteY6" fmla="*/ 203897 h 203897"/>
              <a:gd name="connsiteX7" fmla="*/ 72236 w 87248"/>
              <a:gd name="connsiteY7" fmla="*/ 176915 h 203897"/>
              <a:gd name="connsiteX8" fmla="*/ 78232 w 87248"/>
              <a:gd name="connsiteY8" fmla="*/ 167921 h 203897"/>
              <a:gd name="connsiteX9" fmla="*/ 84228 w 87248"/>
              <a:gd name="connsiteY9" fmla="*/ 143937 h 203897"/>
              <a:gd name="connsiteX10" fmla="*/ 84228 w 87248"/>
              <a:gd name="connsiteY10" fmla="*/ 92970 h 203897"/>
              <a:gd name="connsiteX11" fmla="*/ 75234 w 87248"/>
              <a:gd name="connsiteY11" fmla="*/ 83976 h 203897"/>
              <a:gd name="connsiteX12" fmla="*/ 69238 w 87248"/>
              <a:gd name="connsiteY12" fmla="*/ 74982 h 203897"/>
              <a:gd name="connsiteX13" fmla="*/ 66240 w 87248"/>
              <a:gd name="connsiteY13" fmla="*/ 59992 h 203897"/>
              <a:gd name="connsiteX14" fmla="*/ 60244 w 87248"/>
              <a:gd name="connsiteY14" fmla="*/ 42003 h 203897"/>
              <a:gd name="connsiteX15" fmla="*/ 57246 w 87248"/>
              <a:gd name="connsiteY15" fmla="*/ 9025 h 203897"/>
              <a:gd name="connsiteX16" fmla="*/ 33262 w 87248"/>
              <a:gd name="connsiteY16" fmla="*/ 3029 h 203897"/>
              <a:gd name="connsiteX17" fmla="*/ 12275 w 87248"/>
              <a:gd name="connsiteY17" fmla="*/ 6027 h 20389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</a:cxnLst>
            <a:rect l="l" t="t" r="r" b="b"/>
            <a:pathLst>
              <a:path w="87248" h="203897">
                <a:moveTo>
                  <a:pt x="12275" y="6027"/>
                </a:moveTo>
                <a:cubicBezTo>
                  <a:pt x="7778" y="9525"/>
                  <a:pt x="8095" y="17961"/>
                  <a:pt x="6279" y="24015"/>
                </a:cubicBezTo>
                <a:cubicBezTo>
                  <a:pt x="-6181" y="65548"/>
                  <a:pt x="3231" y="110262"/>
                  <a:pt x="6279" y="152931"/>
                </a:cubicBezTo>
                <a:cubicBezTo>
                  <a:pt x="6600" y="157426"/>
                  <a:pt x="19172" y="168822"/>
                  <a:pt x="21269" y="170919"/>
                </a:cubicBezTo>
                <a:cubicBezTo>
                  <a:pt x="23707" y="178234"/>
                  <a:pt x="24451" y="183096"/>
                  <a:pt x="30263" y="188907"/>
                </a:cubicBezTo>
                <a:cubicBezTo>
                  <a:pt x="32811" y="191455"/>
                  <a:pt x="36326" y="192809"/>
                  <a:pt x="39258" y="194903"/>
                </a:cubicBezTo>
                <a:cubicBezTo>
                  <a:pt x="43324" y="197807"/>
                  <a:pt x="47253" y="200899"/>
                  <a:pt x="51250" y="203897"/>
                </a:cubicBezTo>
                <a:cubicBezTo>
                  <a:pt x="65340" y="189807"/>
                  <a:pt x="57892" y="198431"/>
                  <a:pt x="72236" y="176915"/>
                </a:cubicBezTo>
                <a:cubicBezTo>
                  <a:pt x="74235" y="173917"/>
                  <a:pt x="77093" y="171339"/>
                  <a:pt x="78232" y="167921"/>
                </a:cubicBezTo>
                <a:cubicBezTo>
                  <a:pt x="82841" y="154093"/>
                  <a:pt x="80610" y="162026"/>
                  <a:pt x="84228" y="143937"/>
                </a:cubicBezTo>
                <a:cubicBezTo>
                  <a:pt x="85668" y="129532"/>
                  <a:pt x="90237" y="107992"/>
                  <a:pt x="84228" y="92970"/>
                </a:cubicBezTo>
                <a:cubicBezTo>
                  <a:pt x="82653" y="89033"/>
                  <a:pt x="77948" y="87233"/>
                  <a:pt x="75234" y="83976"/>
                </a:cubicBezTo>
                <a:cubicBezTo>
                  <a:pt x="72927" y="81208"/>
                  <a:pt x="71237" y="77980"/>
                  <a:pt x="69238" y="74982"/>
                </a:cubicBezTo>
                <a:cubicBezTo>
                  <a:pt x="68239" y="69985"/>
                  <a:pt x="67581" y="64908"/>
                  <a:pt x="66240" y="59992"/>
                </a:cubicBezTo>
                <a:cubicBezTo>
                  <a:pt x="64577" y="53894"/>
                  <a:pt x="60244" y="42003"/>
                  <a:pt x="60244" y="42003"/>
                </a:cubicBezTo>
                <a:cubicBezTo>
                  <a:pt x="59245" y="31010"/>
                  <a:pt x="60958" y="19420"/>
                  <a:pt x="57246" y="9025"/>
                </a:cubicBezTo>
                <a:cubicBezTo>
                  <a:pt x="52351" y="-4681"/>
                  <a:pt x="41531" y="667"/>
                  <a:pt x="33262" y="3029"/>
                </a:cubicBezTo>
                <a:cubicBezTo>
                  <a:pt x="30223" y="3897"/>
                  <a:pt x="16772" y="2529"/>
                  <a:pt x="12275" y="6027"/>
                </a:cubicBezTo>
                <a:close/>
              </a:path>
            </a:pathLst>
          </a:custGeom>
          <a:noFill/>
          <a:ln>
            <a:solidFill>
              <a:schemeClr val="accent4">
                <a:lumMod val="60000"/>
                <a:lumOff val="40000"/>
              </a:schemeClr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3601487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/>
          <p:cNvGraphicFramePr>
            <a:graphicFrameLocks noChangeAspect="1"/>
          </p:cNvGraphicFramePr>
          <p:nvPr>
            <p:extLst/>
          </p:nvPr>
        </p:nvGraphicFramePr>
        <p:xfrm>
          <a:off x="180975" y="5665788"/>
          <a:ext cx="2308225" cy="18605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77" name="Prism 10" r:id="rId3" imgW="3077969" imgH="2479416" progId="Prism10.Document">
                  <p:embed/>
                </p:oleObj>
              </mc:Choice>
              <mc:Fallback>
                <p:oleObj name="Prism 10" r:id="rId3" imgW="3077969" imgH="2479416" progId="Prism10.Document">
                  <p:embed/>
                  <p:pic>
                    <p:nvPicPr>
                      <p:cNvPr id="2" name="Object 1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80975" y="5665788"/>
                        <a:ext cx="2308225" cy="18605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66337" y="171034"/>
            <a:ext cx="21621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upplementary Fig. 4</a:t>
            </a:r>
            <a:endParaRPr lang="en-US" dirty="0"/>
          </a:p>
        </p:txBody>
      </p:sp>
      <p:sp>
        <p:nvSpPr>
          <p:cNvPr id="4" name="TextBox 3"/>
          <p:cNvSpPr txBox="1"/>
          <p:nvPr/>
        </p:nvSpPr>
        <p:spPr>
          <a:xfrm>
            <a:off x="74963" y="2084320"/>
            <a:ext cx="27924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b</a:t>
            </a:r>
            <a:endParaRPr lang="en-US" sz="1400" dirty="0"/>
          </a:p>
        </p:txBody>
      </p:sp>
      <p:pic>
        <p:nvPicPr>
          <p:cNvPr id="9" name="Picture 8"/>
          <p:cNvPicPr>
            <a:picLocks noChangeAspect="1"/>
          </p:cNvPicPr>
          <p:nvPr/>
        </p:nvPicPr>
        <p:blipFill>
          <a:blip r:embed="rId5" cstate="hq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68006" y="3446194"/>
            <a:ext cx="914400" cy="914400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7" cstate="hqprint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493194" y="3446194"/>
            <a:ext cx="914400" cy="914400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>
          <a:blip r:embed="rId9" cstate="hqprint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529509" y="3448946"/>
            <a:ext cx="914400" cy="914400"/>
          </a:xfrm>
          <a:prstGeom prst="rect">
            <a:avLst/>
          </a:prstGeom>
        </p:spPr>
      </p:pic>
      <p:pic>
        <p:nvPicPr>
          <p:cNvPr id="13" name="Picture 12"/>
          <p:cNvPicPr>
            <a:picLocks noChangeAspect="1"/>
          </p:cNvPicPr>
          <p:nvPr/>
        </p:nvPicPr>
        <p:blipFill>
          <a:blip r:embed="rId11" cstate="hqprint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68006" y="2484581"/>
            <a:ext cx="914400" cy="914400"/>
          </a:xfrm>
          <a:prstGeom prst="rect">
            <a:avLst/>
          </a:prstGeom>
        </p:spPr>
      </p:pic>
      <p:pic>
        <p:nvPicPr>
          <p:cNvPr id="14" name="Picture 13"/>
          <p:cNvPicPr>
            <a:picLocks noChangeAspect="1"/>
          </p:cNvPicPr>
          <p:nvPr/>
        </p:nvPicPr>
        <p:blipFill>
          <a:blip r:embed="rId13" cstate="hqprint">
            <a:extLst>
              <a:ext uri="{BEBA8EAE-BF5A-486C-A8C5-ECC9F3942E4B}">
                <a14:imgProps xmlns:a14="http://schemas.microsoft.com/office/drawing/2010/main">
                  <a14:imgLayer r:embed="rId14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523150" y="2484388"/>
            <a:ext cx="914400" cy="914400"/>
          </a:xfrm>
          <a:prstGeom prst="rect">
            <a:avLst/>
          </a:prstGeom>
        </p:spPr>
      </p:pic>
      <p:pic>
        <p:nvPicPr>
          <p:cNvPr id="15" name="Picture 14"/>
          <p:cNvPicPr>
            <a:picLocks noChangeAspect="1"/>
          </p:cNvPicPr>
          <p:nvPr/>
        </p:nvPicPr>
        <p:blipFill>
          <a:blip r:embed="rId15" cstate="hqprint">
            <a:extLst>
              <a:ext uri="{BEBA8EAE-BF5A-486C-A8C5-ECC9F3942E4B}">
                <a14:imgProps xmlns:a14="http://schemas.microsoft.com/office/drawing/2010/main">
                  <a14:imgLayer r:embed="rId16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493194" y="2484581"/>
            <a:ext cx="914400" cy="914400"/>
          </a:xfrm>
          <a:prstGeom prst="rect">
            <a:avLst/>
          </a:prstGeom>
        </p:spPr>
      </p:pic>
      <p:pic>
        <p:nvPicPr>
          <p:cNvPr id="16" name="Picture 15"/>
          <p:cNvPicPr>
            <a:picLocks noChangeAspect="1"/>
          </p:cNvPicPr>
          <p:nvPr/>
        </p:nvPicPr>
        <p:blipFill>
          <a:blip r:embed="rId17" cstate="hqprint">
            <a:extLst>
              <a:ext uri="{BEBA8EAE-BF5A-486C-A8C5-ECC9F3942E4B}">
                <a14:imgProps xmlns:a14="http://schemas.microsoft.com/office/drawing/2010/main">
                  <a14:imgLayer r:embed="rId18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493194" y="4407807"/>
            <a:ext cx="914400" cy="914400"/>
          </a:xfrm>
          <a:prstGeom prst="rect">
            <a:avLst/>
          </a:prstGeom>
        </p:spPr>
      </p:pic>
      <p:pic>
        <p:nvPicPr>
          <p:cNvPr id="17" name="Picture 16"/>
          <p:cNvPicPr>
            <a:picLocks noChangeAspect="1"/>
          </p:cNvPicPr>
          <p:nvPr/>
        </p:nvPicPr>
        <p:blipFill>
          <a:blip r:embed="rId19" cstate="hqprint">
            <a:extLst>
              <a:ext uri="{BEBA8EAE-BF5A-486C-A8C5-ECC9F3942E4B}">
                <a14:imgProps xmlns:a14="http://schemas.microsoft.com/office/drawing/2010/main">
                  <a14:imgLayer r:embed="rId20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530600" y="4407807"/>
            <a:ext cx="914400" cy="914400"/>
          </a:xfrm>
          <a:prstGeom prst="rect">
            <a:avLst/>
          </a:prstGeom>
        </p:spPr>
      </p:pic>
      <p:pic>
        <p:nvPicPr>
          <p:cNvPr id="18" name="Picture 17"/>
          <p:cNvPicPr>
            <a:picLocks noChangeAspect="1"/>
          </p:cNvPicPr>
          <p:nvPr/>
        </p:nvPicPr>
        <p:blipFill>
          <a:blip r:embed="rId21" cstate="hqprint">
            <a:extLst>
              <a:ext uri="{BEBA8EAE-BF5A-486C-A8C5-ECC9F3942E4B}">
                <a14:imgProps xmlns:a14="http://schemas.microsoft.com/office/drawing/2010/main">
                  <a14:imgLayer r:embed="rId22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68006" y="4407807"/>
            <a:ext cx="914400" cy="914400"/>
          </a:xfrm>
          <a:prstGeom prst="rect">
            <a:avLst/>
          </a:prstGeom>
        </p:spPr>
      </p:pic>
      <p:sp>
        <p:nvSpPr>
          <p:cNvPr id="19" name="TextBox 7"/>
          <p:cNvSpPr txBox="1"/>
          <p:nvPr/>
        </p:nvSpPr>
        <p:spPr>
          <a:xfrm>
            <a:off x="1604520" y="2188010"/>
            <a:ext cx="76655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V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ehicle/HI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1"/>
          <p:cNvSpPr txBox="1"/>
          <p:nvPr/>
        </p:nvSpPr>
        <p:spPr>
          <a:xfrm rot="16200000">
            <a:off x="110506" y="2803281"/>
            <a:ext cx="5898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Cortex</a:t>
            </a:r>
            <a:endParaRPr lang="en-US" sz="1200" dirty="0"/>
          </a:p>
        </p:txBody>
      </p:sp>
      <p:sp>
        <p:nvSpPr>
          <p:cNvPr id="21" name="TextBox 11"/>
          <p:cNvSpPr txBox="1"/>
          <p:nvPr/>
        </p:nvSpPr>
        <p:spPr>
          <a:xfrm rot="16200000">
            <a:off x="-122651" y="3741247"/>
            <a:ext cx="105612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Hippocampus</a:t>
            </a:r>
            <a:endParaRPr lang="en-US" sz="1200" dirty="0"/>
          </a:p>
        </p:txBody>
      </p:sp>
      <p:sp>
        <p:nvSpPr>
          <p:cNvPr id="22" name="TextBox 11"/>
          <p:cNvSpPr txBox="1"/>
          <p:nvPr/>
        </p:nvSpPr>
        <p:spPr>
          <a:xfrm rot="16200000">
            <a:off x="-122651" y="4555405"/>
            <a:ext cx="105612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Thalamus</a:t>
            </a:r>
            <a:endParaRPr lang="en-US" sz="1200" dirty="0"/>
          </a:p>
        </p:txBody>
      </p:sp>
      <p:cxnSp>
        <p:nvCxnSpPr>
          <p:cNvPr id="24" name="Straight Connector 23"/>
          <p:cNvCxnSpPr/>
          <p:nvPr/>
        </p:nvCxnSpPr>
        <p:spPr>
          <a:xfrm>
            <a:off x="568005" y="2413974"/>
            <a:ext cx="2839589" cy="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5" name="TextBox 24"/>
          <p:cNvSpPr txBox="1"/>
          <p:nvPr/>
        </p:nvSpPr>
        <p:spPr>
          <a:xfrm>
            <a:off x="74963" y="5380753"/>
            <a:ext cx="2600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c</a:t>
            </a:r>
            <a:endParaRPr lang="en-US" sz="1400" dirty="0"/>
          </a:p>
        </p:txBody>
      </p:sp>
      <p:pic>
        <p:nvPicPr>
          <p:cNvPr id="28" name="Picture 27"/>
          <p:cNvPicPr>
            <a:picLocks noChangeAspect="1"/>
          </p:cNvPicPr>
          <p:nvPr/>
        </p:nvPicPr>
        <p:blipFill>
          <a:blip r:embed="rId23" cstate="hqprint">
            <a:extLst>
              <a:ext uri="{BEBA8EAE-BF5A-486C-A8C5-ECC9F3942E4B}">
                <a14:imgProps xmlns:a14="http://schemas.microsoft.com/office/drawing/2010/main">
                  <a14:imgLayer r:embed="rId24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506164" y="3446194"/>
            <a:ext cx="914400" cy="914400"/>
          </a:xfrm>
          <a:prstGeom prst="rect">
            <a:avLst/>
          </a:prstGeom>
        </p:spPr>
      </p:pic>
      <p:pic>
        <p:nvPicPr>
          <p:cNvPr id="29" name="Picture 28"/>
          <p:cNvPicPr>
            <a:picLocks noChangeAspect="1"/>
          </p:cNvPicPr>
          <p:nvPr/>
        </p:nvPicPr>
        <p:blipFill>
          <a:blip r:embed="rId25" cstate="hqprint">
            <a:extLst>
              <a:ext uri="{BEBA8EAE-BF5A-486C-A8C5-ECC9F3942E4B}">
                <a14:imgProps xmlns:a14="http://schemas.microsoft.com/office/drawing/2010/main">
                  <a14:imgLayer r:embed="rId26">
                    <a14:imgEffect>
                      <a14:brightnessContrast bright="-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431352" y="3446194"/>
            <a:ext cx="914400" cy="914400"/>
          </a:xfrm>
          <a:prstGeom prst="rect">
            <a:avLst/>
          </a:prstGeom>
        </p:spPr>
      </p:pic>
      <p:pic>
        <p:nvPicPr>
          <p:cNvPr id="30" name="Picture 29"/>
          <p:cNvPicPr>
            <a:picLocks noChangeAspect="1"/>
          </p:cNvPicPr>
          <p:nvPr/>
        </p:nvPicPr>
        <p:blipFill>
          <a:blip r:embed="rId27" cstate="hqprint">
            <a:extLst>
              <a:ext uri="{BEBA8EAE-BF5A-486C-A8C5-ECC9F3942E4B}">
                <a14:imgProps xmlns:a14="http://schemas.microsoft.com/office/drawing/2010/main">
                  <a14:imgLayer r:embed="rId28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468758" y="3446194"/>
            <a:ext cx="914400" cy="914400"/>
          </a:xfrm>
          <a:prstGeom prst="rect">
            <a:avLst/>
          </a:prstGeom>
        </p:spPr>
      </p:pic>
      <p:sp>
        <p:nvSpPr>
          <p:cNvPr id="34" name="TextBox 7"/>
          <p:cNvSpPr txBox="1"/>
          <p:nvPr/>
        </p:nvSpPr>
        <p:spPr>
          <a:xfrm>
            <a:off x="4436362" y="2188191"/>
            <a:ext cx="98777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Clemastine/HI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5" name="Straight Connector 34"/>
          <p:cNvCxnSpPr/>
          <p:nvPr/>
        </p:nvCxnSpPr>
        <p:spPr>
          <a:xfrm>
            <a:off x="3510453" y="2414155"/>
            <a:ext cx="2839589" cy="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36" name="Picture 35"/>
          <p:cNvPicPr>
            <a:picLocks noChangeAspect="1"/>
          </p:cNvPicPr>
          <p:nvPr/>
        </p:nvPicPr>
        <p:blipFill>
          <a:blip r:embed="rId29" cstate="hqprint">
            <a:extLst>
              <a:ext uri="{BEBA8EAE-BF5A-486C-A8C5-ECC9F3942E4B}">
                <a14:imgProps xmlns:a14="http://schemas.microsoft.com/office/drawing/2010/main">
                  <a14:imgLayer r:embed="rId30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431352" y="4407807"/>
            <a:ext cx="914400" cy="914400"/>
          </a:xfrm>
          <a:prstGeom prst="rect">
            <a:avLst/>
          </a:prstGeom>
        </p:spPr>
      </p:pic>
      <p:pic>
        <p:nvPicPr>
          <p:cNvPr id="37" name="Picture 36"/>
          <p:cNvPicPr>
            <a:picLocks noChangeAspect="1"/>
          </p:cNvPicPr>
          <p:nvPr/>
        </p:nvPicPr>
        <p:blipFill>
          <a:blip r:embed="rId31" cstate="hqprint">
            <a:extLst>
              <a:ext uri="{BEBA8EAE-BF5A-486C-A8C5-ECC9F3942E4B}">
                <a14:imgProps xmlns:a14="http://schemas.microsoft.com/office/drawing/2010/main">
                  <a14:imgLayer r:embed="rId32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468758" y="4407807"/>
            <a:ext cx="914400" cy="914400"/>
          </a:xfrm>
          <a:prstGeom prst="rect">
            <a:avLst/>
          </a:prstGeom>
        </p:spPr>
      </p:pic>
      <p:pic>
        <p:nvPicPr>
          <p:cNvPr id="38" name="Picture 37"/>
          <p:cNvPicPr>
            <a:picLocks noChangeAspect="1"/>
          </p:cNvPicPr>
          <p:nvPr/>
        </p:nvPicPr>
        <p:blipFill>
          <a:blip r:embed="rId33" cstate="hqprint">
            <a:extLst>
              <a:ext uri="{BEBA8EAE-BF5A-486C-A8C5-ECC9F3942E4B}">
                <a14:imgProps xmlns:a14="http://schemas.microsoft.com/office/drawing/2010/main">
                  <a14:imgLayer r:embed="rId34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506164" y="4407807"/>
            <a:ext cx="914400" cy="914400"/>
          </a:xfrm>
          <a:prstGeom prst="rect">
            <a:avLst/>
          </a:prstGeom>
        </p:spPr>
      </p:pic>
      <p:sp>
        <p:nvSpPr>
          <p:cNvPr id="39" name="Rectangle 38"/>
          <p:cNvSpPr/>
          <p:nvPr/>
        </p:nvSpPr>
        <p:spPr>
          <a:xfrm>
            <a:off x="5910117" y="5199106"/>
            <a:ext cx="365760" cy="4572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0" name="Isosceles Triangle 39"/>
          <p:cNvSpPr/>
          <p:nvPr/>
        </p:nvSpPr>
        <p:spPr>
          <a:xfrm flipV="1">
            <a:off x="1093222" y="2740781"/>
            <a:ext cx="62892" cy="61292"/>
          </a:xfrm>
          <a:prstGeom prst="triangl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1" name="Isosceles Triangle 40"/>
          <p:cNvSpPr/>
          <p:nvPr/>
        </p:nvSpPr>
        <p:spPr>
          <a:xfrm flipV="1">
            <a:off x="2669308" y="2176916"/>
            <a:ext cx="62892" cy="61292"/>
          </a:xfrm>
          <a:prstGeom prst="triangl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2" name="Isosceles Triangle 41"/>
          <p:cNvSpPr/>
          <p:nvPr/>
        </p:nvSpPr>
        <p:spPr>
          <a:xfrm flipV="1">
            <a:off x="2073655" y="2727305"/>
            <a:ext cx="62892" cy="61292"/>
          </a:xfrm>
          <a:prstGeom prst="triangl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3" name="Isosceles Triangle 42"/>
          <p:cNvSpPr/>
          <p:nvPr/>
        </p:nvSpPr>
        <p:spPr>
          <a:xfrm flipV="1">
            <a:off x="1929515" y="3093565"/>
            <a:ext cx="62892" cy="61292"/>
          </a:xfrm>
          <a:prstGeom prst="triangl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4" name="Isosceles Triangle 43"/>
          <p:cNvSpPr/>
          <p:nvPr/>
        </p:nvSpPr>
        <p:spPr>
          <a:xfrm flipV="1">
            <a:off x="980051" y="3123015"/>
            <a:ext cx="62892" cy="61292"/>
          </a:xfrm>
          <a:prstGeom prst="triangl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5" name="Isosceles Triangle 44"/>
          <p:cNvSpPr/>
          <p:nvPr/>
        </p:nvSpPr>
        <p:spPr>
          <a:xfrm flipV="1">
            <a:off x="1201899" y="2585585"/>
            <a:ext cx="62892" cy="61292"/>
          </a:xfrm>
          <a:prstGeom prst="triangl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6" name="Isosceles Triangle 45"/>
          <p:cNvSpPr/>
          <p:nvPr/>
        </p:nvSpPr>
        <p:spPr>
          <a:xfrm flipV="1">
            <a:off x="2174266" y="2592016"/>
            <a:ext cx="62892" cy="61292"/>
          </a:xfrm>
          <a:prstGeom prst="triangl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7" name="Isosceles Triangle 46"/>
          <p:cNvSpPr/>
          <p:nvPr/>
        </p:nvSpPr>
        <p:spPr>
          <a:xfrm rot="16200000" flipV="1">
            <a:off x="805005" y="2605246"/>
            <a:ext cx="62892" cy="61292"/>
          </a:xfrm>
          <a:prstGeom prst="triangl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8" name="Isosceles Triangle 47"/>
          <p:cNvSpPr/>
          <p:nvPr/>
        </p:nvSpPr>
        <p:spPr>
          <a:xfrm rot="16200000" flipV="1">
            <a:off x="1767652" y="2598103"/>
            <a:ext cx="62892" cy="61292"/>
          </a:xfrm>
          <a:prstGeom prst="triangl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9" name="Isosceles Triangle 48"/>
          <p:cNvSpPr/>
          <p:nvPr/>
        </p:nvSpPr>
        <p:spPr>
          <a:xfrm rot="16200000" flipV="1">
            <a:off x="795506" y="2964332"/>
            <a:ext cx="62892" cy="61292"/>
          </a:xfrm>
          <a:prstGeom prst="triangl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0" name="Isosceles Triangle 49"/>
          <p:cNvSpPr/>
          <p:nvPr/>
        </p:nvSpPr>
        <p:spPr>
          <a:xfrm rot="16200000" flipV="1">
            <a:off x="1759087" y="2964332"/>
            <a:ext cx="62892" cy="61292"/>
          </a:xfrm>
          <a:prstGeom prst="triangl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1" name="Isosceles Triangle 50"/>
          <p:cNvSpPr/>
          <p:nvPr/>
        </p:nvSpPr>
        <p:spPr>
          <a:xfrm flipV="1">
            <a:off x="3871559" y="2667338"/>
            <a:ext cx="62892" cy="61292"/>
          </a:xfrm>
          <a:prstGeom prst="triangl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2" name="Isosceles Triangle 51"/>
          <p:cNvSpPr/>
          <p:nvPr/>
        </p:nvSpPr>
        <p:spPr>
          <a:xfrm flipV="1">
            <a:off x="4826470" y="2667338"/>
            <a:ext cx="62892" cy="61292"/>
          </a:xfrm>
          <a:prstGeom prst="triangl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3" name="Isosceles Triangle 52"/>
          <p:cNvSpPr/>
          <p:nvPr/>
        </p:nvSpPr>
        <p:spPr>
          <a:xfrm flipV="1">
            <a:off x="4826470" y="3642217"/>
            <a:ext cx="62892" cy="61292"/>
          </a:xfrm>
          <a:prstGeom prst="triangl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56" name="Picture 55"/>
          <p:cNvPicPr>
            <a:picLocks noChangeAspect="1"/>
          </p:cNvPicPr>
          <p:nvPr/>
        </p:nvPicPr>
        <p:blipFill>
          <a:blip r:embed="rId35" cstate="hqprint">
            <a:extLst>
              <a:ext uri="{BEBA8EAE-BF5A-486C-A8C5-ECC9F3942E4B}">
                <a14:imgProps xmlns:a14="http://schemas.microsoft.com/office/drawing/2010/main">
                  <a14:imgLayer r:embed="rId36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431352" y="2480727"/>
            <a:ext cx="914400" cy="914400"/>
          </a:xfrm>
          <a:prstGeom prst="rect">
            <a:avLst/>
          </a:prstGeom>
        </p:spPr>
      </p:pic>
      <p:pic>
        <p:nvPicPr>
          <p:cNvPr id="57" name="Picture 56"/>
          <p:cNvPicPr>
            <a:picLocks noChangeAspect="1"/>
          </p:cNvPicPr>
          <p:nvPr/>
        </p:nvPicPr>
        <p:blipFill>
          <a:blip r:embed="rId37" cstate="hqprint">
            <a:extLst>
              <a:ext uri="{BEBA8EAE-BF5A-486C-A8C5-ECC9F3942E4B}">
                <a14:imgProps xmlns:a14="http://schemas.microsoft.com/office/drawing/2010/main">
                  <a14:imgLayer r:embed="rId38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468758" y="2480727"/>
            <a:ext cx="914400" cy="914400"/>
          </a:xfrm>
          <a:prstGeom prst="rect">
            <a:avLst/>
          </a:prstGeom>
        </p:spPr>
      </p:pic>
      <p:pic>
        <p:nvPicPr>
          <p:cNvPr id="58" name="Picture 57"/>
          <p:cNvPicPr>
            <a:picLocks noChangeAspect="1"/>
          </p:cNvPicPr>
          <p:nvPr/>
        </p:nvPicPr>
        <p:blipFill>
          <a:blip r:embed="rId39" cstate="hqprint">
            <a:extLst>
              <a:ext uri="{BEBA8EAE-BF5A-486C-A8C5-ECC9F3942E4B}">
                <a14:imgProps xmlns:a14="http://schemas.microsoft.com/office/drawing/2010/main">
                  <a14:imgLayer r:embed="rId40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510189" y="2480727"/>
            <a:ext cx="914400" cy="914400"/>
          </a:xfrm>
          <a:prstGeom prst="rect">
            <a:avLst/>
          </a:prstGeom>
        </p:spPr>
      </p:pic>
      <p:sp>
        <p:nvSpPr>
          <p:cNvPr id="59" name="Isosceles Triangle 58"/>
          <p:cNvSpPr/>
          <p:nvPr/>
        </p:nvSpPr>
        <p:spPr>
          <a:xfrm flipV="1">
            <a:off x="3840113" y="3611571"/>
            <a:ext cx="62892" cy="61292"/>
          </a:xfrm>
          <a:prstGeom prst="triangl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0" name="Isosceles Triangle 59"/>
          <p:cNvSpPr/>
          <p:nvPr/>
        </p:nvSpPr>
        <p:spPr>
          <a:xfrm flipV="1">
            <a:off x="4937556" y="3642217"/>
            <a:ext cx="62892" cy="61292"/>
          </a:xfrm>
          <a:prstGeom prst="triangl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1" name="Isosceles Triangle 60"/>
          <p:cNvSpPr/>
          <p:nvPr/>
        </p:nvSpPr>
        <p:spPr>
          <a:xfrm flipV="1">
            <a:off x="3963364" y="3611571"/>
            <a:ext cx="62892" cy="61292"/>
          </a:xfrm>
          <a:prstGeom prst="triangl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2" name="Isosceles Triangle 61"/>
          <p:cNvSpPr/>
          <p:nvPr/>
        </p:nvSpPr>
        <p:spPr>
          <a:xfrm rot="16200000" flipV="1">
            <a:off x="3535801" y="3992550"/>
            <a:ext cx="62892" cy="61292"/>
          </a:xfrm>
          <a:prstGeom prst="triangl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3" name="Isosceles Triangle 62"/>
          <p:cNvSpPr/>
          <p:nvPr/>
        </p:nvSpPr>
        <p:spPr>
          <a:xfrm rot="16200000" flipV="1">
            <a:off x="4487688" y="3992550"/>
            <a:ext cx="62892" cy="61292"/>
          </a:xfrm>
          <a:prstGeom prst="triangl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4" name="Isosceles Triangle 63"/>
          <p:cNvSpPr/>
          <p:nvPr/>
        </p:nvSpPr>
        <p:spPr>
          <a:xfrm flipV="1">
            <a:off x="4942629" y="2858493"/>
            <a:ext cx="62892" cy="61292"/>
          </a:xfrm>
          <a:prstGeom prst="triangl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5" name="Isosceles Triangle 64"/>
          <p:cNvSpPr/>
          <p:nvPr/>
        </p:nvSpPr>
        <p:spPr>
          <a:xfrm flipV="1">
            <a:off x="3994810" y="2841180"/>
            <a:ext cx="62892" cy="61292"/>
          </a:xfrm>
          <a:prstGeom prst="triangl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6" name="Isosceles Triangle 65"/>
          <p:cNvSpPr/>
          <p:nvPr/>
        </p:nvSpPr>
        <p:spPr>
          <a:xfrm flipV="1">
            <a:off x="3840113" y="3124993"/>
            <a:ext cx="62892" cy="61292"/>
          </a:xfrm>
          <a:prstGeom prst="triangl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7" name="Isosceles Triangle 66"/>
          <p:cNvSpPr/>
          <p:nvPr/>
        </p:nvSpPr>
        <p:spPr>
          <a:xfrm flipV="1">
            <a:off x="4795024" y="3153661"/>
            <a:ext cx="62892" cy="61292"/>
          </a:xfrm>
          <a:prstGeom prst="triangl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8" name="Isosceles Triangle 67"/>
          <p:cNvSpPr/>
          <p:nvPr/>
        </p:nvSpPr>
        <p:spPr>
          <a:xfrm flipV="1">
            <a:off x="5028447" y="4834361"/>
            <a:ext cx="62892" cy="61292"/>
          </a:xfrm>
          <a:prstGeom prst="triangl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9" name="Isosceles Triangle 68"/>
          <p:cNvSpPr/>
          <p:nvPr/>
        </p:nvSpPr>
        <p:spPr>
          <a:xfrm flipV="1">
            <a:off x="4057702" y="4803715"/>
            <a:ext cx="62892" cy="61292"/>
          </a:xfrm>
          <a:prstGeom prst="triangl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0" name="Isosceles Triangle 69"/>
          <p:cNvSpPr/>
          <p:nvPr/>
        </p:nvSpPr>
        <p:spPr>
          <a:xfrm flipV="1">
            <a:off x="4210102" y="4956115"/>
            <a:ext cx="62892" cy="61292"/>
          </a:xfrm>
          <a:prstGeom prst="triangl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1" name="Isosceles Triangle 70"/>
          <p:cNvSpPr/>
          <p:nvPr/>
        </p:nvSpPr>
        <p:spPr>
          <a:xfrm flipV="1">
            <a:off x="1659814" y="4574151"/>
            <a:ext cx="62892" cy="61292"/>
          </a:xfrm>
          <a:prstGeom prst="triangl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2" name="Isosceles Triangle 71"/>
          <p:cNvSpPr/>
          <p:nvPr/>
        </p:nvSpPr>
        <p:spPr>
          <a:xfrm flipV="1">
            <a:off x="673124" y="4599842"/>
            <a:ext cx="62892" cy="61292"/>
          </a:xfrm>
          <a:prstGeom prst="triangl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3" name="Isosceles Triangle 72"/>
          <p:cNvSpPr/>
          <p:nvPr/>
        </p:nvSpPr>
        <p:spPr>
          <a:xfrm flipV="1">
            <a:off x="2010763" y="4961515"/>
            <a:ext cx="62892" cy="61292"/>
          </a:xfrm>
          <a:prstGeom prst="triangl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4" name="Isosceles Triangle 73"/>
          <p:cNvSpPr/>
          <p:nvPr/>
        </p:nvSpPr>
        <p:spPr>
          <a:xfrm flipV="1">
            <a:off x="1061776" y="4961515"/>
            <a:ext cx="62892" cy="61292"/>
          </a:xfrm>
          <a:prstGeom prst="triangl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5" name="Isosceles Triangle 74"/>
          <p:cNvSpPr/>
          <p:nvPr/>
        </p:nvSpPr>
        <p:spPr>
          <a:xfrm flipV="1">
            <a:off x="1829744" y="4663258"/>
            <a:ext cx="62892" cy="61292"/>
          </a:xfrm>
          <a:prstGeom prst="triangl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6" name="Isosceles Triangle 75"/>
          <p:cNvSpPr/>
          <p:nvPr/>
        </p:nvSpPr>
        <p:spPr>
          <a:xfrm flipV="1">
            <a:off x="854213" y="4655636"/>
            <a:ext cx="62892" cy="61292"/>
          </a:xfrm>
          <a:prstGeom prst="triangl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7" name="Isosceles Triangle 76"/>
          <p:cNvSpPr/>
          <p:nvPr/>
        </p:nvSpPr>
        <p:spPr>
          <a:xfrm flipV="1">
            <a:off x="1006613" y="4808036"/>
            <a:ext cx="62892" cy="61292"/>
          </a:xfrm>
          <a:prstGeom prst="triangl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8" name="Isosceles Triangle 77"/>
          <p:cNvSpPr/>
          <p:nvPr/>
        </p:nvSpPr>
        <p:spPr>
          <a:xfrm flipV="1">
            <a:off x="1585146" y="4834767"/>
            <a:ext cx="62892" cy="61292"/>
          </a:xfrm>
          <a:prstGeom prst="triangl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9" name="Isosceles Triangle 78"/>
          <p:cNvSpPr/>
          <p:nvPr/>
        </p:nvSpPr>
        <p:spPr>
          <a:xfrm flipV="1">
            <a:off x="611034" y="4803715"/>
            <a:ext cx="62892" cy="61292"/>
          </a:xfrm>
          <a:prstGeom prst="triangl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0" name="Isosceles Triangle 79"/>
          <p:cNvSpPr/>
          <p:nvPr/>
        </p:nvSpPr>
        <p:spPr>
          <a:xfrm flipV="1">
            <a:off x="2073655" y="3836721"/>
            <a:ext cx="62892" cy="61292"/>
          </a:xfrm>
          <a:prstGeom prst="triangl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1" name="Isosceles Triangle 80"/>
          <p:cNvSpPr/>
          <p:nvPr/>
        </p:nvSpPr>
        <p:spPr>
          <a:xfrm flipV="1">
            <a:off x="2195890" y="3778817"/>
            <a:ext cx="62892" cy="61292"/>
          </a:xfrm>
          <a:prstGeom prst="triangl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2" name="Isosceles Triangle 81"/>
          <p:cNvSpPr/>
          <p:nvPr/>
        </p:nvSpPr>
        <p:spPr>
          <a:xfrm flipV="1">
            <a:off x="2132998" y="4000790"/>
            <a:ext cx="62892" cy="61292"/>
          </a:xfrm>
          <a:prstGeom prst="triangl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4" name="Isosceles Triangle 83"/>
          <p:cNvSpPr/>
          <p:nvPr/>
        </p:nvSpPr>
        <p:spPr>
          <a:xfrm flipV="1">
            <a:off x="1829744" y="3767882"/>
            <a:ext cx="62892" cy="61292"/>
          </a:xfrm>
          <a:prstGeom prst="triangl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5" name="Isosceles Triangle 84"/>
          <p:cNvSpPr/>
          <p:nvPr/>
        </p:nvSpPr>
        <p:spPr>
          <a:xfrm flipV="1">
            <a:off x="1696995" y="3699328"/>
            <a:ext cx="62892" cy="61292"/>
          </a:xfrm>
          <a:prstGeom prst="triangl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6" name="Isosceles Triangle 85"/>
          <p:cNvSpPr/>
          <p:nvPr/>
        </p:nvSpPr>
        <p:spPr>
          <a:xfrm flipV="1">
            <a:off x="778612" y="3699328"/>
            <a:ext cx="62892" cy="61292"/>
          </a:xfrm>
          <a:prstGeom prst="triangl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7" name="Isosceles Triangle 86"/>
          <p:cNvSpPr/>
          <p:nvPr/>
        </p:nvSpPr>
        <p:spPr>
          <a:xfrm flipV="1">
            <a:off x="891759" y="3758067"/>
            <a:ext cx="62892" cy="61292"/>
          </a:xfrm>
          <a:prstGeom prst="triangl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8" name="Isosceles Triangle 87"/>
          <p:cNvSpPr/>
          <p:nvPr/>
        </p:nvSpPr>
        <p:spPr>
          <a:xfrm flipV="1">
            <a:off x="1105706" y="3818454"/>
            <a:ext cx="62892" cy="61292"/>
          </a:xfrm>
          <a:prstGeom prst="triangl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9" name="Isosceles Triangle 88"/>
          <p:cNvSpPr/>
          <p:nvPr/>
        </p:nvSpPr>
        <p:spPr>
          <a:xfrm flipV="1">
            <a:off x="1007958" y="3724129"/>
            <a:ext cx="62892" cy="61292"/>
          </a:xfrm>
          <a:prstGeom prst="triangl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0" name="Isosceles Triangle 89"/>
          <p:cNvSpPr/>
          <p:nvPr/>
        </p:nvSpPr>
        <p:spPr>
          <a:xfrm flipV="1">
            <a:off x="1962145" y="3729974"/>
            <a:ext cx="62892" cy="61292"/>
          </a:xfrm>
          <a:prstGeom prst="triangl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1" name="Isosceles Triangle 90"/>
          <p:cNvSpPr/>
          <p:nvPr/>
        </p:nvSpPr>
        <p:spPr>
          <a:xfrm flipV="1">
            <a:off x="1225521" y="3767882"/>
            <a:ext cx="62892" cy="61292"/>
          </a:xfrm>
          <a:prstGeom prst="triangl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2" name="Isosceles Triangle 91"/>
          <p:cNvSpPr/>
          <p:nvPr/>
        </p:nvSpPr>
        <p:spPr>
          <a:xfrm flipV="1">
            <a:off x="1201899" y="3997459"/>
            <a:ext cx="62892" cy="61292"/>
          </a:xfrm>
          <a:prstGeom prst="triangl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83" name="Group 82"/>
          <p:cNvGrpSpPr/>
          <p:nvPr/>
        </p:nvGrpSpPr>
        <p:grpSpPr>
          <a:xfrm>
            <a:off x="2258782" y="5742946"/>
            <a:ext cx="1050979" cy="379475"/>
            <a:chOff x="2024063" y="1101666"/>
            <a:chExt cx="1050979" cy="379475"/>
          </a:xfrm>
        </p:grpSpPr>
        <p:sp>
          <p:nvSpPr>
            <p:cNvPr id="93" name="Oval 92"/>
            <p:cNvSpPr/>
            <p:nvPr/>
          </p:nvSpPr>
          <p:spPr>
            <a:xfrm>
              <a:off x="2024063" y="1211475"/>
              <a:ext cx="53353" cy="48459"/>
            </a:xfrm>
            <a:prstGeom prst="ellipse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4" name="Rectangle 93"/>
            <p:cNvSpPr/>
            <p:nvPr/>
          </p:nvSpPr>
          <p:spPr>
            <a:xfrm>
              <a:off x="2027879" y="1337889"/>
              <a:ext cx="45719" cy="4571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5" name="TextBox 94"/>
            <p:cNvSpPr txBox="1"/>
            <p:nvPr/>
          </p:nvSpPr>
          <p:spPr>
            <a:xfrm>
              <a:off x="2042340" y="1101666"/>
              <a:ext cx="800219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Vehicle/HI</a:t>
              </a:r>
              <a:endParaRPr lang="en-US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6" name="TextBox 95"/>
            <p:cNvSpPr txBox="1"/>
            <p:nvPr/>
          </p:nvSpPr>
          <p:spPr>
            <a:xfrm>
              <a:off x="2042387" y="1227225"/>
              <a:ext cx="1032655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lemastine/HI</a:t>
              </a:r>
              <a:endParaRPr lang="en-US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97" name="Textfeld 23"/>
          <p:cNvSpPr txBox="1"/>
          <p:nvPr/>
        </p:nvSpPr>
        <p:spPr>
          <a:xfrm>
            <a:off x="482096" y="5322207"/>
            <a:ext cx="194636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lig2</a:t>
            </a:r>
            <a:r>
              <a:rPr lang="en-US" sz="1000" b="1" smtClean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sz="1000" b="1" smtClean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thoGreen (PG)</a:t>
            </a:r>
            <a:r>
              <a:rPr lang="en-US" sz="1000" b="1" smtClean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sz="1000" b="1" smtClean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  <a:endParaRPr lang="en-US" sz="1000" b="1" dirty="0">
              <a:solidFill>
                <a:schemeClr val="accent6">
                  <a:lumMod val="40000"/>
                  <a:lumOff val="6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TextBox 97"/>
          <p:cNvSpPr txBox="1"/>
          <p:nvPr/>
        </p:nvSpPr>
        <p:spPr>
          <a:xfrm>
            <a:off x="74963" y="569888"/>
            <a:ext cx="27122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a</a:t>
            </a: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41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79512" y="723776"/>
            <a:ext cx="2069846" cy="144889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4296432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62" name="Table 461"/>
          <p:cNvGraphicFramePr>
            <a:graphicFrameLocks noGrp="1"/>
          </p:cNvGraphicFramePr>
          <p:nvPr>
            <p:extLst/>
          </p:nvPr>
        </p:nvGraphicFramePr>
        <p:xfrm>
          <a:off x="2033978" y="10140604"/>
          <a:ext cx="4104523" cy="1678854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61271">
                  <a:extLst>
                    <a:ext uri="{9D8B030D-6E8A-4147-A177-3AD203B41FA5}">
                      <a16:colId xmlns:a16="http://schemas.microsoft.com/office/drawing/2014/main" val="1931613504"/>
                    </a:ext>
                  </a:extLst>
                </a:gridCol>
                <a:gridCol w="386940">
                  <a:extLst>
                    <a:ext uri="{9D8B030D-6E8A-4147-A177-3AD203B41FA5}">
                      <a16:colId xmlns:a16="http://schemas.microsoft.com/office/drawing/2014/main" val="3034343333"/>
                    </a:ext>
                  </a:extLst>
                </a:gridCol>
                <a:gridCol w="1229579">
                  <a:extLst>
                    <a:ext uri="{9D8B030D-6E8A-4147-A177-3AD203B41FA5}">
                      <a16:colId xmlns:a16="http://schemas.microsoft.com/office/drawing/2014/main" val="2610843802"/>
                    </a:ext>
                  </a:extLst>
                </a:gridCol>
                <a:gridCol w="1231900">
                  <a:extLst>
                    <a:ext uri="{9D8B030D-6E8A-4147-A177-3AD203B41FA5}">
                      <a16:colId xmlns:a16="http://schemas.microsoft.com/office/drawing/2014/main" val="1870459983"/>
                    </a:ext>
                  </a:extLst>
                </a:gridCol>
                <a:gridCol w="208280">
                  <a:extLst>
                    <a:ext uri="{9D8B030D-6E8A-4147-A177-3AD203B41FA5}">
                      <a16:colId xmlns:a16="http://schemas.microsoft.com/office/drawing/2014/main" val="3213023867"/>
                    </a:ext>
                  </a:extLst>
                </a:gridCol>
                <a:gridCol w="786553">
                  <a:extLst>
                    <a:ext uri="{9D8B030D-6E8A-4147-A177-3AD203B41FA5}">
                      <a16:colId xmlns:a16="http://schemas.microsoft.com/office/drawing/2014/main" val="3381088522"/>
                    </a:ext>
                  </a:extLst>
                </a:gridCol>
              </a:tblGrid>
              <a:tr h="403743">
                <a:tc rowSpan="2">
                  <a:txBody>
                    <a:bodyPr/>
                    <a:lstStyle/>
                    <a:p>
                      <a:pPr algn="ctr"/>
                      <a:r>
                        <a:rPr lang="en-US" sz="9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ehicle/HI</a:t>
                      </a:r>
                      <a:endParaRPr lang="en-US" sz="9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vert="vert27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h</a:t>
                      </a:r>
                      <a:endParaRPr lang="en-US" sz="9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en-US" sz="6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6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6 KDa JNK</a:t>
                      </a:r>
                    </a:p>
                    <a:p>
                      <a:endParaRPr lang="en-US" sz="600" b="0" dirty="0" smtClean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6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 KDa Actin</a:t>
                      </a:r>
                      <a:endParaRPr lang="en-US" sz="6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05222174"/>
                  </a:ext>
                </a:extLst>
              </a:tr>
              <a:tr h="425037"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8h</a:t>
                      </a:r>
                      <a:endParaRPr lang="en-US" sz="9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6 KDa JNK</a:t>
                      </a:r>
                    </a:p>
                    <a:p>
                      <a:endParaRPr lang="en-US" sz="600" dirty="0" smtClean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</a:t>
                      </a:r>
                      <a:r>
                        <a:rPr lang="en-US" sz="6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KDa Actin</a:t>
                      </a:r>
                      <a:endParaRPr lang="en-US" sz="600" dirty="0" smtClean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13521728"/>
                  </a:ext>
                </a:extLst>
              </a:tr>
              <a:tr h="425037">
                <a:tc rowSpan="2"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lemastine/HI</a:t>
                      </a:r>
                    </a:p>
                    <a:p>
                      <a:pPr algn="ctr"/>
                      <a:endParaRPr lang="en-US" dirty="0"/>
                    </a:p>
                  </a:txBody>
                  <a:tcPr vert="vert27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h</a:t>
                      </a:r>
                      <a:endParaRPr lang="en-US" sz="9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6 KDa</a:t>
                      </a:r>
                      <a:r>
                        <a:rPr lang="en-US" sz="6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JNK</a:t>
                      </a:r>
                    </a:p>
                    <a:p>
                      <a:endParaRPr lang="en-US" sz="600" baseline="0" dirty="0" smtClean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6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 KDa Actin</a:t>
                      </a:r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49778991"/>
                  </a:ext>
                </a:extLst>
              </a:tr>
              <a:tr h="425037"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8h</a:t>
                      </a:r>
                      <a:endParaRPr lang="en-US" sz="9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6 KDa</a:t>
                      </a:r>
                      <a:r>
                        <a:rPr lang="en-US" sz="6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JNK</a:t>
                      </a:r>
                    </a:p>
                    <a:p>
                      <a:endParaRPr lang="en-US" sz="600" baseline="0" dirty="0" smtClean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6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 KDa Actin</a:t>
                      </a:r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48463950"/>
                  </a:ext>
                </a:extLst>
              </a:tr>
            </a:tbl>
          </a:graphicData>
        </a:graphic>
      </p:graphicFrame>
      <p:graphicFrame>
        <p:nvGraphicFramePr>
          <p:cNvPr id="430" name="Table 429"/>
          <p:cNvGraphicFramePr>
            <a:graphicFrameLocks noGrp="1"/>
          </p:cNvGraphicFramePr>
          <p:nvPr>
            <p:extLst/>
          </p:nvPr>
        </p:nvGraphicFramePr>
        <p:xfrm>
          <a:off x="2033051" y="7935947"/>
          <a:ext cx="4104523" cy="1678854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61271">
                  <a:extLst>
                    <a:ext uri="{9D8B030D-6E8A-4147-A177-3AD203B41FA5}">
                      <a16:colId xmlns:a16="http://schemas.microsoft.com/office/drawing/2014/main" val="1931613504"/>
                    </a:ext>
                  </a:extLst>
                </a:gridCol>
                <a:gridCol w="386940">
                  <a:extLst>
                    <a:ext uri="{9D8B030D-6E8A-4147-A177-3AD203B41FA5}">
                      <a16:colId xmlns:a16="http://schemas.microsoft.com/office/drawing/2014/main" val="3034343333"/>
                    </a:ext>
                  </a:extLst>
                </a:gridCol>
                <a:gridCol w="1229579">
                  <a:extLst>
                    <a:ext uri="{9D8B030D-6E8A-4147-A177-3AD203B41FA5}">
                      <a16:colId xmlns:a16="http://schemas.microsoft.com/office/drawing/2014/main" val="2610843802"/>
                    </a:ext>
                  </a:extLst>
                </a:gridCol>
                <a:gridCol w="1231900">
                  <a:extLst>
                    <a:ext uri="{9D8B030D-6E8A-4147-A177-3AD203B41FA5}">
                      <a16:colId xmlns:a16="http://schemas.microsoft.com/office/drawing/2014/main" val="1870459983"/>
                    </a:ext>
                  </a:extLst>
                </a:gridCol>
                <a:gridCol w="208280">
                  <a:extLst>
                    <a:ext uri="{9D8B030D-6E8A-4147-A177-3AD203B41FA5}">
                      <a16:colId xmlns:a16="http://schemas.microsoft.com/office/drawing/2014/main" val="3213023867"/>
                    </a:ext>
                  </a:extLst>
                </a:gridCol>
                <a:gridCol w="786553">
                  <a:extLst>
                    <a:ext uri="{9D8B030D-6E8A-4147-A177-3AD203B41FA5}">
                      <a16:colId xmlns:a16="http://schemas.microsoft.com/office/drawing/2014/main" val="3381088522"/>
                    </a:ext>
                  </a:extLst>
                </a:gridCol>
              </a:tblGrid>
              <a:tr h="403743">
                <a:tc rowSpan="2">
                  <a:txBody>
                    <a:bodyPr/>
                    <a:lstStyle/>
                    <a:p>
                      <a:pPr algn="ctr"/>
                      <a:r>
                        <a:rPr lang="en-US" sz="9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ehicle/HI</a:t>
                      </a:r>
                      <a:endParaRPr lang="en-US" sz="9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vert="vert27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h</a:t>
                      </a:r>
                      <a:endParaRPr lang="en-US" sz="9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en-US" sz="6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6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 KDa p38</a:t>
                      </a:r>
                    </a:p>
                    <a:p>
                      <a:endParaRPr lang="en-US" sz="600" b="0" dirty="0" smtClean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6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 KDa Actin</a:t>
                      </a:r>
                      <a:endParaRPr lang="en-US" sz="6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05222174"/>
                  </a:ext>
                </a:extLst>
              </a:tr>
              <a:tr h="425037"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8h</a:t>
                      </a:r>
                      <a:endParaRPr lang="en-US" sz="9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 KDa p38</a:t>
                      </a:r>
                    </a:p>
                    <a:p>
                      <a:endParaRPr lang="en-US" sz="600" dirty="0" smtClean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</a:t>
                      </a:r>
                      <a:r>
                        <a:rPr lang="en-US" sz="6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KDa Actin</a:t>
                      </a:r>
                      <a:endParaRPr lang="en-US" sz="600" dirty="0" smtClean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13521728"/>
                  </a:ext>
                </a:extLst>
              </a:tr>
              <a:tr h="425037">
                <a:tc rowSpan="2"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lemastine/HI</a:t>
                      </a:r>
                    </a:p>
                    <a:p>
                      <a:pPr algn="ctr"/>
                      <a:endParaRPr lang="en-US" dirty="0"/>
                    </a:p>
                  </a:txBody>
                  <a:tcPr vert="vert27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h</a:t>
                      </a:r>
                      <a:endParaRPr lang="en-US" sz="9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 KDa</a:t>
                      </a:r>
                      <a:r>
                        <a:rPr lang="en-US" sz="6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p38</a:t>
                      </a:r>
                    </a:p>
                    <a:p>
                      <a:endParaRPr lang="en-US" sz="600" baseline="0" dirty="0" smtClean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6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 KDa Actin</a:t>
                      </a:r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49778991"/>
                  </a:ext>
                </a:extLst>
              </a:tr>
              <a:tr h="425037"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8h</a:t>
                      </a:r>
                      <a:endParaRPr lang="en-US" sz="9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 KDa</a:t>
                      </a:r>
                      <a:r>
                        <a:rPr lang="en-US" sz="6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p38</a:t>
                      </a:r>
                    </a:p>
                    <a:p>
                      <a:endParaRPr lang="en-US" sz="600" baseline="0" dirty="0" smtClean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6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 KDa Actin</a:t>
                      </a:r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48463950"/>
                  </a:ext>
                </a:extLst>
              </a:tr>
            </a:tbl>
          </a:graphicData>
        </a:graphic>
      </p:graphicFrame>
      <p:graphicFrame>
        <p:nvGraphicFramePr>
          <p:cNvPr id="290" name="Table 289"/>
          <p:cNvGraphicFramePr>
            <a:graphicFrameLocks noGrp="1"/>
          </p:cNvGraphicFramePr>
          <p:nvPr>
            <p:extLst/>
          </p:nvPr>
        </p:nvGraphicFramePr>
        <p:xfrm>
          <a:off x="2033051" y="3654876"/>
          <a:ext cx="4104523" cy="1678854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61271">
                  <a:extLst>
                    <a:ext uri="{9D8B030D-6E8A-4147-A177-3AD203B41FA5}">
                      <a16:colId xmlns:a16="http://schemas.microsoft.com/office/drawing/2014/main" val="1931613504"/>
                    </a:ext>
                  </a:extLst>
                </a:gridCol>
                <a:gridCol w="386940">
                  <a:extLst>
                    <a:ext uri="{9D8B030D-6E8A-4147-A177-3AD203B41FA5}">
                      <a16:colId xmlns:a16="http://schemas.microsoft.com/office/drawing/2014/main" val="3034343333"/>
                    </a:ext>
                  </a:extLst>
                </a:gridCol>
                <a:gridCol w="1229579">
                  <a:extLst>
                    <a:ext uri="{9D8B030D-6E8A-4147-A177-3AD203B41FA5}">
                      <a16:colId xmlns:a16="http://schemas.microsoft.com/office/drawing/2014/main" val="2610843802"/>
                    </a:ext>
                  </a:extLst>
                </a:gridCol>
                <a:gridCol w="1231900">
                  <a:extLst>
                    <a:ext uri="{9D8B030D-6E8A-4147-A177-3AD203B41FA5}">
                      <a16:colId xmlns:a16="http://schemas.microsoft.com/office/drawing/2014/main" val="1870459983"/>
                    </a:ext>
                  </a:extLst>
                </a:gridCol>
                <a:gridCol w="208280">
                  <a:extLst>
                    <a:ext uri="{9D8B030D-6E8A-4147-A177-3AD203B41FA5}">
                      <a16:colId xmlns:a16="http://schemas.microsoft.com/office/drawing/2014/main" val="3213023867"/>
                    </a:ext>
                  </a:extLst>
                </a:gridCol>
                <a:gridCol w="786553">
                  <a:extLst>
                    <a:ext uri="{9D8B030D-6E8A-4147-A177-3AD203B41FA5}">
                      <a16:colId xmlns:a16="http://schemas.microsoft.com/office/drawing/2014/main" val="3381088522"/>
                    </a:ext>
                  </a:extLst>
                </a:gridCol>
              </a:tblGrid>
              <a:tr h="403743">
                <a:tc rowSpan="2">
                  <a:txBody>
                    <a:bodyPr/>
                    <a:lstStyle/>
                    <a:p>
                      <a:pPr algn="ctr"/>
                      <a:r>
                        <a:rPr lang="en-US" sz="9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ehicle/HI</a:t>
                      </a:r>
                      <a:endParaRPr lang="en-US" sz="9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vert="vert27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h</a:t>
                      </a:r>
                      <a:endParaRPr lang="en-US" sz="9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en-US" sz="6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6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 KDa p38</a:t>
                      </a:r>
                    </a:p>
                    <a:p>
                      <a:endParaRPr lang="en-US" sz="600" b="0" dirty="0" smtClean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6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 KDa Actin</a:t>
                      </a:r>
                      <a:endParaRPr lang="en-US" sz="6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05222174"/>
                  </a:ext>
                </a:extLst>
              </a:tr>
              <a:tr h="425037"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8h</a:t>
                      </a:r>
                      <a:endParaRPr lang="en-US" sz="9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 KDa p38</a:t>
                      </a:r>
                    </a:p>
                    <a:p>
                      <a:endParaRPr lang="en-US" sz="600" dirty="0" smtClean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</a:t>
                      </a:r>
                      <a:r>
                        <a:rPr lang="en-US" sz="6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KDa Actin</a:t>
                      </a:r>
                      <a:endParaRPr lang="en-US" sz="600" dirty="0" smtClean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13521728"/>
                  </a:ext>
                </a:extLst>
              </a:tr>
              <a:tr h="425037">
                <a:tc rowSpan="2"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lemastine/HI</a:t>
                      </a:r>
                    </a:p>
                    <a:p>
                      <a:pPr algn="ctr"/>
                      <a:endParaRPr lang="en-US" dirty="0"/>
                    </a:p>
                  </a:txBody>
                  <a:tcPr vert="vert27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h</a:t>
                      </a:r>
                      <a:endParaRPr lang="en-US" sz="9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 KDa</a:t>
                      </a:r>
                      <a:r>
                        <a:rPr lang="en-US" sz="6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p38</a:t>
                      </a:r>
                    </a:p>
                    <a:p>
                      <a:endParaRPr lang="en-US" sz="600" baseline="0" dirty="0" smtClean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6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 KDa Actin</a:t>
                      </a:r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49778991"/>
                  </a:ext>
                </a:extLst>
              </a:tr>
              <a:tr h="425037"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8h</a:t>
                      </a:r>
                      <a:endParaRPr lang="en-US" sz="9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 KDa</a:t>
                      </a:r>
                      <a:r>
                        <a:rPr lang="en-US" sz="6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p38</a:t>
                      </a:r>
                    </a:p>
                    <a:p>
                      <a:endParaRPr lang="en-US" sz="600" baseline="0" dirty="0" smtClean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6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 KDa Actin</a:t>
                      </a:r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48463950"/>
                  </a:ext>
                </a:extLst>
              </a:tr>
            </a:tbl>
          </a:graphicData>
        </a:graphic>
      </p:graphicFrame>
      <p:sp>
        <p:nvSpPr>
          <p:cNvPr id="2" name="TextBox 1"/>
          <p:cNvSpPr txBox="1"/>
          <p:nvPr/>
        </p:nvSpPr>
        <p:spPr>
          <a:xfrm>
            <a:off x="146392" y="279318"/>
            <a:ext cx="21621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upplementary Fig. 5</a:t>
            </a:r>
            <a:endParaRPr lang="en-US" dirty="0"/>
          </a:p>
        </p:txBody>
      </p:sp>
      <p:sp>
        <p:nvSpPr>
          <p:cNvPr id="21" name="TextBox 20"/>
          <p:cNvSpPr txBox="1"/>
          <p:nvPr/>
        </p:nvSpPr>
        <p:spPr>
          <a:xfrm>
            <a:off x="66337" y="696744"/>
            <a:ext cx="27122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a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100825" y="3135165"/>
            <a:ext cx="27924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b</a:t>
            </a:r>
          </a:p>
        </p:txBody>
      </p:sp>
      <p:sp>
        <p:nvSpPr>
          <p:cNvPr id="38" name="TextBox 37"/>
          <p:cNvSpPr txBox="1"/>
          <p:nvPr/>
        </p:nvSpPr>
        <p:spPr>
          <a:xfrm>
            <a:off x="2178583" y="3137751"/>
            <a:ext cx="2600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c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78359" y="5344706"/>
            <a:ext cx="27924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d</a:t>
            </a:r>
          </a:p>
        </p:txBody>
      </p:sp>
      <p:pic>
        <p:nvPicPr>
          <p:cNvPr id="40" name="Picture 39"/>
          <p:cNvPicPr>
            <a:picLocks noChangeAspect="1"/>
          </p:cNvPicPr>
          <p:nvPr/>
        </p:nvPicPr>
        <p:blipFill rotWithShape="1">
          <a:blip r:embed="rId3"/>
          <a:srcRect r="7798"/>
          <a:stretch/>
        </p:blipFill>
        <p:spPr>
          <a:xfrm>
            <a:off x="2690484" y="6535271"/>
            <a:ext cx="1132868" cy="261015"/>
          </a:xfrm>
          <a:prstGeom prst="rect">
            <a:avLst/>
          </a:prstGeom>
        </p:spPr>
      </p:pic>
      <p:pic>
        <p:nvPicPr>
          <p:cNvPr id="44" name="Picture 4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671571" y="5709169"/>
            <a:ext cx="1207633" cy="261654"/>
          </a:xfrm>
          <a:prstGeom prst="rect">
            <a:avLst/>
          </a:prstGeom>
        </p:spPr>
      </p:pic>
      <p:graphicFrame>
        <p:nvGraphicFramePr>
          <p:cNvPr id="91" name="Object 90"/>
          <p:cNvGraphicFramePr>
            <a:graphicFrameLocks noChangeAspect="1"/>
          </p:cNvGraphicFramePr>
          <p:nvPr>
            <p:extLst/>
          </p:nvPr>
        </p:nvGraphicFramePr>
        <p:xfrm>
          <a:off x="-823902" y="5363325"/>
          <a:ext cx="4059238" cy="18669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65" name="Prism 10" r:id="rId5" imgW="6178975" imgH="2825339" progId="Prism10.Document">
                  <p:embed/>
                </p:oleObj>
              </mc:Choice>
              <mc:Fallback>
                <p:oleObj name="Prism 10" r:id="rId5" imgW="6178975" imgH="2825339" progId="Prism10.Document">
                  <p:embed/>
                  <p:pic>
                    <p:nvPicPr>
                      <p:cNvPr id="91" name="Object 90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-823902" y="5363325"/>
                        <a:ext cx="4059238" cy="18669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233" name="Picture 232"/>
          <p:cNvPicPr>
            <a:picLocks noChangeAspect="1"/>
          </p:cNvPicPr>
          <p:nvPr/>
        </p:nvPicPr>
        <p:blipFill rotWithShape="1">
          <a:blip r:embed="rId7"/>
          <a:srcRect t="15221"/>
          <a:stretch/>
        </p:blipFill>
        <p:spPr>
          <a:xfrm>
            <a:off x="2713734" y="11039982"/>
            <a:ext cx="1188720" cy="254953"/>
          </a:xfrm>
          <a:prstGeom prst="rect">
            <a:avLst/>
          </a:prstGeom>
        </p:spPr>
      </p:pic>
      <p:pic>
        <p:nvPicPr>
          <p:cNvPr id="234" name="Picture 233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945396" y="11020575"/>
            <a:ext cx="1154108" cy="246336"/>
          </a:xfrm>
          <a:prstGeom prst="rect">
            <a:avLst/>
          </a:prstGeom>
        </p:spPr>
      </p:pic>
      <p:pic>
        <p:nvPicPr>
          <p:cNvPr id="235" name="Picture 234"/>
          <p:cNvPicPr>
            <a:picLocks noChangeAspect="1"/>
          </p:cNvPicPr>
          <p:nvPr/>
        </p:nvPicPr>
        <p:blipFill rotWithShape="1">
          <a:blip r:embed="rId9"/>
          <a:srcRect t="24938" r="8387" b="3069"/>
          <a:stretch/>
        </p:blipFill>
        <p:spPr>
          <a:xfrm>
            <a:off x="2690484" y="10240243"/>
            <a:ext cx="1188720" cy="219229"/>
          </a:xfrm>
          <a:prstGeom prst="rect">
            <a:avLst/>
          </a:prstGeom>
        </p:spPr>
      </p:pic>
      <p:pic>
        <p:nvPicPr>
          <p:cNvPr id="236" name="Picture 235"/>
          <p:cNvPicPr>
            <a:picLocks noChangeAspect="1"/>
          </p:cNvPicPr>
          <p:nvPr/>
        </p:nvPicPr>
        <p:blipFill rotWithShape="1">
          <a:blip r:embed="rId10"/>
          <a:srcRect t="18419" r="9304" b="3195"/>
          <a:stretch/>
        </p:blipFill>
        <p:spPr>
          <a:xfrm>
            <a:off x="3920278" y="10254610"/>
            <a:ext cx="1188720" cy="190496"/>
          </a:xfrm>
          <a:prstGeom prst="rect">
            <a:avLst/>
          </a:prstGeom>
        </p:spPr>
      </p:pic>
      <p:pic>
        <p:nvPicPr>
          <p:cNvPr id="237" name="Picture 236"/>
          <p:cNvPicPr>
            <a:picLocks noChangeAspect="1"/>
          </p:cNvPicPr>
          <p:nvPr/>
        </p:nvPicPr>
        <p:blipFill rotWithShape="1">
          <a:blip r:embed="rId11"/>
          <a:srcRect t="29007" r="12057"/>
          <a:stretch/>
        </p:blipFill>
        <p:spPr>
          <a:xfrm>
            <a:off x="2690484" y="11474181"/>
            <a:ext cx="1188720" cy="289393"/>
          </a:xfrm>
          <a:prstGeom prst="rect">
            <a:avLst/>
          </a:prstGeom>
        </p:spPr>
      </p:pic>
      <p:pic>
        <p:nvPicPr>
          <p:cNvPr id="238" name="Picture 237"/>
          <p:cNvPicPr>
            <a:picLocks noChangeAspect="1"/>
          </p:cNvPicPr>
          <p:nvPr/>
        </p:nvPicPr>
        <p:blipFill rotWithShape="1">
          <a:blip r:embed="rId12"/>
          <a:srcRect t="15544" r="10875"/>
          <a:stretch/>
        </p:blipFill>
        <p:spPr>
          <a:xfrm>
            <a:off x="3926210" y="11434271"/>
            <a:ext cx="1188720" cy="315886"/>
          </a:xfrm>
          <a:prstGeom prst="rect">
            <a:avLst/>
          </a:prstGeom>
        </p:spPr>
      </p:pic>
      <p:pic>
        <p:nvPicPr>
          <p:cNvPr id="239" name="Picture 238"/>
          <p:cNvPicPr>
            <a:picLocks noChangeAspect="1"/>
          </p:cNvPicPr>
          <p:nvPr/>
        </p:nvPicPr>
        <p:blipFill rotWithShape="1">
          <a:blip r:embed="rId13"/>
          <a:srcRect t="23591"/>
          <a:stretch/>
        </p:blipFill>
        <p:spPr>
          <a:xfrm>
            <a:off x="2690484" y="10637097"/>
            <a:ext cx="1188720" cy="217143"/>
          </a:xfrm>
          <a:prstGeom prst="rect">
            <a:avLst/>
          </a:prstGeom>
        </p:spPr>
      </p:pic>
      <p:pic>
        <p:nvPicPr>
          <p:cNvPr id="240" name="Picture 239"/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3959011" y="10587853"/>
            <a:ext cx="1151445" cy="307111"/>
          </a:xfrm>
          <a:prstGeom prst="rect">
            <a:avLst/>
          </a:prstGeom>
        </p:spPr>
      </p:pic>
      <p:sp>
        <p:nvSpPr>
          <p:cNvPr id="241" name="Textfeld 32"/>
          <p:cNvSpPr txBox="1"/>
          <p:nvPr/>
        </p:nvSpPr>
        <p:spPr>
          <a:xfrm>
            <a:off x="98397" y="7669896"/>
            <a:ext cx="23916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f</a:t>
            </a:r>
          </a:p>
        </p:txBody>
      </p:sp>
      <p:sp>
        <p:nvSpPr>
          <p:cNvPr id="242" name="Textfeld 42"/>
          <p:cNvSpPr txBox="1"/>
          <p:nvPr/>
        </p:nvSpPr>
        <p:spPr>
          <a:xfrm>
            <a:off x="78359" y="9889383"/>
            <a:ext cx="27924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h</a:t>
            </a:r>
          </a:p>
        </p:txBody>
      </p:sp>
      <p:sp>
        <p:nvSpPr>
          <p:cNvPr id="263" name="TextBox 262"/>
          <p:cNvSpPr txBox="1"/>
          <p:nvPr/>
        </p:nvSpPr>
        <p:spPr>
          <a:xfrm>
            <a:off x="2179590" y="5315231"/>
            <a:ext cx="2744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e</a:t>
            </a:r>
            <a:endParaRPr lang="en-US" sz="1400" dirty="0"/>
          </a:p>
        </p:txBody>
      </p:sp>
      <p:sp>
        <p:nvSpPr>
          <p:cNvPr id="264" name="TextBox 263"/>
          <p:cNvSpPr txBox="1"/>
          <p:nvPr/>
        </p:nvSpPr>
        <p:spPr>
          <a:xfrm>
            <a:off x="2167096" y="7647863"/>
            <a:ext cx="26962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g</a:t>
            </a:r>
            <a:endParaRPr lang="en-US" sz="1400" dirty="0"/>
          </a:p>
        </p:txBody>
      </p:sp>
      <p:graphicFrame>
        <p:nvGraphicFramePr>
          <p:cNvPr id="171" name="Objekt 170"/>
          <p:cNvGraphicFramePr>
            <a:graphicFrameLocks noChangeAspect="1"/>
          </p:cNvGraphicFramePr>
          <p:nvPr>
            <p:extLst/>
          </p:nvPr>
        </p:nvGraphicFramePr>
        <p:xfrm>
          <a:off x="20638" y="3338513"/>
          <a:ext cx="1892300" cy="16367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66" name="Prism 10" r:id="rId15" imgW="2845079" imgH="2457818" progId="Prism10.Document">
                  <p:embed/>
                </p:oleObj>
              </mc:Choice>
              <mc:Fallback>
                <p:oleObj name="Prism 10" r:id="rId15" imgW="2845079" imgH="2457818" progId="Prism10.Document">
                  <p:embed/>
                  <p:pic>
                    <p:nvPicPr>
                      <p:cNvPr id="171" name="Objekt 170"/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20638" y="3338513"/>
                        <a:ext cx="1892300" cy="16367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74" name="Objekt 173"/>
          <p:cNvGraphicFramePr>
            <a:graphicFrameLocks noChangeAspect="1"/>
          </p:cNvGraphicFramePr>
          <p:nvPr>
            <p:extLst/>
          </p:nvPr>
        </p:nvGraphicFramePr>
        <p:xfrm>
          <a:off x="85725" y="10017125"/>
          <a:ext cx="1885950" cy="1828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67" name="Prism 10" r:id="rId17" imgW="2715495" imgH="2631679" progId="Prism10.Document">
                  <p:embed/>
                </p:oleObj>
              </mc:Choice>
              <mc:Fallback>
                <p:oleObj name="Prism 10" r:id="rId17" imgW="2715495" imgH="2631679" progId="Prism10.Document">
                  <p:embed/>
                  <p:pic>
                    <p:nvPicPr>
                      <p:cNvPr id="174" name="Objekt 173"/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85725" y="10017125"/>
                        <a:ext cx="1885950" cy="1828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75" name="Objekt 174"/>
          <p:cNvGraphicFramePr>
            <a:graphicFrameLocks noChangeAspect="1"/>
          </p:cNvGraphicFramePr>
          <p:nvPr>
            <p:extLst/>
          </p:nvPr>
        </p:nvGraphicFramePr>
        <p:xfrm>
          <a:off x="36513" y="7856538"/>
          <a:ext cx="1912937" cy="16668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68" name="Prism 10" r:id="rId19" imgW="2799364" imgH="2435140" progId="Prism10.Document">
                  <p:embed/>
                </p:oleObj>
              </mc:Choice>
              <mc:Fallback>
                <p:oleObj name="Prism 10" r:id="rId19" imgW="2799364" imgH="2435140" progId="Prism10.Document">
                  <p:embed/>
                  <p:pic>
                    <p:nvPicPr>
                      <p:cNvPr id="175" name="Objekt 174"/>
                      <p:cNvPicPr/>
                      <p:nvPr/>
                    </p:nvPicPr>
                    <p:blipFill>
                      <a:blip r:embed="rId20"/>
                      <a:stretch>
                        <a:fillRect/>
                      </a:stretch>
                    </p:blipFill>
                    <p:spPr>
                      <a:xfrm>
                        <a:off x="36513" y="7856538"/>
                        <a:ext cx="1912937" cy="16668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72" name="Rectangle 171"/>
          <p:cNvSpPr/>
          <p:nvPr/>
        </p:nvSpPr>
        <p:spPr>
          <a:xfrm>
            <a:off x="54116" y="3148663"/>
            <a:ext cx="6703612" cy="4422617"/>
          </a:xfrm>
          <a:prstGeom prst="rect">
            <a:avLst/>
          </a:prstGeom>
          <a:noFill/>
          <a:ln>
            <a:solidFill>
              <a:schemeClr val="bg1">
                <a:lumMod val="6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3" name="Rectangle 172"/>
          <p:cNvSpPr/>
          <p:nvPr/>
        </p:nvSpPr>
        <p:spPr>
          <a:xfrm>
            <a:off x="54116" y="7575080"/>
            <a:ext cx="6703612" cy="4519509"/>
          </a:xfrm>
          <a:prstGeom prst="rect">
            <a:avLst/>
          </a:prstGeom>
          <a:noFill/>
          <a:ln>
            <a:solidFill>
              <a:schemeClr val="bg1">
                <a:lumMod val="6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84" name="TextBox 183"/>
          <p:cNvSpPr txBox="1"/>
          <p:nvPr/>
        </p:nvSpPr>
        <p:spPr>
          <a:xfrm>
            <a:off x="6157371" y="3134556"/>
            <a:ext cx="6003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Cortex</a:t>
            </a:r>
          </a:p>
        </p:txBody>
      </p:sp>
      <p:sp>
        <p:nvSpPr>
          <p:cNvPr id="200" name="TextBox 199"/>
          <p:cNvSpPr txBox="1"/>
          <p:nvPr/>
        </p:nvSpPr>
        <p:spPr>
          <a:xfrm>
            <a:off x="5739795" y="7525635"/>
            <a:ext cx="10622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Hippocampus</a:t>
            </a:r>
            <a:endParaRPr lang="en-US" sz="1200" b="1" dirty="0"/>
          </a:p>
        </p:txBody>
      </p:sp>
      <p:grpSp>
        <p:nvGrpSpPr>
          <p:cNvPr id="211" name="Group 210"/>
          <p:cNvGrpSpPr/>
          <p:nvPr/>
        </p:nvGrpSpPr>
        <p:grpSpPr>
          <a:xfrm>
            <a:off x="263134" y="4821393"/>
            <a:ext cx="1050979" cy="379475"/>
            <a:chOff x="2024063" y="1101666"/>
            <a:chExt cx="1050979" cy="379475"/>
          </a:xfrm>
        </p:grpSpPr>
        <p:sp>
          <p:nvSpPr>
            <p:cNvPr id="213" name="Oval 212"/>
            <p:cNvSpPr/>
            <p:nvPr/>
          </p:nvSpPr>
          <p:spPr>
            <a:xfrm>
              <a:off x="2024063" y="1211475"/>
              <a:ext cx="53353" cy="48459"/>
            </a:xfrm>
            <a:prstGeom prst="ellipse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14" name="Rectangle 213"/>
            <p:cNvSpPr/>
            <p:nvPr/>
          </p:nvSpPr>
          <p:spPr>
            <a:xfrm>
              <a:off x="2027879" y="1337889"/>
              <a:ext cx="45719" cy="4571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15" name="TextBox 214"/>
            <p:cNvSpPr txBox="1"/>
            <p:nvPr/>
          </p:nvSpPr>
          <p:spPr>
            <a:xfrm>
              <a:off x="2042340" y="1101666"/>
              <a:ext cx="800219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Vehicle/HI</a:t>
              </a:r>
              <a:endParaRPr lang="en-US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6" name="TextBox 215"/>
            <p:cNvSpPr txBox="1"/>
            <p:nvPr/>
          </p:nvSpPr>
          <p:spPr>
            <a:xfrm>
              <a:off x="2042387" y="1227225"/>
              <a:ext cx="1032655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lemastine/HI</a:t>
              </a:r>
              <a:endParaRPr lang="en-US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68" name="Group 267"/>
          <p:cNvGrpSpPr/>
          <p:nvPr/>
        </p:nvGrpSpPr>
        <p:grpSpPr>
          <a:xfrm>
            <a:off x="280469" y="7144399"/>
            <a:ext cx="1050979" cy="379475"/>
            <a:chOff x="2024063" y="1101666"/>
            <a:chExt cx="1050979" cy="379475"/>
          </a:xfrm>
        </p:grpSpPr>
        <p:sp>
          <p:nvSpPr>
            <p:cNvPr id="269" name="Oval 268"/>
            <p:cNvSpPr/>
            <p:nvPr/>
          </p:nvSpPr>
          <p:spPr>
            <a:xfrm>
              <a:off x="2024063" y="1211475"/>
              <a:ext cx="53353" cy="48459"/>
            </a:xfrm>
            <a:prstGeom prst="ellipse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70" name="Rectangle 269"/>
            <p:cNvSpPr/>
            <p:nvPr/>
          </p:nvSpPr>
          <p:spPr>
            <a:xfrm>
              <a:off x="2027879" y="1337889"/>
              <a:ext cx="45719" cy="4571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71" name="TextBox 270"/>
            <p:cNvSpPr txBox="1"/>
            <p:nvPr/>
          </p:nvSpPr>
          <p:spPr>
            <a:xfrm>
              <a:off x="2042340" y="1101666"/>
              <a:ext cx="800219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Vehicle/HI</a:t>
              </a:r>
              <a:endParaRPr lang="en-US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2" name="TextBox 271"/>
            <p:cNvSpPr txBox="1"/>
            <p:nvPr/>
          </p:nvSpPr>
          <p:spPr>
            <a:xfrm>
              <a:off x="2042387" y="1227225"/>
              <a:ext cx="1032655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lemastine/HI</a:t>
              </a:r>
              <a:endParaRPr lang="en-US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73" name="Group 272"/>
          <p:cNvGrpSpPr/>
          <p:nvPr/>
        </p:nvGrpSpPr>
        <p:grpSpPr>
          <a:xfrm>
            <a:off x="236459" y="9412375"/>
            <a:ext cx="1050979" cy="379475"/>
            <a:chOff x="2024063" y="1101666"/>
            <a:chExt cx="1050979" cy="379475"/>
          </a:xfrm>
        </p:grpSpPr>
        <p:sp>
          <p:nvSpPr>
            <p:cNvPr id="274" name="Oval 273"/>
            <p:cNvSpPr/>
            <p:nvPr/>
          </p:nvSpPr>
          <p:spPr>
            <a:xfrm>
              <a:off x="2024063" y="1211475"/>
              <a:ext cx="53353" cy="48459"/>
            </a:xfrm>
            <a:prstGeom prst="ellipse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75" name="Rectangle 274"/>
            <p:cNvSpPr/>
            <p:nvPr/>
          </p:nvSpPr>
          <p:spPr>
            <a:xfrm>
              <a:off x="2027879" y="1337889"/>
              <a:ext cx="45719" cy="4571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76" name="TextBox 275"/>
            <p:cNvSpPr txBox="1"/>
            <p:nvPr/>
          </p:nvSpPr>
          <p:spPr>
            <a:xfrm>
              <a:off x="2042340" y="1101666"/>
              <a:ext cx="800219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Vehicle/HI</a:t>
              </a:r>
              <a:endParaRPr lang="en-US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7" name="TextBox 276"/>
            <p:cNvSpPr txBox="1"/>
            <p:nvPr/>
          </p:nvSpPr>
          <p:spPr>
            <a:xfrm>
              <a:off x="2042387" y="1227225"/>
              <a:ext cx="1032655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lemastine/HI</a:t>
              </a:r>
              <a:endParaRPr lang="en-US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78" name="Group 277"/>
          <p:cNvGrpSpPr/>
          <p:nvPr/>
        </p:nvGrpSpPr>
        <p:grpSpPr>
          <a:xfrm>
            <a:off x="241986" y="11681040"/>
            <a:ext cx="1050979" cy="379475"/>
            <a:chOff x="2024063" y="1101666"/>
            <a:chExt cx="1050979" cy="379475"/>
          </a:xfrm>
        </p:grpSpPr>
        <p:sp>
          <p:nvSpPr>
            <p:cNvPr id="279" name="Oval 278"/>
            <p:cNvSpPr/>
            <p:nvPr/>
          </p:nvSpPr>
          <p:spPr>
            <a:xfrm>
              <a:off x="2024063" y="1211475"/>
              <a:ext cx="53353" cy="48459"/>
            </a:xfrm>
            <a:prstGeom prst="ellipse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0" name="Rectangle 279"/>
            <p:cNvSpPr/>
            <p:nvPr/>
          </p:nvSpPr>
          <p:spPr>
            <a:xfrm>
              <a:off x="2027879" y="1337889"/>
              <a:ext cx="45719" cy="4571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1" name="TextBox 280"/>
            <p:cNvSpPr txBox="1"/>
            <p:nvPr/>
          </p:nvSpPr>
          <p:spPr>
            <a:xfrm>
              <a:off x="2042340" y="1101666"/>
              <a:ext cx="800219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Vehicle/HI</a:t>
              </a:r>
              <a:endParaRPr lang="en-US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2" name="TextBox 281"/>
            <p:cNvSpPr txBox="1"/>
            <p:nvPr/>
          </p:nvSpPr>
          <p:spPr>
            <a:xfrm>
              <a:off x="2042387" y="1227225"/>
              <a:ext cx="1032655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lemastine/HI</a:t>
              </a:r>
              <a:endParaRPr lang="en-US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65" name="Textfeld 42"/>
          <p:cNvSpPr txBox="1"/>
          <p:nvPr/>
        </p:nvSpPr>
        <p:spPr>
          <a:xfrm>
            <a:off x="2142497" y="9889382"/>
            <a:ext cx="22634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i</a:t>
            </a:r>
          </a:p>
        </p:txBody>
      </p:sp>
      <p:sp>
        <p:nvSpPr>
          <p:cNvPr id="266" name="Rectangle 265"/>
          <p:cNvSpPr/>
          <p:nvPr/>
        </p:nvSpPr>
        <p:spPr>
          <a:xfrm>
            <a:off x="54116" y="780888"/>
            <a:ext cx="4781138" cy="2359844"/>
          </a:xfrm>
          <a:prstGeom prst="rect">
            <a:avLst/>
          </a:prstGeom>
          <a:noFill/>
          <a:ln>
            <a:solidFill>
              <a:schemeClr val="bg1">
                <a:lumMod val="6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316" name="Straight Connector 315"/>
          <p:cNvCxnSpPr/>
          <p:nvPr/>
        </p:nvCxnSpPr>
        <p:spPr>
          <a:xfrm>
            <a:off x="5147821" y="3713800"/>
            <a:ext cx="12427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8" name="Straight Connector 317"/>
          <p:cNvCxnSpPr/>
          <p:nvPr/>
        </p:nvCxnSpPr>
        <p:spPr>
          <a:xfrm>
            <a:off x="5147821" y="3909902"/>
            <a:ext cx="12427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9" name="Straight Connector 318"/>
          <p:cNvCxnSpPr/>
          <p:nvPr/>
        </p:nvCxnSpPr>
        <p:spPr>
          <a:xfrm>
            <a:off x="5147821" y="4174194"/>
            <a:ext cx="12427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1" name="Straight Connector 320"/>
          <p:cNvCxnSpPr/>
          <p:nvPr/>
        </p:nvCxnSpPr>
        <p:spPr>
          <a:xfrm>
            <a:off x="5147821" y="4370296"/>
            <a:ext cx="12427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2" name="Straight Connector 321"/>
          <p:cNvCxnSpPr/>
          <p:nvPr/>
        </p:nvCxnSpPr>
        <p:spPr>
          <a:xfrm>
            <a:off x="5147821" y="4585081"/>
            <a:ext cx="12427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9" name="Straight Connector 328"/>
          <p:cNvCxnSpPr/>
          <p:nvPr/>
        </p:nvCxnSpPr>
        <p:spPr>
          <a:xfrm>
            <a:off x="5147821" y="4781183"/>
            <a:ext cx="12427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0" name="Straight Connector 329"/>
          <p:cNvCxnSpPr/>
          <p:nvPr/>
        </p:nvCxnSpPr>
        <p:spPr>
          <a:xfrm>
            <a:off x="5147821" y="4996318"/>
            <a:ext cx="12427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2" name="Straight Connector 331"/>
          <p:cNvCxnSpPr/>
          <p:nvPr/>
        </p:nvCxnSpPr>
        <p:spPr>
          <a:xfrm>
            <a:off x="5147821" y="5192420"/>
            <a:ext cx="12427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3" name="TextBox 332"/>
          <p:cNvSpPr txBox="1"/>
          <p:nvPr/>
        </p:nvSpPr>
        <p:spPr>
          <a:xfrm>
            <a:off x="3103581" y="3469134"/>
            <a:ext cx="42832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total</a:t>
            </a:r>
          </a:p>
        </p:txBody>
      </p:sp>
      <p:sp>
        <p:nvSpPr>
          <p:cNvPr id="334" name="TextBox 333"/>
          <p:cNvSpPr txBox="1"/>
          <p:nvPr/>
        </p:nvSpPr>
        <p:spPr>
          <a:xfrm>
            <a:off x="4196938" y="3449003"/>
            <a:ext cx="63831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/>
              <a:t>phospho</a:t>
            </a:r>
            <a:endParaRPr lang="en-US" sz="1000" dirty="0"/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21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706171" y="3708331"/>
            <a:ext cx="1188720" cy="98766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22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690484" y="3874257"/>
            <a:ext cx="1188720" cy="113935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>
          <a:blip r:embed="rId23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942362" y="3687875"/>
            <a:ext cx="1188720" cy="113772"/>
          </a:xfrm>
          <a:prstGeom prst="rect">
            <a:avLst/>
          </a:prstGeom>
        </p:spPr>
      </p:pic>
      <p:pic>
        <p:nvPicPr>
          <p:cNvPr id="13" name="Picture 12"/>
          <p:cNvPicPr>
            <a:picLocks noChangeAspect="1"/>
          </p:cNvPicPr>
          <p:nvPr/>
        </p:nvPicPr>
        <p:blipFill>
          <a:blip r:embed="rId24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920278" y="3853649"/>
            <a:ext cx="1188720" cy="139393"/>
          </a:xfrm>
          <a:prstGeom prst="rect">
            <a:avLst/>
          </a:prstGeom>
        </p:spPr>
      </p:pic>
      <p:pic>
        <p:nvPicPr>
          <p:cNvPr id="15" name="Picture 14"/>
          <p:cNvPicPr>
            <a:picLocks noChangeAspect="1"/>
          </p:cNvPicPr>
          <p:nvPr/>
        </p:nvPicPr>
        <p:blipFill>
          <a:blip r:embed="rId25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921756" y="4554515"/>
            <a:ext cx="1188720" cy="119582"/>
          </a:xfrm>
          <a:prstGeom prst="rect">
            <a:avLst/>
          </a:prstGeom>
        </p:spPr>
      </p:pic>
      <p:pic>
        <p:nvPicPr>
          <p:cNvPr id="16" name="Picture 15"/>
          <p:cNvPicPr>
            <a:picLocks noChangeAspect="1"/>
          </p:cNvPicPr>
          <p:nvPr/>
        </p:nvPicPr>
        <p:blipFill>
          <a:blip r:embed="rId26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926210" y="4714111"/>
            <a:ext cx="1188720" cy="118872"/>
          </a:xfrm>
          <a:prstGeom prst="rect">
            <a:avLst/>
          </a:prstGeom>
        </p:spPr>
      </p:pic>
      <p:pic>
        <p:nvPicPr>
          <p:cNvPr id="17" name="Picture 16"/>
          <p:cNvPicPr>
            <a:picLocks noChangeAspect="1"/>
          </p:cNvPicPr>
          <p:nvPr/>
        </p:nvPicPr>
        <p:blipFill>
          <a:blip r:embed="rId27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703153" y="4543386"/>
            <a:ext cx="1188720" cy="159486"/>
          </a:xfrm>
          <a:prstGeom prst="rect">
            <a:avLst/>
          </a:prstGeom>
        </p:spPr>
      </p:pic>
      <p:pic>
        <p:nvPicPr>
          <p:cNvPr id="18" name="Picture 17"/>
          <p:cNvPicPr>
            <a:picLocks noChangeAspect="1"/>
          </p:cNvPicPr>
          <p:nvPr/>
        </p:nvPicPr>
        <p:blipFill>
          <a:blip r:embed="rId28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703153" y="4720018"/>
            <a:ext cx="1188720" cy="101516"/>
          </a:xfrm>
          <a:prstGeom prst="rect">
            <a:avLst/>
          </a:prstGeom>
        </p:spPr>
      </p:pic>
      <p:pic>
        <p:nvPicPr>
          <p:cNvPr id="23" name="Picture 22"/>
          <p:cNvPicPr>
            <a:picLocks noChangeAspect="1"/>
          </p:cNvPicPr>
          <p:nvPr/>
        </p:nvPicPr>
        <p:blipFill>
          <a:blip r:embed="rId29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921756" y="4130005"/>
            <a:ext cx="1188720" cy="89983"/>
          </a:xfrm>
          <a:prstGeom prst="rect">
            <a:avLst/>
          </a:prstGeom>
        </p:spPr>
      </p:pic>
      <p:pic>
        <p:nvPicPr>
          <p:cNvPr id="24" name="Picture 23"/>
          <p:cNvPicPr>
            <a:picLocks noChangeAspect="1"/>
          </p:cNvPicPr>
          <p:nvPr/>
        </p:nvPicPr>
        <p:blipFill>
          <a:blip r:embed="rId30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938612" y="4321707"/>
            <a:ext cx="1188720" cy="101168"/>
          </a:xfrm>
          <a:prstGeom prst="rect">
            <a:avLst/>
          </a:prstGeom>
        </p:spPr>
      </p:pic>
      <p:pic>
        <p:nvPicPr>
          <p:cNvPr id="25" name="Picture 24"/>
          <p:cNvPicPr>
            <a:picLocks noChangeAspect="1"/>
          </p:cNvPicPr>
          <p:nvPr/>
        </p:nvPicPr>
        <p:blipFill>
          <a:blip r:embed="rId31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706171" y="4311527"/>
            <a:ext cx="1188720" cy="115324"/>
          </a:xfrm>
          <a:prstGeom prst="rect">
            <a:avLst/>
          </a:prstGeom>
        </p:spPr>
      </p:pic>
      <p:pic>
        <p:nvPicPr>
          <p:cNvPr id="26" name="Picture 25"/>
          <p:cNvPicPr>
            <a:picLocks noChangeAspect="1"/>
          </p:cNvPicPr>
          <p:nvPr/>
        </p:nvPicPr>
        <p:blipFill>
          <a:blip r:embed="rId32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690484" y="4110471"/>
            <a:ext cx="1188720" cy="125128"/>
          </a:xfrm>
          <a:prstGeom prst="rect">
            <a:avLst/>
          </a:prstGeom>
        </p:spPr>
      </p:pic>
      <p:pic>
        <p:nvPicPr>
          <p:cNvPr id="27" name="Picture 26"/>
          <p:cNvPicPr>
            <a:picLocks noChangeAspect="1"/>
          </p:cNvPicPr>
          <p:nvPr/>
        </p:nvPicPr>
        <p:blipFill>
          <a:blip r:embed="rId33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942362" y="5123059"/>
            <a:ext cx="1188720" cy="109009"/>
          </a:xfrm>
          <a:prstGeom prst="rect">
            <a:avLst/>
          </a:prstGeom>
        </p:spPr>
      </p:pic>
      <p:pic>
        <p:nvPicPr>
          <p:cNvPr id="28" name="Picture 27"/>
          <p:cNvPicPr>
            <a:picLocks noChangeAspect="1"/>
          </p:cNvPicPr>
          <p:nvPr/>
        </p:nvPicPr>
        <p:blipFill>
          <a:blip r:embed="rId34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942282" y="4931659"/>
            <a:ext cx="1188720" cy="144714"/>
          </a:xfrm>
          <a:prstGeom prst="rect">
            <a:avLst/>
          </a:prstGeom>
        </p:spPr>
      </p:pic>
      <p:pic>
        <p:nvPicPr>
          <p:cNvPr id="30" name="Picture 29"/>
          <p:cNvPicPr>
            <a:picLocks noChangeAspect="1"/>
          </p:cNvPicPr>
          <p:nvPr/>
        </p:nvPicPr>
        <p:blipFill>
          <a:blip r:embed="rId35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709651" y="5121939"/>
            <a:ext cx="1188720" cy="131518"/>
          </a:xfrm>
          <a:prstGeom prst="rect">
            <a:avLst/>
          </a:prstGeom>
        </p:spPr>
      </p:pic>
      <p:pic>
        <p:nvPicPr>
          <p:cNvPr id="31" name="Picture 30"/>
          <p:cNvPicPr>
            <a:picLocks noChangeAspect="1"/>
          </p:cNvPicPr>
          <p:nvPr/>
        </p:nvPicPr>
        <p:blipFill>
          <a:blip r:embed="rId36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713734" y="4920816"/>
            <a:ext cx="1188720" cy="159525"/>
          </a:xfrm>
          <a:prstGeom prst="rect">
            <a:avLst/>
          </a:prstGeom>
        </p:spPr>
      </p:pic>
      <p:graphicFrame>
        <p:nvGraphicFramePr>
          <p:cNvPr id="335" name="Table 334"/>
          <p:cNvGraphicFramePr>
            <a:graphicFrameLocks noGrp="1"/>
          </p:cNvGraphicFramePr>
          <p:nvPr>
            <p:extLst/>
          </p:nvPr>
        </p:nvGraphicFramePr>
        <p:xfrm>
          <a:off x="2033051" y="5651314"/>
          <a:ext cx="4104523" cy="1678854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61271">
                  <a:extLst>
                    <a:ext uri="{9D8B030D-6E8A-4147-A177-3AD203B41FA5}">
                      <a16:colId xmlns:a16="http://schemas.microsoft.com/office/drawing/2014/main" val="1931613504"/>
                    </a:ext>
                  </a:extLst>
                </a:gridCol>
                <a:gridCol w="386940">
                  <a:extLst>
                    <a:ext uri="{9D8B030D-6E8A-4147-A177-3AD203B41FA5}">
                      <a16:colId xmlns:a16="http://schemas.microsoft.com/office/drawing/2014/main" val="3034343333"/>
                    </a:ext>
                  </a:extLst>
                </a:gridCol>
                <a:gridCol w="1229579">
                  <a:extLst>
                    <a:ext uri="{9D8B030D-6E8A-4147-A177-3AD203B41FA5}">
                      <a16:colId xmlns:a16="http://schemas.microsoft.com/office/drawing/2014/main" val="2610843802"/>
                    </a:ext>
                  </a:extLst>
                </a:gridCol>
                <a:gridCol w="1231900">
                  <a:extLst>
                    <a:ext uri="{9D8B030D-6E8A-4147-A177-3AD203B41FA5}">
                      <a16:colId xmlns:a16="http://schemas.microsoft.com/office/drawing/2014/main" val="1870459983"/>
                    </a:ext>
                  </a:extLst>
                </a:gridCol>
                <a:gridCol w="208280">
                  <a:extLst>
                    <a:ext uri="{9D8B030D-6E8A-4147-A177-3AD203B41FA5}">
                      <a16:colId xmlns:a16="http://schemas.microsoft.com/office/drawing/2014/main" val="3213023867"/>
                    </a:ext>
                  </a:extLst>
                </a:gridCol>
                <a:gridCol w="786553">
                  <a:extLst>
                    <a:ext uri="{9D8B030D-6E8A-4147-A177-3AD203B41FA5}">
                      <a16:colId xmlns:a16="http://schemas.microsoft.com/office/drawing/2014/main" val="3381088522"/>
                    </a:ext>
                  </a:extLst>
                </a:gridCol>
              </a:tblGrid>
              <a:tr h="403743">
                <a:tc rowSpan="2">
                  <a:txBody>
                    <a:bodyPr/>
                    <a:lstStyle/>
                    <a:p>
                      <a:pPr algn="ctr"/>
                      <a:r>
                        <a:rPr lang="en-US" sz="9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ehicle/HI</a:t>
                      </a:r>
                      <a:endParaRPr lang="en-US" sz="9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vert="vert27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h</a:t>
                      </a:r>
                      <a:endParaRPr lang="en-US" sz="9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en-US" sz="6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6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6 KDa JNK</a:t>
                      </a:r>
                    </a:p>
                    <a:p>
                      <a:endParaRPr lang="en-US" sz="600" b="0" dirty="0" smtClean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6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 KDa Actin</a:t>
                      </a:r>
                      <a:endParaRPr lang="en-US" sz="6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05222174"/>
                  </a:ext>
                </a:extLst>
              </a:tr>
              <a:tr h="425037"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8h</a:t>
                      </a:r>
                      <a:endParaRPr lang="en-US" sz="9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6 KDa JNK</a:t>
                      </a:r>
                    </a:p>
                    <a:p>
                      <a:endParaRPr lang="en-US" sz="600" dirty="0" smtClean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</a:t>
                      </a:r>
                      <a:r>
                        <a:rPr lang="en-US" sz="6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KDa Actin</a:t>
                      </a:r>
                      <a:endParaRPr lang="en-US" sz="600" dirty="0" smtClean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13521728"/>
                  </a:ext>
                </a:extLst>
              </a:tr>
              <a:tr h="425037">
                <a:tc rowSpan="2"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lemastine/HI</a:t>
                      </a:r>
                    </a:p>
                    <a:p>
                      <a:pPr algn="ctr"/>
                      <a:endParaRPr lang="en-US" dirty="0"/>
                    </a:p>
                  </a:txBody>
                  <a:tcPr vert="vert27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h</a:t>
                      </a:r>
                      <a:endParaRPr lang="en-US" sz="9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6 KDa</a:t>
                      </a:r>
                      <a:r>
                        <a:rPr lang="en-US" sz="6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JNK</a:t>
                      </a:r>
                    </a:p>
                    <a:p>
                      <a:endParaRPr lang="en-US" sz="600" baseline="0" dirty="0" smtClean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6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 KDa Actin</a:t>
                      </a:r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49778991"/>
                  </a:ext>
                </a:extLst>
              </a:tr>
              <a:tr h="425037"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8h</a:t>
                      </a:r>
                      <a:endParaRPr lang="en-US" sz="9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6 KDa</a:t>
                      </a:r>
                      <a:r>
                        <a:rPr lang="en-US" sz="6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JNK</a:t>
                      </a:r>
                    </a:p>
                    <a:p>
                      <a:endParaRPr lang="en-US" sz="600" baseline="0" dirty="0" smtClean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6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 KDa Actin</a:t>
                      </a:r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48463950"/>
                  </a:ext>
                </a:extLst>
              </a:tr>
            </a:tbl>
          </a:graphicData>
        </a:graphic>
      </p:graphicFrame>
      <p:cxnSp>
        <p:nvCxnSpPr>
          <p:cNvPr id="336" name="Straight Connector 335"/>
          <p:cNvCxnSpPr/>
          <p:nvPr/>
        </p:nvCxnSpPr>
        <p:spPr>
          <a:xfrm>
            <a:off x="5147821" y="5765320"/>
            <a:ext cx="12427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7" name="Straight Connector 336"/>
          <p:cNvCxnSpPr/>
          <p:nvPr/>
        </p:nvCxnSpPr>
        <p:spPr>
          <a:xfrm>
            <a:off x="5147821" y="5906340"/>
            <a:ext cx="12427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8" name="Straight Connector 337"/>
          <p:cNvCxnSpPr/>
          <p:nvPr/>
        </p:nvCxnSpPr>
        <p:spPr>
          <a:xfrm>
            <a:off x="5147821" y="6170632"/>
            <a:ext cx="12427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9" name="Straight Connector 398"/>
          <p:cNvCxnSpPr/>
          <p:nvPr/>
        </p:nvCxnSpPr>
        <p:spPr>
          <a:xfrm>
            <a:off x="5147821" y="6366734"/>
            <a:ext cx="12427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0" name="Straight Connector 399"/>
          <p:cNvCxnSpPr/>
          <p:nvPr/>
        </p:nvCxnSpPr>
        <p:spPr>
          <a:xfrm>
            <a:off x="5147821" y="6581519"/>
            <a:ext cx="12427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2" name="Straight Connector 401"/>
          <p:cNvCxnSpPr/>
          <p:nvPr/>
        </p:nvCxnSpPr>
        <p:spPr>
          <a:xfrm>
            <a:off x="5147821" y="6777621"/>
            <a:ext cx="12427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3" name="Straight Connector 402"/>
          <p:cNvCxnSpPr/>
          <p:nvPr/>
        </p:nvCxnSpPr>
        <p:spPr>
          <a:xfrm>
            <a:off x="5147821" y="6992756"/>
            <a:ext cx="12427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5" name="Straight Connector 404"/>
          <p:cNvCxnSpPr/>
          <p:nvPr/>
        </p:nvCxnSpPr>
        <p:spPr>
          <a:xfrm>
            <a:off x="5147821" y="7188858"/>
            <a:ext cx="12427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6" name="TextBox 405"/>
          <p:cNvSpPr txBox="1"/>
          <p:nvPr/>
        </p:nvSpPr>
        <p:spPr>
          <a:xfrm>
            <a:off x="3103581" y="5465572"/>
            <a:ext cx="42832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total</a:t>
            </a:r>
          </a:p>
        </p:txBody>
      </p:sp>
      <p:sp>
        <p:nvSpPr>
          <p:cNvPr id="407" name="TextBox 406"/>
          <p:cNvSpPr txBox="1"/>
          <p:nvPr/>
        </p:nvSpPr>
        <p:spPr>
          <a:xfrm>
            <a:off x="4196938" y="5445441"/>
            <a:ext cx="63831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/>
              <a:t>phospho</a:t>
            </a:r>
            <a:endParaRPr lang="en-US" sz="1000" dirty="0"/>
          </a:p>
        </p:txBody>
      </p:sp>
      <p:pic>
        <p:nvPicPr>
          <p:cNvPr id="32" name="Picture 31"/>
          <p:cNvPicPr>
            <a:picLocks noChangeAspect="1"/>
          </p:cNvPicPr>
          <p:nvPr/>
        </p:nvPicPr>
        <p:blipFill>
          <a:blip r:embed="rId37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938612" y="5725349"/>
            <a:ext cx="1188720" cy="79943"/>
          </a:xfrm>
          <a:prstGeom prst="rect">
            <a:avLst/>
          </a:prstGeom>
        </p:spPr>
      </p:pic>
      <p:pic>
        <p:nvPicPr>
          <p:cNvPr id="33" name="Picture 32"/>
          <p:cNvPicPr>
            <a:picLocks noChangeAspect="1"/>
          </p:cNvPicPr>
          <p:nvPr/>
        </p:nvPicPr>
        <p:blipFill>
          <a:blip r:embed="rId38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 rot="21413318">
            <a:off x="3933306" y="5848131"/>
            <a:ext cx="1188720" cy="125495"/>
          </a:xfrm>
          <a:prstGeom prst="rect">
            <a:avLst/>
          </a:prstGeom>
        </p:spPr>
      </p:pic>
      <p:pic>
        <p:nvPicPr>
          <p:cNvPr id="34" name="Picture 33"/>
          <p:cNvPicPr>
            <a:picLocks noChangeAspect="1"/>
          </p:cNvPicPr>
          <p:nvPr/>
        </p:nvPicPr>
        <p:blipFill>
          <a:blip r:embed="rId39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932073" y="6708371"/>
            <a:ext cx="1188720" cy="99613"/>
          </a:xfrm>
          <a:prstGeom prst="rect">
            <a:avLst/>
          </a:prstGeom>
        </p:spPr>
      </p:pic>
      <p:pic>
        <p:nvPicPr>
          <p:cNvPr id="35" name="Picture 34"/>
          <p:cNvPicPr>
            <a:picLocks noChangeAspect="1"/>
          </p:cNvPicPr>
          <p:nvPr/>
        </p:nvPicPr>
        <p:blipFill>
          <a:blip r:embed="rId40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930776" y="6540661"/>
            <a:ext cx="1188720" cy="97107"/>
          </a:xfrm>
          <a:prstGeom prst="rect">
            <a:avLst/>
          </a:prstGeom>
        </p:spPr>
      </p:pic>
      <p:pic>
        <p:nvPicPr>
          <p:cNvPr id="36" name="Picture 35"/>
          <p:cNvPicPr>
            <a:picLocks noChangeAspect="1"/>
          </p:cNvPicPr>
          <p:nvPr/>
        </p:nvPicPr>
        <p:blipFill>
          <a:blip r:embed="rId41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921736" y="7121635"/>
            <a:ext cx="1188720" cy="147930"/>
          </a:xfrm>
          <a:prstGeom prst="rect">
            <a:avLst/>
          </a:prstGeom>
        </p:spPr>
      </p:pic>
      <p:grpSp>
        <p:nvGrpSpPr>
          <p:cNvPr id="55" name="Group 54"/>
          <p:cNvGrpSpPr/>
          <p:nvPr/>
        </p:nvGrpSpPr>
        <p:grpSpPr>
          <a:xfrm>
            <a:off x="2748865" y="6266527"/>
            <a:ext cx="1103331" cy="157495"/>
            <a:chOff x="1590675" y="5948363"/>
            <a:chExt cx="888226" cy="96198"/>
          </a:xfrm>
        </p:grpSpPr>
        <p:pic>
          <p:nvPicPr>
            <p:cNvPr id="53" name="Picture 52"/>
            <p:cNvPicPr>
              <a:picLocks noChangeAspect="1"/>
            </p:cNvPicPr>
            <p:nvPr/>
          </p:nvPicPr>
          <p:blipFill rotWithShape="1">
            <a:blip r:embed="rId42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t="2" r="68750" b="1223"/>
            <a:stretch/>
          </p:blipFill>
          <p:spPr>
            <a:xfrm>
              <a:off x="1590675" y="5948363"/>
              <a:ext cx="371475" cy="94298"/>
            </a:xfrm>
            <a:prstGeom prst="rect">
              <a:avLst/>
            </a:prstGeom>
          </p:spPr>
        </p:pic>
        <p:pic>
          <p:nvPicPr>
            <p:cNvPr id="424" name="Picture 423"/>
            <p:cNvPicPr>
              <a:picLocks noChangeAspect="1"/>
            </p:cNvPicPr>
            <p:nvPr/>
          </p:nvPicPr>
          <p:blipFill rotWithShape="1">
            <a:blip r:embed="rId42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47730" t="2993" r="19418" b="9205"/>
            <a:stretch/>
          </p:blipFill>
          <p:spPr>
            <a:xfrm>
              <a:off x="1966417" y="5960741"/>
              <a:ext cx="390525" cy="83820"/>
            </a:xfrm>
            <a:prstGeom prst="rect">
              <a:avLst/>
            </a:prstGeom>
          </p:spPr>
        </p:pic>
        <p:pic>
          <p:nvPicPr>
            <p:cNvPr id="425" name="Picture 424"/>
            <p:cNvPicPr>
              <a:picLocks noChangeAspect="1"/>
            </p:cNvPicPr>
            <p:nvPr/>
          </p:nvPicPr>
          <p:blipFill rotWithShape="1">
            <a:blip r:embed="rId42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88676" t="-57" r="267" b="10257"/>
            <a:stretch/>
          </p:blipFill>
          <p:spPr>
            <a:xfrm>
              <a:off x="2347456" y="5948363"/>
              <a:ext cx="131445" cy="85725"/>
            </a:xfrm>
            <a:prstGeom prst="rect">
              <a:avLst/>
            </a:prstGeom>
          </p:spPr>
        </p:pic>
      </p:grpSp>
      <p:grpSp>
        <p:nvGrpSpPr>
          <p:cNvPr id="58" name="Group 57"/>
          <p:cNvGrpSpPr/>
          <p:nvPr/>
        </p:nvGrpSpPr>
        <p:grpSpPr>
          <a:xfrm>
            <a:off x="2752415" y="6108014"/>
            <a:ext cx="1119722" cy="152545"/>
            <a:chOff x="681520" y="5694740"/>
            <a:chExt cx="884488" cy="92954"/>
          </a:xfrm>
        </p:grpSpPr>
        <p:pic>
          <p:nvPicPr>
            <p:cNvPr id="57" name="Picture 56"/>
            <p:cNvPicPr>
              <a:picLocks noChangeAspect="1"/>
            </p:cNvPicPr>
            <p:nvPr/>
          </p:nvPicPr>
          <p:blipFill rotWithShape="1">
            <a:blip r:embed="rId43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r="68738" b="-4123"/>
            <a:stretch/>
          </p:blipFill>
          <p:spPr>
            <a:xfrm>
              <a:off x="681520" y="5696053"/>
              <a:ext cx="371617" cy="83586"/>
            </a:xfrm>
            <a:prstGeom prst="rect">
              <a:avLst/>
            </a:prstGeom>
          </p:spPr>
        </p:pic>
        <p:pic>
          <p:nvPicPr>
            <p:cNvPr id="426" name="Picture 425"/>
            <p:cNvPicPr>
              <a:picLocks noChangeAspect="1"/>
            </p:cNvPicPr>
            <p:nvPr/>
          </p:nvPicPr>
          <p:blipFill rotWithShape="1">
            <a:blip r:embed="rId43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48278" t="-6662" r="20688" b="-7245"/>
            <a:stretch/>
          </p:blipFill>
          <p:spPr>
            <a:xfrm>
              <a:off x="1053137" y="5696254"/>
              <a:ext cx="368913" cy="91440"/>
            </a:xfrm>
            <a:prstGeom prst="rect">
              <a:avLst/>
            </a:prstGeom>
          </p:spPr>
        </p:pic>
        <p:pic>
          <p:nvPicPr>
            <p:cNvPr id="427" name="Picture 426"/>
            <p:cNvPicPr>
              <a:picLocks noChangeAspect="1"/>
            </p:cNvPicPr>
            <p:nvPr/>
          </p:nvPicPr>
          <p:blipFill rotWithShape="1">
            <a:blip r:embed="rId43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88899" t="-4572" r="-835" b="2447"/>
            <a:stretch/>
          </p:blipFill>
          <p:spPr>
            <a:xfrm>
              <a:off x="1424119" y="5694740"/>
              <a:ext cx="141889" cy="81981"/>
            </a:xfrm>
            <a:prstGeom prst="rect">
              <a:avLst/>
            </a:prstGeom>
          </p:spPr>
        </p:pic>
      </p:grpSp>
      <p:pic>
        <p:nvPicPr>
          <p:cNvPr id="59" name="Picture 58"/>
          <p:cNvPicPr>
            <a:picLocks noChangeAspect="1"/>
          </p:cNvPicPr>
          <p:nvPr/>
        </p:nvPicPr>
        <p:blipFill>
          <a:blip r:embed="rId44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930776" y="6953567"/>
            <a:ext cx="1188720" cy="116230"/>
          </a:xfrm>
          <a:prstGeom prst="rect">
            <a:avLst/>
          </a:prstGeom>
        </p:spPr>
      </p:pic>
      <p:pic>
        <p:nvPicPr>
          <p:cNvPr id="60" name="Picture 59"/>
          <p:cNvPicPr>
            <a:picLocks noChangeAspect="1"/>
          </p:cNvPicPr>
          <p:nvPr/>
        </p:nvPicPr>
        <p:blipFill>
          <a:blip r:embed="rId45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693896" y="6962405"/>
            <a:ext cx="1188720" cy="80102"/>
          </a:xfrm>
          <a:prstGeom prst="rect">
            <a:avLst/>
          </a:prstGeom>
        </p:spPr>
      </p:pic>
      <p:pic>
        <p:nvPicPr>
          <p:cNvPr id="62" name="Picture 61"/>
          <p:cNvPicPr>
            <a:picLocks noChangeAspect="1"/>
          </p:cNvPicPr>
          <p:nvPr/>
        </p:nvPicPr>
        <p:blipFill>
          <a:blip r:embed="rId46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698325" y="7144098"/>
            <a:ext cx="1188720" cy="102808"/>
          </a:xfrm>
          <a:prstGeom prst="rect">
            <a:avLst/>
          </a:prstGeom>
        </p:spPr>
      </p:pic>
      <p:pic>
        <p:nvPicPr>
          <p:cNvPr id="63" name="Picture 62"/>
          <p:cNvPicPr>
            <a:picLocks noChangeAspect="1"/>
          </p:cNvPicPr>
          <p:nvPr/>
        </p:nvPicPr>
        <p:blipFill>
          <a:blip r:embed="rId47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938612" y="6328615"/>
            <a:ext cx="1188720" cy="88848"/>
          </a:xfrm>
          <a:prstGeom prst="rect">
            <a:avLst/>
          </a:prstGeom>
        </p:spPr>
      </p:pic>
      <p:pic>
        <p:nvPicPr>
          <p:cNvPr id="64" name="Picture 63"/>
          <p:cNvPicPr>
            <a:picLocks noChangeAspect="1"/>
          </p:cNvPicPr>
          <p:nvPr/>
        </p:nvPicPr>
        <p:blipFill>
          <a:blip r:embed="rId48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938612" y="6137591"/>
            <a:ext cx="1188720" cy="74102"/>
          </a:xfrm>
          <a:prstGeom prst="rect">
            <a:avLst/>
          </a:prstGeom>
        </p:spPr>
      </p:pic>
      <p:cxnSp>
        <p:nvCxnSpPr>
          <p:cNvPr id="431" name="Straight Connector 430"/>
          <p:cNvCxnSpPr/>
          <p:nvPr/>
        </p:nvCxnSpPr>
        <p:spPr>
          <a:xfrm>
            <a:off x="5147821" y="8049953"/>
            <a:ext cx="12427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2" name="Straight Connector 431"/>
          <p:cNvCxnSpPr/>
          <p:nvPr/>
        </p:nvCxnSpPr>
        <p:spPr>
          <a:xfrm>
            <a:off x="5147821" y="8190973"/>
            <a:ext cx="12427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3" name="Straight Connector 432"/>
          <p:cNvCxnSpPr/>
          <p:nvPr/>
        </p:nvCxnSpPr>
        <p:spPr>
          <a:xfrm>
            <a:off x="5147821" y="8455265"/>
            <a:ext cx="12427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4" name="Straight Connector 433"/>
          <p:cNvCxnSpPr/>
          <p:nvPr/>
        </p:nvCxnSpPr>
        <p:spPr>
          <a:xfrm>
            <a:off x="5147821" y="8651367"/>
            <a:ext cx="12427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5" name="Straight Connector 434"/>
          <p:cNvCxnSpPr/>
          <p:nvPr/>
        </p:nvCxnSpPr>
        <p:spPr>
          <a:xfrm>
            <a:off x="5147821" y="8866152"/>
            <a:ext cx="12427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6" name="Straight Connector 435"/>
          <p:cNvCxnSpPr/>
          <p:nvPr/>
        </p:nvCxnSpPr>
        <p:spPr>
          <a:xfrm>
            <a:off x="5147821" y="9062254"/>
            <a:ext cx="12427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7" name="Straight Connector 436"/>
          <p:cNvCxnSpPr/>
          <p:nvPr/>
        </p:nvCxnSpPr>
        <p:spPr>
          <a:xfrm>
            <a:off x="5147821" y="9277389"/>
            <a:ext cx="12427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8" name="Straight Connector 437"/>
          <p:cNvCxnSpPr/>
          <p:nvPr/>
        </p:nvCxnSpPr>
        <p:spPr>
          <a:xfrm>
            <a:off x="5147821" y="9473491"/>
            <a:ext cx="12427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9" name="TextBox 438"/>
          <p:cNvSpPr txBox="1"/>
          <p:nvPr/>
        </p:nvSpPr>
        <p:spPr>
          <a:xfrm>
            <a:off x="3103581" y="7750205"/>
            <a:ext cx="42832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total</a:t>
            </a:r>
          </a:p>
        </p:txBody>
      </p:sp>
      <p:sp>
        <p:nvSpPr>
          <p:cNvPr id="440" name="TextBox 439"/>
          <p:cNvSpPr txBox="1"/>
          <p:nvPr/>
        </p:nvSpPr>
        <p:spPr>
          <a:xfrm>
            <a:off x="4196938" y="7730074"/>
            <a:ext cx="63831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/>
              <a:t>phospho</a:t>
            </a:r>
            <a:endParaRPr lang="en-US" sz="1000" dirty="0"/>
          </a:p>
        </p:txBody>
      </p:sp>
      <p:cxnSp>
        <p:nvCxnSpPr>
          <p:cNvPr id="463" name="Straight Connector 462"/>
          <p:cNvCxnSpPr/>
          <p:nvPr/>
        </p:nvCxnSpPr>
        <p:spPr>
          <a:xfrm>
            <a:off x="5148748" y="10254610"/>
            <a:ext cx="12427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4" name="Straight Connector 463"/>
          <p:cNvCxnSpPr/>
          <p:nvPr/>
        </p:nvCxnSpPr>
        <p:spPr>
          <a:xfrm>
            <a:off x="5148748" y="10395630"/>
            <a:ext cx="12427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5" name="Straight Connector 464"/>
          <p:cNvCxnSpPr/>
          <p:nvPr/>
        </p:nvCxnSpPr>
        <p:spPr>
          <a:xfrm>
            <a:off x="5148748" y="10659922"/>
            <a:ext cx="12427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6" name="Straight Connector 465"/>
          <p:cNvCxnSpPr/>
          <p:nvPr/>
        </p:nvCxnSpPr>
        <p:spPr>
          <a:xfrm>
            <a:off x="5148748" y="10856024"/>
            <a:ext cx="12427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7" name="Straight Connector 466"/>
          <p:cNvCxnSpPr/>
          <p:nvPr/>
        </p:nvCxnSpPr>
        <p:spPr>
          <a:xfrm>
            <a:off x="5148748" y="11070809"/>
            <a:ext cx="12427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8" name="Straight Connector 467"/>
          <p:cNvCxnSpPr/>
          <p:nvPr/>
        </p:nvCxnSpPr>
        <p:spPr>
          <a:xfrm>
            <a:off x="5148748" y="11266911"/>
            <a:ext cx="12427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9" name="Straight Connector 468"/>
          <p:cNvCxnSpPr/>
          <p:nvPr/>
        </p:nvCxnSpPr>
        <p:spPr>
          <a:xfrm>
            <a:off x="5148748" y="11482046"/>
            <a:ext cx="12427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0" name="Straight Connector 469"/>
          <p:cNvCxnSpPr/>
          <p:nvPr/>
        </p:nvCxnSpPr>
        <p:spPr>
          <a:xfrm>
            <a:off x="5148748" y="11678148"/>
            <a:ext cx="12427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1" name="TextBox 470"/>
          <p:cNvSpPr txBox="1"/>
          <p:nvPr/>
        </p:nvSpPr>
        <p:spPr>
          <a:xfrm>
            <a:off x="3104508" y="9954862"/>
            <a:ext cx="42832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total</a:t>
            </a:r>
          </a:p>
        </p:txBody>
      </p:sp>
      <p:sp>
        <p:nvSpPr>
          <p:cNvPr id="472" name="TextBox 471"/>
          <p:cNvSpPr txBox="1"/>
          <p:nvPr/>
        </p:nvSpPr>
        <p:spPr>
          <a:xfrm>
            <a:off x="4197865" y="9934731"/>
            <a:ext cx="63831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/>
              <a:t>phospho</a:t>
            </a:r>
            <a:endParaRPr lang="en-US" sz="1000" dirty="0"/>
          </a:p>
        </p:txBody>
      </p:sp>
      <p:pic>
        <p:nvPicPr>
          <p:cNvPr id="94" name="Picture 93"/>
          <p:cNvPicPr>
            <a:picLocks noChangeAspect="1"/>
          </p:cNvPicPr>
          <p:nvPr/>
        </p:nvPicPr>
        <p:blipFill>
          <a:blip r:embed="rId49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698325" y="8009441"/>
            <a:ext cx="1188720" cy="82850"/>
          </a:xfrm>
          <a:prstGeom prst="rect">
            <a:avLst/>
          </a:prstGeom>
        </p:spPr>
      </p:pic>
      <p:pic>
        <p:nvPicPr>
          <p:cNvPr id="160" name="Picture 159"/>
          <p:cNvPicPr>
            <a:picLocks noChangeAspect="1"/>
          </p:cNvPicPr>
          <p:nvPr/>
        </p:nvPicPr>
        <p:blipFill>
          <a:blip r:embed="rId50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705446" y="8163860"/>
            <a:ext cx="1188720" cy="79248"/>
          </a:xfrm>
          <a:prstGeom prst="rect">
            <a:avLst/>
          </a:prstGeom>
        </p:spPr>
      </p:pic>
      <p:pic>
        <p:nvPicPr>
          <p:cNvPr id="161" name="Picture 160"/>
          <p:cNvPicPr>
            <a:picLocks noChangeAspect="1"/>
          </p:cNvPicPr>
          <p:nvPr/>
        </p:nvPicPr>
        <p:blipFill>
          <a:blip r:embed="rId51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711646" y="8846864"/>
            <a:ext cx="1188720" cy="71014"/>
          </a:xfrm>
          <a:prstGeom prst="rect">
            <a:avLst/>
          </a:prstGeom>
        </p:spPr>
      </p:pic>
      <p:pic>
        <p:nvPicPr>
          <p:cNvPr id="162" name="Picture 161"/>
          <p:cNvPicPr>
            <a:picLocks noChangeAspect="1"/>
          </p:cNvPicPr>
          <p:nvPr/>
        </p:nvPicPr>
        <p:blipFill>
          <a:blip r:embed="rId52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698325" y="9028275"/>
            <a:ext cx="1188720" cy="67228"/>
          </a:xfrm>
          <a:prstGeom prst="rect">
            <a:avLst/>
          </a:prstGeom>
        </p:spPr>
      </p:pic>
      <p:pic>
        <p:nvPicPr>
          <p:cNvPr id="163" name="Picture 162"/>
          <p:cNvPicPr>
            <a:picLocks noChangeAspect="1"/>
          </p:cNvPicPr>
          <p:nvPr/>
        </p:nvPicPr>
        <p:blipFill>
          <a:blip r:embed="rId53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705446" y="9231178"/>
            <a:ext cx="1188720" cy="117341"/>
          </a:xfrm>
          <a:prstGeom prst="rect">
            <a:avLst/>
          </a:prstGeom>
        </p:spPr>
      </p:pic>
      <p:pic>
        <p:nvPicPr>
          <p:cNvPr id="164" name="Picture 163"/>
          <p:cNvPicPr>
            <a:picLocks noChangeAspect="1"/>
          </p:cNvPicPr>
          <p:nvPr/>
        </p:nvPicPr>
        <p:blipFill>
          <a:blip r:embed="rId54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704032" y="9413865"/>
            <a:ext cx="1188720" cy="111284"/>
          </a:xfrm>
          <a:prstGeom prst="rect">
            <a:avLst/>
          </a:prstGeom>
        </p:spPr>
      </p:pic>
      <p:pic>
        <p:nvPicPr>
          <p:cNvPr id="165" name="Picture 164"/>
          <p:cNvPicPr>
            <a:picLocks noChangeAspect="1"/>
          </p:cNvPicPr>
          <p:nvPr/>
        </p:nvPicPr>
        <p:blipFill>
          <a:blip r:embed="rId55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705446" y="8402575"/>
            <a:ext cx="1188720" cy="117341"/>
          </a:xfrm>
          <a:prstGeom prst="rect">
            <a:avLst/>
          </a:prstGeom>
        </p:spPr>
      </p:pic>
      <p:pic>
        <p:nvPicPr>
          <p:cNvPr id="166" name="Picture 165"/>
          <p:cNvPicPr>
            <a:picLocks noChangeAspect="1"/>
          </p:cNvPicPr>
          <p:nvPr/>
        </p:nvPicPr>
        <p:blipFill>
          <a:blip r:embed="rId56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698325" y="8608423"/>
            <a:ext cx="1188720" cy="109882"/>
          </a:xfrm>
          <a:prstGeom prst="rect">
            <a:avLst/>
          </a:prstGeom>
        </p:spPr>
      </p:pic>
      <p:pic>
        <p:nvPicPr>
          <p:cNvPr id="168" name="Picture 167"/>
          <p:cNvPicPr>
            <a:picLocks noChangeAspect="1"/>
          </p:cNvPicPr>
          <p:nvPr/>
        </p:nvPicPr>
        <p:blipFill>
          <a:blip r:embed="rId57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936661" y="8632312"/>
            <a:ext cx="1188720" cy="85993"/>
          </a:xfrm>
          <a:prstGeom prst="rect">
            <a:avLst/>
          </a:prstGeom>
        </p:spPr>
      </p:pic>
      <p:pic>
        <p:nvPicPr>
          <p:cNvPr id="169" name="Picture 168"/>
          <p:cNvPicPr>
            <a:picLocks noChangeAspect="1"/>
          </p:cNvPicPr>
          <p:nvPr/>
        </p:nvPicPr>
        <p:blipFill>
          <a:blip r:embed="rId58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920278" y="9426379"/>
            <a:ext cx="1188720" cy="106136"/>
          </a:xfrm>
          <a:prstGeom prst="rect">
            <a:avLst/>
          </a:prstGeom>
        </p:spPr>
      </p:pic>
      <p:pic>
        <p:nvPicPr>
          <p:cNvPr id="177" name="Picture 176"/>
          <p:cNvPicPr>
            <a:picLocks noChangeAspect="1"/>
          </p:cNvPicPr>
          <p:nvPr/>
        </p:nvPicPr>
        <p:blipFill>
          <a:blip r:embed="rId59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935682" y="8022745"/>
            <a:ext cx="1188720" cy="72705"/>
          </a:xfrm>
          <a:prstGeom prst="rect">
            <a:avLst/>
          </a:prstGeom>
        </p:spPr>
      </p:pic>
      <p:pic>
        <p:nvPicPr>
          <p:cNvPr id="182" name="Picture 181"/>
          <p:cNvPicPr>
            <a:picLocks noChangeAspect="1"/>
          </p:cNvPicPr>
          <p:nvPr/>
        </p:nvPicPr>
        <p:blipFill>
          <a:blip r:embed="rId60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934338" y="8145255"/>
            <a:ext cx="1188720" cy="93941"/>
          </a:xfrm>
          <a:prstGeom prst="rect">
            <a:avLst/>
          </a:prstGeom>
        </p:spPr>
      </p:pic>
      <p:pic>
        <p:nvPicPr>
          <p:cNvPr id="183" name="Picture 182"/>
          <p:cNvPicPr>
            <a:picLocks noChangeAspect="1"/>
          </p:cNvPicPr>
          <p:nvPr/>
        </p:nvPicPr>
        <p:blipFill>
          <a:blip r:embed="rId61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930776" y="8845140"/>
            <a:ext cx="1188720" cy="61274"/>
          </a:xfrm>
          <a:prstGeom prst="rect">
            <a:avLst/>
          </a:prstGeom>
        </p:spPr>
      </p:pic>
      <p:pic>
        <p:nvPicPr>
          <p:cNvPr id="185" name="Picture 184"/>
          <p:cNvPicPr>
            <a:picLocks noChangeAspect="1"/>
          </p:cNvPicPr>
          <p:nvPr/>
        </p:nvPicPr>
        <p:blipFill>
          <a:blip r:embed="rId52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935682" y="9020420"/>
            <a:ext cx="1188720" cy="67228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62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92862" y="850632"/>
            <a:ext cx="4430595" cy="2283768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63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930776" y="9257899"/>
            <a:ext cx="1188720" cy="9062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64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938612" y="8410507"/>
            <a:ext cx="1188720" cy="10900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5694392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Textfeld 44"/>
          <p:cNvSpPr txBox="1"/>
          <p:nvPr/>
        </p:nvSpPr>
        <p:spPr>
          <a:xfrm>
            <a:off x="227023" y="117063"/>
            <a:ext cx="21621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upplementary Fig</a:t>
            </a:r>
            <a:r>
              <a:rPr lang="en-US" dirty="0"/>
              <a:t>. </a:t>
            </a:r>
            <a:r>
              <a:rPr lang="en-US" dirty="0" smtClean="0"/>
              <a:t>6</a:t>
            </a:r>
            <a:endParaRPr lang="en-US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583932"/>
            <a:ext cx="6858000" cy="281859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0614157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</TotalTime>
  <Words>349</Words>
  <Application>Microsoft Office PowerPoint</Application>
  <PresentationFormat>Widescreen</PresentationFormat>
  <Paragraphs>229</Paragraphs>
  <Slides>7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7</vt:i4>
      </vt:variant>
    </vt:vector>
  </HeadingPairs>
  <TitlesOfParts>
    <vt:vector size="13" baseType="lpstr">
      <vt:lpstr>Arial</vt:lpstr>
      <vt:lpstr>Calibri</vt:lpstr>
      <vt:lpstr>Calibri Light</vt:lpstr>
      <vt:lpstr>Office Theme</vt:lpstr>
      <vt:lpstr>Prism 10</vt:lpstr>
      <vt:lpstr>GraphPad Prism Project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DZN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ernis, Maria /DZNE</dc:creator>
  <cp:lastModifiedBy>Bernis, Maria /DZNE</cp:lastModifiedBy>
  <cp:revision>4</cp:revision>
  <dcterms:created xsi:type="dcterms:W3CDTF">2024-07-16T05:50:40Z</dcterms:created>
  <dcterms:modified xsi:type="dcterms:W3CDTF">2024-07-22T08:03:53Z</dcterms:modified>
</cp:coreProperties>
</file>